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notesSlides/notesSlide4.xml" ContentType="application/vnd.openxmlformats-officedocument.presentationml.notesSlide+xml"/>
  <Override PartName="/ppt/charts/chart4.xml" ContentType="application/vnd.openxmlformats-officedocument.drawingml.chart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drawings/drawing5.xml" ContentType="application/vnd.openxmlformats-officedocument.drawingml.chartshapes+xml"/>
  <Override PartName="/ppt/notesSlides/notesSlide5.xml" ContentType="application/vnd.openxmlformats-officedocument.presentationml.notesSlide+xml"/>
  <Override PartName="/ppt/charts/chart6.xml" ContentType="application/vnd.openxmlformats-officedocument.drawingml.chart+xml"/>
  <Override PartName="/ppt/drawings/drawing6.xml" ContentType="application/vnd.openxmlformats-officedocument.drawingml.chartshapes+xml"/>
  <Override PartName="/ppt/charts/chart7.xml" ContentType="application/vnd.openxmlformats-officedocument.drawingml.chart+xml"/>
  <Override PartName="/ppt/drawings/drawing7.xml" ContentType="application/vnd.openxmlformats-officedocument.drawingml.chartshapes+xml"/>
  <Override PartName="/ppt/notesSlides/notesSlide6.xml" ContentType="application/vnd.openxmlformats-officedocument.presentationml.notesSlide+xml"/>
  <Override PartName="/ppt/charts/chart8.xml" ContentType="application/vnd.openxmlformats-officedocument.drawingml.chart+xml"/>
  <Override PartName="/ppt/drawings/drawing8.xml" ContentType="application/vnd.openxmlformats-officedocument.drawingml.chartshapes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10"/>
  </p:notesMasterIdLst>
  <p:sldIdLst>
    <p:sldId id="285" r:id="rId2"/>
    <p:sldId id="289" r:id="rId3"/>
    <p:sldId id="292" r:id="rId4"/>
    <p:sldId id="274" r:id="rId5"/>
    <p:sldId id="280" r:id="rId6"/>
    <p:sldId id="286" r:id="rId7"/>
    <p:sldId id="288" r:id="rId8"/>
    <p:sldId id="291" r:id="rId9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6D256"/>
    <a:srgbClr val="25B160"/>
    <a:srgbClr val="F45000"/>
    <a:srgbClr val="0673C4"/>
    <a:srgbClr val="D8B60E"/>
    <a:srgbClr val="F35100"/>
    <a:srgbClr val="C5A3FF"/>
    <a:srgbClr val="FF65B9"/>
    <a:srgbClr val="00E5CA"/>
    <a:srgbClr val="00E4C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728D5D2-C422-484A-B570-D8FEC6E1511F}" v="3" dt="2026-04-02T17:05:49.20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6684"/>
    <p:restoredTop sz="84851"/>
  </p:normalViewPr>
  <p:slideViewPr>
    <p:cSldViewPr snapToGrid="0">
      <p:cViewPr>
        <p:scale>
          <a:sx n="102" d="100"/>
          <a:sy n="102" d="100"/>
        </p:scale>
        <p:origin x="392" y="5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52" d="100"/>
        <a:sy n="52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essica Tyler" userId="a8ac3dbb-21db-45f9-ba94-e12509dd3320" providerId="ADAL" clId="{E3DB39A1-9812-5154-9906-722CC67BD601}"/>
    <pc:docChg chg="custSel addSld modSld">
      <pc:chgData name="Jessica Tyler" userId="a8ac3dbb-21db-45f9-ba94-e12509dd3320" providerId="ADAL" clId="{E3DB39A1-9812-5154-9906-722CC67BD601}" dt="2026-04-01T01:33:13.569" v="24" actId="1076"/>
      <pc:docMkLst>
        <pc:docMk/>
      </pc:docMkLst>
      <pc:sldChg chg="addSp delSp modSp new mod">
        <pc:chgData name="Jessica Tyler" userId="a8ac3dbb-21db-45f9-ba94-e12509dd3320" providerId="ADAL" clId="{E3DB39A1-9812-5154-9906-722CC67BD601}" dt="2026-04-01T01:33:13.569" v="24" actId="1076"/>
        <pc:sldMkLst>
          <pc:docMk/>
          <pc:sldMk cId="2493341208" sldId="292"/>
        </pc:sldMkLst>
        <pc:spChg chg="add mod">
          <ac:chgData name="Jessica Tyler" userId="a8ac3dbb-21db-45f9-ba94-e12509dd3320" providerId="ADAL" clId="{E3DB39A1-9812-5154-9906-722CC67BD601}" dt="2026-03-31T22:55:01.350" v="6" actId="20577"/>
          <ac:spMkLst>
            <pc:docMk/>
            <pc:sldMk cId="2493341208" sldId="292"/>
            <ac:spMk id="2" creationId="{C59AD383-4AD3-81C6-9A24-10BCCE6060AA}"/>
          </ac:spMkLst>
        </pc:spChg>
        <pc:spChg chg="add mod">
          <ac:chgData name="Jessica Tyler" userId="a8ac3dbb-21db-45f9-ba94-e12509dd3320" providerId="ADAL" clId="{E3DB39A1-9812-5154-9906-722CC67BD601}" dt="2026-04-01T01:28:11.530" v="19" actId="1076"/>
          <ac:spMkLst>
            <pc:docMk/>
            <pc:sldMk cId="2493341208" sldId="292"/>
            <ac:spMk id="3" creationId="{C0D12AEE-4BEE-917B-ED4C-E2D1EBCF9E18}"/>
          </ac:spMkLst>
        </pc:spChg>
        <pc:spChg chg="add mod">
          <ac:chgData name="Jessica Tyler" userId="a8ac3dbb-21db-45f9-ba94-e12509dd3320" providerId="ADAL" clId="{E3DB39A1-9812-5154-9906-722CC67BD601}" dt="2026-04-01T01:27:58.800" v="17" actId="1076"/>
          <ac:spMkLst>
            <pc:docMk/>
            <pc:sldMk cId="2493341208" sldId="292"/>
            <ac:spMk id="6" creationId="{9F58A93B-439E-0E93-B704-E7B5EC222AC5}"/>
          </ac:spMkLst>
        </pc:spChg>
        <pc:spChg chg="add mod">
          <ac:chgData name="Jessica Tyler" userId="a8ac3dbb-21db-45f9-ba94-e12509dd3320" providerId="ADAL" clId="{E3DB39A1-9812-5154-9906-722CC67BD601}" dt="2026-04-01T01:27:58.800" v="17" actId="1076"/>
          <ac:spMkLst>
            <pc:docMk/>
            <pc:sldMk cId="2493341208" sldId="292"/>
            <ac:spMk id="7" creationId="{A2EF6C4C-2E4A-737E-85C9-65913AF8E07A}"/>
          </ac:spMkLst>
        </pc:spChg>
        <pc:spChg chg="add mod">
          <ac:chgData name="Jessica Tyler" userId="a8ac3dbb-21db-45f9-ba94-e12509dd3320" providerId="ADAL" clId="{E3DB39A1-9812-5154-9906-722CC67BD601}" dt="2026-04-01T01:27:58.800" v="17" actId="1076"/>
          <ac:spMkLst>
            <pc:docMk/>
            <pc:sldMk cId="2493341208" sldId="292"/>
            <ac:spMk id="8" creationId="{B1924B90-D8E0-2611-09F8-F1E4709551D2}"/>
          </ac:spMkLst>
        </pc:spChg>
        <pc:spChg chg="add mod">
          <ac:chgData name="Jessica Tyler" userId="a8ac3dbb-21db-45f9-ba94-e12509dd3320" providerId="ADAL" clId="{E3DB39A1-9812-5154-9906-722CC67BD601}" dt="2026-04-01T01:27:58.800" v="17" actId="1076"/>
          <ac:spMkLst>
            <pc:docMk/>
            <pc:sldMk cId="2493341208" sldId="292"/>
            <ac:spMk id="9" creationId="{C60006AF-E651-3FC8-449D-BA57E99D6798}"/>
          </ac:spMkLst>
        </pc:spChg>
        <pc:spChg chg="add mod">
          <ac:chgData name="Jessica Tyler" userId="a8ac3dbb-21db-45f9-ba94-e12509dd3320" providerId="ADAL" clId="{E3DB39A1-9812-5154-9906-722CC67BD601}" dt="2026-04-01T01:27:58.800" v="17" actId="1076"/>
          <ac:spMkLst>
            <pc:docMk/>
            <pc:sldMk cId="2493341208" sldId="292"/>
            <ac:spMk id="10" creationId="{96A7CA88-925B-7A15-8C5A-B777631200BE}"/>
          </ac:spMkLst>
        </pc:spChg>
        <pc:spChg chg="add mod">
          <ac:chgData name="Jessica Tyler" userId="a8ac3dbb-21db-45f9-ba94-e12509dd3320" providerId="ADAL" clId="{E3DB39A1-9812-5154-9906-722CC67BD601}" dt="2026-04-01T01:27:58.800" v="17" actId="1076"/>
          <ac:spMkLst>
            <pc:docMk/>
            <pc:sldMk cId="2493341208" sldId="292"/>
            <ac:spMk id="11" creationId="{0F9E6EC7-D96B-DDE9-BFE4-000C69830281}"/>
          </ac:spMkLst>
        </pc:spChg>
        <pc:spChg chg="add mod">
          <ac:chgData name="Jessica Tyler" userId="a8ac3dbb-21db-45f9-ba94-e12509dd3320" providerId="ADAL" clId="{E3DB39A1-9812-5154-9906-722CC67BD601}" dt="2026-04-01T01:27:58.800" v="17" actId="1076"/>
          <ac:spMkLst>
            <pc:docMk/>
            <pc:sldMk cId="2493341208" sldId="292"/>
            <ac:spMk id="12" creationId="{705B257E-CA45-4136-56D0-5F7F1767C559}"/>
          </ac:spMkLst>
        </pc:spChg>
        <pc:spChg chg="add mod">
          <ac:chgData name="Jessica Tyler" userId="a8ac3dbb-21db-45f9-ba94-e12509dd3320" providerId="ADAL" clId="{E3DB39A1-9812-5154-9906-722CC67BD601}" dt="2026-04-01T01:28:17.496" v="22" actId="20577"/>
          <ac:spMkLst>
            <pc:docMk/>
            <pc:sldMk cId="2493341208" sldId="292"/>
            <ac:spMk id="13" creationId="{7E64BDCB-1AA0-1822-68FC-E9C40A80BF03}"/>
          </ac:spMkLst>
        </pc:spChg>
        <pc:spChg chg="add mod">
          <ac:chgData name="Jessica Tyler" userId="a8ac3dbb-21db-45f9-ba94-e12509dd3320" providerId="ADAL" clId="{E3DB39A1-9812-5154-9906-722CC67BD601}" dt="2026-04-01T01:33:13.569" v="24" actId="1076"/>
          <ac:spMkLst>
            <pc:docMk/>
            <pc:sldMk cId="2493341208" sldId="292"/>
            <ac:spMk id="16" creationId="{2756FB95-5DE9-D4A9-A489-26DC00C931B6}"/>
          </ac:spMkLst>
        </pc:spChg>
        <pc:spChg chg="add mod">
          <ac:chgData name="Jessica Tyler" userId="a8ac3dbb-21db-45f9-ba94-e12509dd3320" providerId="ADAL" clId="{E3DB39A1-9812-5154-9906-722CC67BD601}" dt="2026-04-01T01:33:13.569" v="24" actId="1076"/>
          <ac:spMkLst>
            <pc:docMk/>
            <pc:sldMk cId="2493341208" sldId="292"/>
            <ac:spMk id="17" creationId="{A32C6825-52A5-2E36-02D9-310B0800C387}"/>
          </ac:spMkLst>
        </pc:spChg>
        <pc:spChg chg="add mod">
          <ac:chgData name="Jessica Tyler" userId="a8ac3dbb-21db-45f9-ba94-e12509dd3320" providerId="ADAL" clId="{E3DB39A1-9812-5154-9906-722CC67BD601}" dt="2026-04-01T01:33:13.569" v="24" actId="1076"/>
          <ac:spMkLst>
            <pc:docMk/>
            <pc:sldMk cId="2493341208" sldId="292"/>
            <ac:spMk id="19" creationId="{1926E707-BD99-BD44-1A8C-44939FC206DA}"/>
          </ac:spMkLst>
        </pc:spChg>
        <pc:spChg chg="add mod">
          <ac:chgData name="Jessica Tyler" userId="a8ac3dbb-21db-45f9-ba94-e12509dd3320" providerId="ADAL" clId="{E3DB39A1-9812-5154-9906-722CC67BD601}" dt="2026-04-01T01:33:13.569" v="24" actId="1076"/>
          <ac:spMkLst>
            <pc:docMk/>
            <pc:sldMk cId="2493341208" sldId="292"/>
            <ac:spMk id="21" creationId="{01346534-956A-A7FA-3722-C8D3C81EB434}"/>
          </ac:spMkLst>
        </pc:spChg>
        <pc:spChg chg="add mod">
          <ac:chgData name="Jessica Tyler" userId="a8ac3dbb-21db-45f9-ba94-e12509dd3320" providerId="ADAL" clId="{E3DB39A1-9812-5154-9906-722CC67BD601}" dt="2026-04-01T01:33:13.569" v="24" actId="1076"/>
          <ac:spMkLst>
            <pc:docMk/>
            <pc:sldMk cId="2493341208" sldId="292"/>
            <ac:spMk id="23" creationId="{1F00D743-F6CD-1C04-97B5-ECF83ABDECA2}"/>
          </ac:spMkLst>
        </pc:spChg>
        <pc:spChg chg="add mod">
          <ac:chgData name="Jessica Tyler" userId="a8ac3dbb-21db-45f9-ba94-e12509dd3320" providerId="ADAL" clId="{E3DB39A1-9812-5154-9906-722CC67BD601}" dt="2026-04-01T01:33:13.569" v="24" actId="1076"/>
          <ac:spMkLst>
            <pc:docMk/>
            <pc:sldMk cId="2493341208" sldId="292"/>
            <ac:spMk id="24" creationId="{8C98AC25-C55A-DA5A-63B8-5D2F1639378E}"/>
          </ac:spMkLst>
        </pc:spChg>
        <pc:spChg chg="add mod">
          <ac:chgData name="Jessica Tyler" userId="a8ac3dbb-21db-45f9-ba94-e12509dd3320" providerId="ADAL" clId="{E3DB39A1-9812-5154-9906-722CC67BD601}" dt="2026-04-01T01:33:13.569" v="24" actId="1076"/>
          <ac:spMkLst>
            <pc:docMk/>
            <pc:sldMk cId="2493341208" sldId="292"/>
            <ac:spMk id="25" creationId="{83B692A5-84A5-0B88-7641-C98E1A14A640}"/>
          </ac:spMkLst>
        </pc:spChg>
        <pc:spChg chg="add mod">
          <ac:chgData name="Jessica Tyler" userId="a8ac3dbb-21db-45f9-ba94-e12509dd3320" providerId="ADAL" clId="{E3DB39A1-9812-5154-9906-722CC67BD601}" dt="2026-04-01T01:33:13.569" v="24" actId="1076"/>
          <ac:spMkLst>
            <pc:docMk/>
            <pc:sldMk cId="2493341208" sldId="292"/>
            <ac:spMk id="26" creationId="{2BFF8E9D-266F-4C45-E57F-0FCFEBCE994B}"/>
          </ac:spMkLst>
        </pc:spChg>
        <pc:spChg chg="add mod">
          <ac:chgData name="Jessica Tyler" userId="a8ac3dbb-21db-45f9-ba94-e12509dd3320" providerId="ADAL" clId="{E3DB39A1-9812-5154-9906-722CC67BD601}" dt="2026-04-01T01:33:13.569" v="24" actId="1076"/>
          <ac:spMkLst>
            <pc:docMk/>
            <pc:sldMk cId="2493341208" sldId="292"/>
            <ac:spMk id="29" creationId="{09AFF052-9884-FBFA-7C67-2BE519905821}"/>
          </ac:spMkLst>
        </pc:spChg>
        <pc:spChg chg="add mod">
          <ac:chgData name="Jessica Tyler" userId="a8ac3dbb-21db-45f9-ba94-e12509dd3320" providerId="ADAL" clId="{E3DB39A1-9812-5154-9906-722CC67BD601}" dt="2026-04-01T01:33:13.569" v="24" actId="1076"/>
          <ac:spMkLst>
            <pc:docMk/>
            <pc:sldMk cId="2493341208" sldId="292"/>
            <ac:spMk id="30" creationId="{020CACBF-1A20-C2E3-F3CB-6389E10276E5}"/>
          </ac:spMkLst>
        </pc:spChg>
        <pc:picChg chg="add mod">
          <ac:chgData name="Jessica Tyler" userId="a8ac3dbb-21db-45f9-ba94-e12509dd3320" providerId="ADAL" clId="{E3DB39A1-9812-5154-9906-722CC67BD601}" dt="2026-04-01T01:27:58.800" v="17" actId="1076"/>
          <ac:picMkLst>
            <pc:docMk/>
            <pc:sldMk cId="2493341208" sldId="292"/>
            <ac:picMk id="4" creationId="{C5E71BBD-8A41-0BE6-8583-7895189E33F0}"/>
          </ac:picMkLst>
        </pc:picChg>
        <pc:picChg chg="add mod">
          <ac:chgData name="Jessica Tyler" userId="a8ac3dbb-21db-45f9-ba94-e12509dd3320" providerId="ADAL" clId="{E3DB39A1-9812-5154-9906-722CC67BD601}" dt="2026-04-01T01:27:58.800" v="17" actId="1076"/>
          <ac:picMkLst>
            <pc:docMk/>
            <pc:sldMk cId="2493341208" sldId="292"/>
            <ac:picMk id="5" creationId="{CC9309F7-1829-3FC9-5670-AF7AEAE89006}"/>
          </ac:picMkLst>
        </pc:picChg>
      </pc:sldChg>
    </pc:docChg>
  </pc:docChgLst>
  <pc:docChgLst>
    <pc:chgData name="Jessica Tyler" userId="a8ac3dbb-21db-45f9-ba94-e12509dd3320" providerId="ADAL" clId="{F0AE5C43-1844-5897-9CB1-3CA326E8E62B}"/>
    <pc:docChg chg="undo custSel modSld">
      <pc:chgData name="Jessica Tyler" userId="a8ac3dbb-21db-45f9-ba94-e12509dd3320" providerId="ADAL" clId="{F0AE5C43-1844-5897-9CB1-3CA326E8E62B}" dt="2026-04-02T17:17:09.507" v="267" actId="20577"/>
      <pc:docMkLst>
        <pc:docMk/>
      </pc:docMkLst>
      <pc:sldChg chg="modSp mod">
        <pc:chgData name="Jessica Tyler" userId="a8ac3dbb-21db-45f9-ba94-e12509dd3320" providerId="ADAL" clId="{F0AE5C43-1844-5897-9CB1-3CA326E8E62B}" dt="2026-04-02T17:10:01.284" v="201" actId="20577"/>
        <pc:sldMkLst>
          <pc:docMk/>
          <pc:sldMk cId="3073742487" sldId="274"/>
        </pc:sldMkLst>
        <pc:spChg chg="mod">
          <ac:chgData name="Jessica Tyler" userId="a8ac3dbb-21db-45f9-ba94-e12509dd3320" providerId="ADAL" clId="{F0AE5C43-1844-5897-9CB1-3CA326E8E62B}" dt="2026-04-02T17:10:01.284" v="201" actId="20577"/>
          <ac:spMkLst>
            <pc:docMk/>
            <pc:sldMk cId="3073742487" sldId="274"/>
            <ac:spMk id="11" creationId="{ADB8DD18-5C1E-BD04-D389-FED89FADF482}"/>
          </ac:spMkLst>
        </pc:spChg>
      </pc:sldChg>
      <pc:sldChg chg="modSp mod">
        <pc:chgData name="Jessica Tyler" userId="a8ac3dbb-21db-45f9-ba94-e12509dd3320" providerId="ADAL" clId="{F0AE5C43-1844-5897-9CB1-3CA326E8E62B}" dt="2026-04-02T17:10:06.169" v="203" actId="20577"/>
        <pc:sldMkLst>
          <pc:docMk/>
          <pc:sldMk cId="1482060022" sldId="280"/>
        </pc:sldMkLst>
        <pc:spChg chg="mod">
          <ac:chgData name="Jessica Tyler" userId="a8ac3dbb-21db-45f9-ba94-e12509dd3320" providerId="ADAL" clId="{F0AE5C43-1844-5897-9CB1-3CA326E8E62B}" dt="2026-04-02T17:10:06.169" v="203" actId="20577"/>
          <ac:spMkLst>
            <pc:docMk/>
            <pc:sldMk cId="1482060022" sldId="280"/>
            <ac:spMk id="34" creationId="{5E01AB36-7639-AE9B-635E-8D01B93E39A8}"/>
          </ac:spMkLst>
        </pc:spChg>
      </pc:sldChg>
      <pc:sldChg chg="modSp mod">
        <pc:chgData name="Jessica Tyler" userId="a8ac3dbb-21db-45f9-ba94-e12509dd3320" providerId="ADAL" clId="{F0AE5C43-1844-5897-9CB1-3CA326E8E62B}" dt="2026-04-02T17:10:10.076" v="205" actId="20577"/>
        <pc:sldMkLst>
          <pc:docMk/>
          <pc:sldMk cId="2648616619" sldId="286"/>
        </pc:sldMkLst>
        <pc:spChg chg="mod">
          <ac:chgData name="Jessica Tyler" userId="a8ac3dbb-21db-45f9-ba94-e12509dd3320" providerId="ADAL" clId="{F0AE5C43-1844-5897-9CB1-3CA326E8E62B}" dt="2026-04-02T17:10:10.076" v="205" actId="20577"/>
          <ac:spMkLst>
            <pc:docMk/>
            <pc:sldMk cId="2648616619" sldId="286"/>
            <ac:spMk id="11" creationId="{A10AFA60-AD5D-1218-8692-C6FAF4059A60}"/>
          </ac:spMkLst>
        </pc:spChg>
      </pc:sldChg>
      <pc:sldChg chg="modSp mod">
        <pc:chgData name="Jessica Tyler" userId="a8ac3dbb-21db-45f9-ba94-e12509dd3320" providerId="ADAL" clId="{F0AE5C43-1844-5897-9CB1-3CA326E8E62B}" dt="2026-04-02T17:10:14.576" v="207" actId="20577"/>
        <pc:sldMkLst>
          <pc:docMk/>
          <pc:sldMk cId="3617527370" sldId="288"/>
        </pc:sldMkLst>
        <pc:spChg chg="mod">
          <ac:chgData name="Jessica Tyler" userId="a8ac3dbb-21db-45f9-ba94-e12509dd3320" providerId="ADAL" clId="{F0AE5C43-1844-5897-9CB1-3CA326E8E62B}" dt="2026-04-02T17:10:14.576" v="207" actId="20577"/>
          <ac:spMkLst>
            <pc:docMk/>
            <pc:sldMk cId="3617527370" sldId="288"/>
            <ac:spMk id="11" creationId="{C3F4E36C-2BC3-9B84-1E9B-6417A85F2014}"/>
          </ac:spMkLst>
        </pc:spChg>
      </pc:sldChg>
      <pc:sldChg chg="modSp mod">
        <pc:chgData name="Jessica Tyler" userId="a8ac3dbb-21db-45f9-ba94-e12509dd3320" providerId="ADAL" clId="{F0AE5C43-1844-5897-9CB1-3CA326E8E62B}" dt="2026-04-02T17:10:39.300" v="216" actId="1038"/>
        <pc:sldMkLst>
          <pc:docMk/>
          <pc:sldMk cId="1402348512" sldId="291"/>
        </pc:sldMkLst>
        <pc:spChg chg="mod">
          <ac:chgData name="Jessica Tyler" userId="a8ac3dbb-21db-45f9-ba94-e12509dd3320" providerId="ADAL" clId="{F0AE5C43-1844-5897-9CB1-3CA326E8E62B}" dt="2026-04-02T17:10:19.152" v="209" actId="20577"/>
          <ac:spMkLst>
            <pc:docMk/>
            <pc:sldMk cId="1402348512" sldId="291"/>
            <ac:spMk id="4" creationId="{FC167D58-C3E2-A7EB-9C9A-AD4184449703}"/>
          </ac:spMkLst>
        </pc:spChg>
        <pc:spChg chg="mod">
          <ac:chgData name="Jessica Tyler" userId="a8ac3dbb-21db-45f9-ba94-e12509dd3320" providerId="ADAL" clId="{F0AE5C43-1844-5897-9CB1-3CA326E8E62B}" dt="2026-04-02T17:10:39.300" v="216" actId="1038"/>
          <ac:spMkLst>
            <pc:docMk/>
            <pc:sldMk cId="1402348512" sldId="291"/>
            <ac:spMk id="62" creationId="{A98690E4-A51B-3C3E-5722-0C913AC05E3D}"/>
          </ac:spMkLst>
        </pc:spChg>
        <pc:grpChg chg="mod">
          <ac:chgData name="Jessica Tyler" userId="a8ac3dbb-21db-45f9-ba94-e12509dd3320" providerId="ADAL" clId="{F0AE5C43-1844-5897-9CB1-3CA326E8E62B}" dt="2026-04-02T17:10:29.928" v="210" actId="1076"/>
          <ac:grpSpMkLst>
            <pc:docMk/>
            <pc:sldMk cId="1402348512" sldId="291"/>
            <ac:grpSpMk id="75" creationId="{DA8DEB5F-993F-0B7A-57D8-D27121D52562}"/>
          </ac:grpSpMkLst>
        </pc:grpChg>
        <pc:picChg chg="mod">
          <ac:chgData name="Jessica Tyler" userId="a8ac3dbb-21db-45f9-ba94-e12509dd3320" providerId="ADAL" clId="{F0AE5C43-1844-5897-9CB1-3CA326E8E62B}" dt="2026-04-02T17:10:29.928" v="210" actId="1076"/>
          <ac:picMkLst>
            <pc:docMk/>
            <pc:sldMk cId="1402348512" sldId="291"/>
            <ac:picMk id="6" creationId="{3BFDA478-2D5D-60B4-A580-C35DAACA0046}"/>
          </ac:picMkLst>
        </pc:picChg>
        <pc:picChg chg="mod">
          <ac:chgData name="Jessica Tyler" userId="a8ac3dbb-21db-45f9-ba94-e12509dd3320" providerId="ADAL" clId="{F0AE5C43-1844-5897-9CB1-3CA326E8E62B}" dt="2026-04-02T17:10:29.928" v="210" actId="1076"/>
          <ac:picMkLst>
            <pc:docMk/>
            <pc:sldMk cId="1402348512" sldId="291"/>
            <ac:picMk id="8" creationId="{76468225-D82A-0C68-8C25-89F206ECAE59}"/>
          </ac:picMkLst>
        </pc:picChg>
        <pc:picChg chg="mod">
          <ac:chgData name="Jessica Tyler" userId="a8ac3dbb-21db-45f9-ba94-e12509dd3320" providerId="ADAL" clId="{F0AE5C43-1844-5897-9CB1-3CA326E8E62B}" dt="2026-04-02T17:10:29.928" v="210" actId="1076"/>
          <ac:picMkLst>
            <pc:docMk/>
            <pc:sldMk cId="1402348512" sldId="291"/>
            <ac:picMk id="12" creationId="{7C3A95D2-8865-F6BA-C736-160E17C0FED2}"/>
          </ac:picMkLst>
        </pc:picChg>
      </pc:sldChg>
      <pc:sldChg chg="addSp delSp modSp mod">
        <pc:chgData name="Jessica Tyler" userId="a8ac3dbb-21db-45f9-ba94-e12509dd3320" providerId="ADAL" clId="{F0AE5C43-1844-5897-9CB1-3CA326E8E62B}" dt="2026-04-02T17:17:09.507" v="267" actId="20577"/>
        <pc:sldMkLst>
          <pc:docMk/>
          <pc:sldMk cId="2493341208" sldId="292"/>
        </pc:sldMkLst>
        <pc:spChg chg="mod">
          <ac:chgData name="Jessica Tyler" userId="a8ac3dbb-21db-45f9-ba94-e12509dd3320" providerId="ADAL" clId="{F0AE5C43-1844-5897-9CB1-3CA326E8E62B}" dt="2026-04-02T17:09:27.642" v="180" actId="1035"/>
          <ac:spMkLst>
            <pc:docMk/>
            <pc:sldMk cId="2493341208" sldId="292"/>
            <ac:spMk id="3" creationId="{C0D12AEE-4BEE-917B-ED4C-E2D1EBCF9E18}"/>
          </ac:spMkLst>
        </pc:spChg>
        <pc:spChg chg="mod">
          <ac:chgData name="Jessica Tyler" userId="a8ac3dbb-21db-45f9-ba94-e12509dd3320" providerId="ADAL" clId="{F0AE5C43-1844-5897-9CB1-3CA326E8E62B}" dt="2026-04-02T17:13:47.882" v="255" actId="555"/>
          <ac:spMkLst>
            <pc:docMk/>
            <pc:sldMk cId="2493341208" sldId="292"/>
            <ac:spMk id="6" creationId="{9F58A93B-439E-0E93-B704-E7B5EC222AC5}"/>
          </ac:spMkLst>
        </pc:spChg>
        <pc:spChg chg="mod">
          <ac:chgData name="Jessica Tyler" userId="a8ac3dbb-21db-45f9-ba94-e12509dd3320" providerId="ADAL" clId="{F0AE5C43-1844-5897-9CB1-3CA326E8E62B}" dt="2026-04-02T17:13:47.882" v="255" actId="555"/>
          <ac:spMkLst>
            <pc:docMk/>
            <pc:sldMk cId="2493341208" sldId="292"/>
            <ac:spMk id="7" creationId="{A2EF6C4C-2E4A-737E-85C9-65913AF8E07A}"/>
          </ac:spMkLst>
        </pc:spChg>
        <pc:spChg chg="mod">
          <ac:chgData name="Jessica Tyler" userId="a8ac3dbb-21db-45f9-ba94-e12509dd3320" providerId="ADAL" clId="{F0AE5C43-1844-5897-9CB1-3CA326E8E62B}" dt="2026-04-02T17:13:47.882" v="255" actId="555"/>
          <ac:spMkLst>
            <pc:docMk/>
            <pc:sldMk cId="2493341208" sldId="292"/>
            <ac:spMk id="8" creationId="{B1924B90-D8E0-2611-09F8-F1E4709551D2}"/>
          </ac:spMkLst>
        </pc:spChg>
        <pc:spChg chg="mod">
          <ac:chgData name="Jessica Tyler" userId="a8ac3dbb-21db-45f9-ba94-e12509dd3320" providerId="ADAL" clId="{F0AE5C43-1844-5897-9CB1-3CA326E8E62B}" dt="2026-04-02T17:13:47.882" v="255" actId="555"/>
          <ac:spMkLst>
            <pc:docMk/>
            <pc:sldMk cId="2493341208" sldId="292"/>
            <ac:spMk id="9" creationId="{C60006AF-E651-3FC8-449D-BA57E99D6798}"/>
          </ac:spMkLst>
        </pc:spChg>
        <pc:spChg chg="mod">
          <ac:chgData name="Jessica Tyler" userId="a8ac3dbb-21db-45f9-ba94-e12509dd3320" providerId="ADAL" clId="{F0AE5C43-1844-5897-9CB1-3CA326E8E62B}" dt="2026-04-02T17:09:49.742" v="199" actId="1035"/>
          <ac:spMkLst>
            <pc:docMk/>
            <pc:sldMk cId="2493341208" sldId="292"/>
            <ac:spMk id="10" creationId="{96A7CA88-925B-7A15-8C5A-B777631200BE}"/>
          </ac:spMkLst>
        </pc:spChg>
        <pc:spChg chg="mod">
          <ac:chgData name="Jessica Tyler" userId="a8ac3dbb-21db-45f9-ba94-e12509dd3320" providerId="ADAL" clId="{F0AE5C43-1844-5897-9CB1-3CA326E8E62B}" dt="2026-04-02T17:09:49.742" v="199" actId="1035"/>
          <ac:spMkLst>
            <pc:docMk/>
            <pc:sldMk cId="2493341208" sldId="292"/>
            <ac:spMk id="11" creationId="{0F9E6EC7-D96B-DDE9-BFE4-000C69830281}"/>
          </ac:spMkLst>
        </pc:spChg>
        <pc:spChg chg="mod">
          <ac:chgData name="Jessica Tyler" userId="a8ac3dbb-21db-45f9-ba94-e12509dd3320" providerId="ADAL" clId="{F0AE5C43-1844-5897-9CB1-3CA326E8E62B}" dt="2026-04-02T17:09:49.742" v="199" actId="1035"/>
          <ac:spMkLst>
            <pc:docMk/>
            <pc:sldMk cId="2493341208" sldId="292"/>
            <ac:spMk id="12" creationId="{705B257E-CA45-4136-56D0-5F7F1767C559}"/>
          </ac:spMkLst>
        </pc:spChg>
        <pc:spChg chg="mod">
          <ac:chgData name="Jessica Tyler" userId="a8ac3dbb-21db-45f9-ba94-e12509dd3320" providerId="ADAL" clId="{F0AE5C43-1844-5897-9CB1-3CA326E8E62B}" dt="2026-04-02T17:09:49.742" v="199" actId="1035"/>
          <ac:spMkLst>
            <pc:docMk/>
            <pc:sldMk cId="2493341208" sldId="292"/>
            <ac:spMk id="13" creationId="{7E64BDCB-1AA0-1822-68FC-E9C40A80BF03}"/>
          </ac:spMkLst>
        </pc:spChg>
        <pc:spChg chg="mod">
          <ac:chgData name="Jessica Tyler" userId="a8ac3dbb-21db-45f9-ba94-e12509dd3320" providerId="ADAL" clId="{F0AE5C43-1844-5897-9CB1-3CA326E8E62B}" dt="2026-04-02T17:13:05.827" v="246" actId="1036"/>
          <ac:spMkLst>
            <pc:docMk/>
            <pc:sldMk cId="2493341208" sldId="292"/>
            <ac:spMk id="16" creationId="{2756FB95-5DE9-D4A9-A489-26DC00C931B6}"/>
          </ac:spMkLst>
        </pc:spChg>
        <pc:spChg chg="del">
          <ac:chgData name="Jessica Tyler" userId="a8ac3dbb-21db-45f9-ba94-e12509dd3320" providerId="ADAL" clId="{F0AE5C43-1844-5897-9CB1-3CA326E8E62B}" dt="2026-04-02T17:07:51.760" v="150" actId="478"/>
          <ac:spMkLst>
            <pc:docMk/>
            <pc:sldMk cId="2493341208" sldId="292"/>
            <ac:spMk id="17" creationId="{A32C6825-52A5-2E36-02D9-310B0800C387}"/>
          </ac:spMkLst>
        </pc:spChg>
        <pc:spChg chg="del">
          <ac:chgData name="Jessica Tyler" userId="a8ac3dbb-21db-45f9-ba94-e12509dd3320" providerId="ADAL" clId="{F0AE5C43-1844-5897-9CB1-3CA326E8E62B}" dt="2026-04-02T17:07:51.760" v="150" actId="478"/>
          <ac:spMkLst>
            <pc:docMk/>
            <pc:sldMk cId="2493341208" sldId="292"/>
            <ac:spMk id="19" creationId="{1926E707-BD99-BD44-1A8C-44939FC206DA}"/>
          </ac:spMkLst>
        </pc:spChg>
        <pc:spChg chg="del">
          <ac:chgData name="Jessica Tyler" userId="a8ac3dbb-21db-45f9-ba94-e12509dd3320" providerId="ADAL" clId="{F0AE5C43-1844-5897-9CB1-3CA326E8E62B}" dt="2026-04-02T17:07:51.760" v="150" actId="478"/>
          <ac:spMkLst>
            <pc:docMk/>
            <pc:sldMk cId="2493341208" sldId="292"/>
            <ac:spMk id="21" creationId="{01346534-956A-A7FA-3722-C8D3C81EB434}"/>
          </ac:spMkLst>
        </pc:spChg>
        <pc:spChg chg="mod">
          <ac:chgData name="Jessica Tyler" userId="a8ac3dbb-21db-45f9-ba94-e12509dd3320" providerId="ADAL" clId="{F0AE5C43-1844-5897-9CB1-3CA326E8E62B}" dt="2026-04-02T17:17:09.507" v="267" actId="20577"/>
          <ac:spMkLst>
            <pc:docMk/>
            <pc:sldMk cId="2493341208" sldId="292"/>
            <ac:spMk id="23" creationId="{1F00D743-F6CD-1C04-97B5-ECF83ABDECA2}"/>
          </ac:spMkLst>
        </pc:spChg>
        <pc:spChg chg="mod">
          <ac:chgData name="Jessica Tyler" userId="a8ac3dbb-21db-45f9-ba94-e12509dd3320" providerId="ADAL" clId="{F0AE5C43-1844-5897-9CB1-3CA326E8E62B}" dt="2026-04-02T17:17:07.757" v="265" actId="20577"/>
          <ac:spMkLst>
            <pc:docMk/>
            <pc:sldMk cId="2493341208" sldId="292"/>
            <ac:spMk id="24" creationId="{8C98AC25-C55A-DA5A-63B8-5D2F1639378E}"/>
          </ac:spMkLst>
        </pc:spChg>
        <pc:spChg chg="mod">
          <ac:chgData name="Jessica Tyler" userId="a8ac3dbb-21db-45f9-ba94-e12509dd3320" providerId="ADAL" clId="{F0AE5C43-1844-5897-9CB1-3CA326E8E62B}" dt="2026-04-02T17:13:05.827" v="246" actId="1036"/>
          <ac:spMkLst>
            <pc:docMk/>
            <pc:sldMk cId="2493341208" sldId="292"/>
            <ac:spMk id="25" creationId="{83B692A5-84A5-0B88-7641-C98E1A14A640}"/>
          </ac:spMkLst>
        </pc:spChg>
        <pc:spChg chg="mod">
          <ac:chgData name="Jessica Tyler" userId="a8ac3dbb-21db-45f9-ba94-e12509dd3320" providerId="ADAL" clId="{F0AE5C43-1844-5897-9CB1-3CA326E8E62B}" dt="2026-04-02T17:13:05.827" v="246" actId="1036"/>
          <ac:spMkLst>
            <pc:docMk/>
            <pc:sldMk cId="2493341208" sldId="292"/>
            <ac:spMk id="26" creationId="{2BFF8E9D-266F-4C45-E57F-0FCFEBCE994B}"/>
          </ac:spMkLst>
        </pc:spChg>
        <pc:spChg chg="mod">
          <ac:chgData name="Jessica Tyler" userId="a8ac3dbb-21db-45f9-ba94-e12509dd3320" providerId="ADAL" clId="{F0AE5C43-1844-5897-9CB1-3CA326E8E62B}" dt="2026-04-02T17:13:05.827" v="246" actId="1036"/>
          <ac:spMkLst>
            <pc:docMk/>
            <pc:sldMk cId="2493341208" sldId="292"/>
            <ac:spMk id="29" creationId="{09AFF052-9884-FBFA-7C67-2BE519905821}"/>
          </ac:spMkLst>
        </pc:spChg>
        <pc:spChg chg="mod">
          <ac:chgData name="Jessica Tyler" userId="a8ac3dbb-21db-45f9-ba94-e12509dd3320" providerId="ADAL" clId="{F0AE5C43-1844-5897-9CB1-3CA326E8E62B}" dt="2026-04-02T17:13:05.827" v="246" actId="1036"/>
          <ac:spMkLst>
            <pc:docMk/>
            <pc:sldMk cId="2493341208" sldId="292"/>
            <ac:spMk id="30" creationId="{020CACBF-1A20-C2E3-F3CB-6389E10276E5}"/>
          </ac:spMkLst>
        </pc:spChg>
        <pc:picChg chg="mod">
          <ac:chgData name="Jessica Tyler" userId="a8ac3dbb-21db-45f9-ba94-e12509dd3320" providerId="ADAL" clId="{F0AE5C43-1844-5897-9CB1-3CA326E8E62B}" dt="2026-04-02T17:09:35.653" v="192" actId="1038"/>
          <ac:picMkLst>
            <pc:docMk/>
            <pc:sldMk cId="2493341208" sldId="292"/>
            <ac:picMk id="4" creationId="{C5E71BBD-8A41-0BE6-8583-7895189E33F0}"/>
          </ac:picMkLst>
        </pc:picChg>
        <pc:picChg chg="mod">
          <ac:chgData name="Jessica Tyler" userId="a8ac3dbb-21db-45f9-ba94-e12509dd3320" providerId="ADAL" clId="{F0AE5C43-1844-5897-9CB1-3CA326E8E62B}" dt="2026-04-02T17:09:35.653" v="192" actId="1038"/>
          <ac:picMkLst>
            <pc:docMk/>
            <pc:sldMk cId="2493341208" sldId="292"/>
            <ac:picMk id="5" creationId="{CC9309F7-1829-3FC9-5670-AF7AEAE89006}"/>
          </ac:picMkLst>
        </pc:picChg>
        <pc:picChg chg="mod modCrop">
          <ac:chgData name="Jessica Tyler" userId="a8ac3dbb-21db-45f9-ba94-e12509dd3320" providerId="ADAL" clId="{F0AE5C43-1844-5897-9CB1-3CA326E8E62B}" dt="2026-04-02T17:13:05.827" v="246" actId="1036"/>
          <ac:picMkLst>
            <pc:docMk/>
            <pc:sldMk cId="2493341208" sldId="292"/>
            <ac:picMk id="14" creationId="{8EB6B290-D3DB-8D87-381E-45EECEBF4D32}"/>
          </ac:picMkLst>
        </pc:picChg>
        <pc:picChg chg="mod modCrop">
          <ac:chgData name="Jessica Tyler" userId="a8ac3dbb-21db-45f9-ba94-e12509dd3320" providerId="ADAL" clId="{F0AE5C43-1844-5897-9CB1-3CA326E8E62B}" dt="2026-04-02T17:13:05.827" v="246" actId="1036"/>
          <ac:picMkLst>
            <pc:docMk/>
            <pc:sldMk cId="2493341208" sldId="292"/>
            <ac:picMk id="27" creationId="{5DFE3638-3209-358D-E846-5B87D4F74AB9}"/>
          </ac:picMkLst>
        </pc:picChg>
        <pc:cxnChg chg="mod">
          <ac:chgData name="Jessica Tyler" userId="a8ac3dbb-21db-45f9-ba94-e12509dd3320" providerId="ADAL" clId="{F0AE5C43-1844-5897-9CB1-3CA326E8E62B}" dt="2026-04-02T17:12:55.584" v="222" actId="1076"/>
          <ac:cxnSpMkLst>
            <pc:docMk/>
            <pc:sldMk cId="2493341208" sldId="292"/>
            <ac:cxnSpMk id="15" creationId="{9466F422-6032-AC01-9B5F-AFF126270DEB}"/>
          </ac:cxnSpMkLst>
        </pc:cxnChg>
        <pc:cxnChg chg="del">
          <ac:chgData name="Jessica Tyler" userId="a8ac3dbb-21db-45f9-ba94-e12509dd3320" providerId="ADAL" clId="{F0AE5C43-1844-5897-9CB1-3CA326E8E62B}" dt="2026-04-02T17:07:51.760" v="150" actId="478"/>
          <ac:cxnSpMkLst>
            <pc:docMk/>
            <pc:sldMk cId="2493341208" sldId="292"/>
            <ac:cxnSpMk id="18" creationId="{5A687623-24A0-6447-AEC8-44EB69A35966}"/>
          </ac:cxnSpMkLst>
        </pc:cxnChg>
        <pc:cxnChg chg="del">
          <ac:chgData name="Jessica Tyler" userId="a8ac3dbb-21db-45f9-ba94-e12509dd3320" providerId="ADAL" clId="{F0AE5C43-1844-5897-9CB1-3CA326E8E62B}" dt="2026-04-02T17:07:51.760" v="150" actId="478"/>
          <ac:cxnSpMkLst>
            <pc:docMk/>
            <pc:sldMk cId="2493341208" sldId="292"/>
            <ac:cxnSpMk id="20" creationId="{D4D11C18-9549-47C6-FE40-0CB46E6C1D45}"/>
          </ac:cxnSpMkLst>
        </pc:cxnChg>
        <pc:cxnChg chg="del">
          <ac:chgData name="Jessica Tyler" userId="a8ac3dbb-21db-45f9-ba94-e12509dd3320" providerId="ADAL" clId="{F0AE5C43-1844-5897-9CB1-3CA326E8E62B}" dt="2026-04-02T17:07:51.760" v="150" actId="478"/>
          <ac:cxnSpMkLst>
            <pc:docMk/>
            <pc:sldMk cId="2493341208" sldId="292"/>
            <ac:cxnSpMk id="22" creationId="{0FCC3460-CCBF-BD87-4F93-6503BBF690BB}"/>
          </ac:cxnSpMkLst>
        </pc:cxnChg>
        <pc:cxnChg chg="del mod">
          <ac:chgData name="Jessica Tyler" userId="a8ac3dbb-21db-45f9-ba94-e12509dd3320" providerId="ADAL" clId="{F0AE5C43-1844-5897-9CB1-3CA326E8E62B}" dt="2026-04-02T17:06:04.884" v="79" actId="478"/>
          <ac:cxnSpMkLst>
            <pc:docMk/>
            <pc:sldMk cId="2493341208" sldId="292"/>
            <ac:cxnSpMk id="28" creationId="{6A4C8CA2-16E8-05A6-C40E-8E5A127D95A3}"/>
          </ac:cxnSpMkLst>
        </pc:cxnChg>
        <pc:cxnChg chg="add mod">
          <ac:chgData name="Jessica Tyler" userId="a8ac3dbb-21db-45f9-ba94-e12509dd3320" providerId="ADAL" clId="{F0AE5C43-1844-5897-9CB1-3CA326E8E62B}" dt="2026-04-02T17:05:43.851" v="26"/>
          <ac:cxnSpMkLst>
            <pc:docMk/>
            <pc:sldMk cId="2493341208" sldId="292"/>
            <ac:cxnSpMk id="33" creationId="{1BDA22BF-680B-CF08-878A-780406E24CA3}"/>
          </ac:cxnSpMkLst>
        </pc:cxnChg>
        <pc:cxnChg chg="add mod">
          <ac:chgData name="Jessica Tyler" userId="a8ac3dbb-21db-45f9-ba94-e12509dd3320" providerId="ADAL" clId="{F0AE5C43-1844-5897-9CB1-3CA326E8E62B}" dt="2026-04-02T17:13:05.827" v="246" actId="1036"/>
          <ac:cxnSpMkLst>
            <pc:docMk/>
            <pc:sldMk cId="2493341208" sldId="292"/>
            <ac:cxnSpMk id="34" creationId="{35B4444C-C330-AF30-B1E5-DB4EFC5119D1}"/>
          </ac:cxnSpMkLst>
        </pc:cxn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/Users/kaylahbirmingham/Desktop/10.14.24_by4741_by4742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/Users/kaylahbirmingham/Library/Mobile%20Documents/com~apple~CloudDocs/LAB/CLS%20and%20RLS/CLS/10.3.22/CR+SAM%20for%20F31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/Users/kaylahbirmingham/Desktop/05.08.2023_met2CLS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file:////Users/kaylahbirmingham/Library/Mobile%20Documents/com~apple~CloudDocs/LAB/CLS%20and%20RLS/CLS/02.13.23/02.13.23_ppm1_rph1.xlsx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5.xml"/><Relationship Id="rId1" Type="http://schemas.openxmlformats.org/officeDocument/2006/relationships/oleObject" Target="file:////Users/kaylahbirmingham/Library/Mobile%20Documents/com~apple~CloudDocs/LAB/CLS%20and%20RLS/CLS/04.10.23/04.10.23%20CLS%20ppm1.xlsx" TargetMode="Externa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6.xml"/><Relationship Id="rId1" Type="http://schemas.openxmlformats.org/officeDocument/2006/relationships/oleObject" Target="file:////Users/kaylahbirmingham/Library/Mobile%20Documents/com~apple~CloudDocs/LAB/CLS%20and%20RLS/CLS/06.12.24/06.12.24_rts1_cdc55.xlsx" TargetMode="Externa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7.xml"/><Relationship Id="rId1" Type="http://schemas.openxmlformats.org/officeDocument/2006/relationships/oleObject" Target="file:////Users/kaylahbirmingham/Library/Mobile%20Documents/com~apple~CloudDocs/LAB/CLS%20and%20RLS/CLS/04.29.2024/04.29.2024_D+SAM.xlsx" TargetMode="Externa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8.xml"/><Relationship Id="rId1" Type="http://schemas.openxmlformats.org/officeDocument/2006/relationships/oleObject" Target="file:////Users/kaylahbirmingham/Library/Mobile%20Documents/com~apple~CloudDocs/LAB/CLS%20and%20RLS/CLS/09.09.24/20240909_MR_plus_me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75027702303627"/>
          <c:y val="3.6708889156042979E-2"/>
          <c:w val="0.74889262626591924"/>
          <c:h val="0.74447039620221078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C$7</c:f>
              <c:strCache>
                <c:ptCount val="1"/>
                <c:pt idx="0">
                  <c:v>BY4742</c:v>
                </c:pt>
              </c:strCache>
            </c:strRef>
          </c:tx>
          <c:spPr>
            <a:ln w="12700" cap="rnd">
              <a:solidFill>
                <a:srgbClr val="0673C4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bg1"/>
              </a:solidFill>
              <a:ln w="3175">
                <a:solidFill>
                  <a:srgbClr val="0673C4"/>
                </a:solidFill>
              </a:ln>
              <a:effectLst/>
            </c:spPr>
          </c:marker>
          <c:xVal>
            <c:numRef>
              <c:f>Sheet1!$D$6:$S$6</c:f>
              <c:numCache>
                <c:formatCode>General</c:formatCode>
                <c:ptCount val="16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9</c:v>
                </c:pt>
                <c:pt idx="4">
                  <c:v>11</c:v>
                </c:pt>
                <c:pt idx="5">
                  <c:v>13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1</c:v>
                </c:pt>
                <c:pt idx="10">
                  <c:v>23</c:v>
                </c:pt>
                <c:pt idx="11">
                  <c:v>25</c:v>
                </c:pt>
                <c:pt idx="12">
                  <c:v>27</c:v>
                </c:pt>
                <c:pt idx="13">
                  <c:v>29</c:v>
                </c:pt>
                <c:pt idx="14">
                  <c:v>31</c:v>
                </c:pt>
                <c:pt idx="15">
                  <c:v>33</c:v>
                </c:pt>
              </c:numCache>
            </c:numRef>
          </c:xVal>
          <c:yVal>
            <c:numRef>
              <c:f>Sheet1!$D$7:$S$7</c:f>
              <c:numCache>
                <c:formatCode>General</c:formatCode>
                <c:ptCount val="16"/>
                <c:pt idx="0">
                  <c:v>1</c:v>
                </c:pt>
                <c:pt idx="1">
                  <c:v>0.89340912833999997</c:v>
                </c:pt>
                <c:pt idx="2">
                  <c:v>0.81109234299999999</c:v>
                </c:pt>
                <c:pt idx="3">
                  <c:v>0.73102934799999997</c:v>
                </c:pt>
                <c:pt idx="4">
                  <c:v>0.70109233999999998</c:v>
                </c:pt>
                <c:pt idx="5">
                  <c:v>0.59142093799999995</c:v>
                </c:pt>
                <c:pt idx="6">
                  <c:v>0.44109843119999997</c:v>
                </c:pt>
                <c:pt idx="7">
                  <c:v>0.351092348</c:v>
                </c:pt>
                <c:pt idx="8">
                  <c:v>0.19231904129999999</c:v>
                </c:pt>
                <c:pt idx="9">
                  <c:v>9.2039481300000003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9C9-B342-AF9B-2CE367674108}"/>
            </c:ext>
          </c:extLst>
        </c:ser>
        <c:ser>
          <c:idx val="1"/>
          <c:order val="1"/>
          <c:tx>
            <c:strRef>
              <c:f>Sheet1!$C$8</c:f>
              <c:strCache>
                <c:ptCount val="1"/>
                <c:pt idx="0">
                  <c:v>BY4742 met15∆</c:v>
                </c:pt>
              </c:strCache>
            </c:strRef>
          </c:tx>
          <c:spPr>
            <a:ln w="12700" cap="rnd">
              <a:solidFill>
                <a:srgbClr val="F6D256"/>
              </a:solidFill>
              <a:round/>
            </a:ln>
            <a:effectLst/>
          </c:spPr>
          <c:marker>
            <c:symbol val="square"/>
            <c:size val="4"/>
            <c:spPr>
              <a:solidFill>
                <a:schemeClr val="bg1"/>
              </a:solidFill>
              <a:ln w="3175">
                <a:solidFill>
                  <a:srgbClr val="F6D256"/>
                </a:solidFill>
              </a:ln>
              <a:effectLst/>
            </c:spPr>
          </c:marker>
          <c:xVal>
            <c:numRef>
              <c:f>Sheet1!$D$6:$S$6</c:f>
              <c:numCache>
                <c:formatCode>General</c:formatCode>
                <c:ptCount val="16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9</c:v>
                </c:pt>
                <c:pt idx="4">
                  <c:v>11</c:v>
                </c:pt>
                <c:pt idx="5">
                  <c:v>13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1</c:v>
                </c:pt>
                <c:pt idx="10">
                  <c:v>23</c:v>
                </c:pt>
                <c:pt idx="11">
                  <c:v>25</c:v>
                </c:pt>
                <c:pt idx="12">
                  <c:v>27</c:v>
                </c:pt>
                <c:pt idx="13">
                  <c:v>29</c:v>
                </c:pt>
                <c:pt idx="14">
                  <c:v>31</c:v>
                </c:pt>
                <c:pt idx="15">
                  <c:v>33</c:v>
                </c:pt>
              </c:numCache>
            </c:numRef>
          </c:xVal>
          <c:yVal>
            <c:numRef>
              <c:f>Sheet1!$D$8:$S$8</c:f>
              <c:numCache>
                <c:formatCode>General</c:formatCode>
                <c:ptCount val="16"/>
                <c:pt idx="0">
                  <c:v>1</c:v>
                </c:pt>
                <c:pt idx="1">
                  <c:v>0.92190238400000002</c:v>
                </c:pt>
                <c:pt idx="2">
                  <c:v>0.87123094812000001</c:v>
                </c:pt>
                <c:pt idx="3">
                  <c:v>0.791029384</c:v>
                </c:pt>
                <c:pt idx="4">
                  <c:v>0.78918343400000002</c:v>
                </c:pt>
                <c:pt idx="5">
                  <c:v>0.72192083409999996</c:v>
                </c:pt>
                <c:pt idx="6">
                  <c:v>0.60109342340000005</c:v>
                </c:pt>
                <c:pt idx="7">
                  <c:v>0.5212903418</c:v>
                </c:pt>
                <c:pt idx="8">
                  <c:v>0.43910234809999998</c:v>
                </c:pt>
                <c:pt idx="9">
                  <c:v>0.40120931399999998</c:v>
                </c:pt>
                <c:pt idx="10">
                  <c:v>0.38109834100000001</c:v>
                </c:pt>
                <c:pt idx="11">
                  <c:v>0.33102938412999999</c:v>
                </c:pt>
                <c:pt idx="12">
                  <c:v>0.27398412080000001</c:v>
                </c:pt>
                <c:pt idx="13">
                  <c:v>0.2030918343</c:v>
                </c:pt>
                <c:pt idx="14">
                  <c:v>0.12095908431000001</c:v>
                </c:pt>
                <c:pt idx="15">
                  <c:v>8.1209384122999995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9C9-B342-AF9B-2CE367674108}"/>
            </c:ext>
          </c:extLst>
        </c:ser>
        <c:ser>
          <c:idx val="2"/>
          <c:order val="2"/>
          <c:tx>
            <c:strRef>
              <c:f>Sheet1!$C$9</c:f>
              <c:strCache>
                <c:ptCount val="1"/>
                <c:pt idx="0">
                  <c:v>BY4741 </c:v>
                </c:pt>
              </c:strCache>
            </c:strRef>
          </c:tx>
          <c:spPr>
            <a:ln w="12700" cap="rnd">
              <a:solidFill>
                <a:srgbClr val="25B160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bg1"/>
              </a:solidFill>
              <a:ln w="3175">
                <a:solidFill>
                  <a:srgbClr val="25B160"/>
                </a:solidFill>
              </a:ln>
              <a:effectLst/>
            </c:spPr>
          </c:marker>
          <c:xVal>
            <c:numRef>
              <c:f>Sheet1!$D$6:$S$6</c:f>
              <c:numCache>
                <c:formatCode>General</c:formatCode>
                <c:ptCount val="16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9</c:v>
                </c:pt>
                <c:pt idx="4">
                  <c:v>11</c:v>
                </c:pt>
                <c:pt idx="5">
                  <c:v>13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1</c:v>
                </c:pt>
                <c:pt idx="10">
                  <c:v>23</c:v>
                </c:pt>
                <c:pt idx="11">
                  <c:v>25</c:v>
                </c:pt>
                <c:pt idx="12">
                  <c:v>27</c:v>
                </c:pt>
                <c:pt idx="13">
                  <c:v>29</c:v>
                </c:pt>
                <c:pt idx="14">
                  <c:v>31</c:v>
                </c:pt>
                <c:pt idx="15">
                  <c:v>33</c:v>
                </c:pt>
              </c:numCache>
            </c:numRef>
          </c:xVal>
          <c:yVal>
            <c:numRef>
              <c:f>Sheet1!$D$9:$S$9</c:f>
              <c:numCache>
                <c:formatCode>General</c:formatCode>
                <c:ptCount val="16"/>
                <c:pt idx="0">
                  <c:v>1</c:v>
                </c:pt>
                <c:pt idx="1">
                  <c:v>0.98238941023000004</c:v>
                </c:pt>
                <c:pt idx="2">
                  <c:v>0.92309418229999995</c:v>
                </c:pt>
                <c:pt idx="3">
                  <c:v>0.85091238410000003</c:v>
                </c:pt>
                <c:pt idx="4">
                  <c:v>0.80912349800000005</c:v>
                </c:pt>
                <c:pt idx="5">
                  <c:v>0.74109283412299998</c:v>
                </c:pt>
                <c:pt idx="6">
                  <c:v>0.70109238419999997</c:v>
                </c:pt>
                <c:pt idx="7">
                  <c:v>0.55192348124000001</c:v>
                </c:pt>
                <c:pt idx="8">
                  <c:v>0.48102394120000003</c:v>
                </c:pt>
                <c:pt idx="9">
                  <c:v>0.41230914819999998</c:v>
                </c:pt>
                <c:pt idx="10">
                  <c:v>0.35019340999999998</c:v>
                </c:pt>
                <c:pt idx="11">
                  <c:v>0.30019283400000002</c:v>
                </c:pt>
                <c:pt idx="12">
                  <c:v>0.29084193400000002</c:v>
                </c:pt>
                <c:pt idx="13">
                  <c:v>0.20910983429999999</c:v>
                </c:pt>
                <c:pt idx="14">
                  <c:v>0.1910298342</c:v>
                </c:pt>
                <c:pt idx="15">
                  <c:v>8.3109238409999994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E9C9-B342-AF9B-2CE3676741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29961279"/>
        <c:axId val="1229532863"/>
      </c:scatterChart>
      <c:valAx>
        <c:axId val="1229961279"/>
        <c:scaling>
          <c:orientation val="minMax"/>
          <c:max val="40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 sz="1000" b="0"/>
                </a:pPr>
                <a:r>
                  <a:rPr lang="en-US" sz="1000" b="0"/>
                  <a:t>Time (day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sz="900"/>
            </a:pPr>
            <a:endParaRPr lang="en-US"/>
          </a:p>
        </c:txPr>
        <c:crossAx val="1229532863"/>
        <c:crosses val="autoZero"/>
        <c:crossBetween val="midCat"/>
        <c:majorUnit val="10"/>
      </c:valAx>
      <c:valAx>
        <c:axId val="1229532863"/>
        <c:scaling>
          <c:orientation val="minMax"/>
          <c:max val="1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 b="0"/>
                </a:pPr>
                <a:r>
                  <a:rPr lang="en-US" sz="1000" b="0"/>
                  <a:t>Surviva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sz="900"/>
            </a:pPr>
            <a:endParaRPr lang="en-US"/>
          </a:p>
        </c:txPr>
        <c:crossAx val="1229961279"/>
        <c:crosses val="autoZero"/>
        <c:crossBetween val="midCat"/>
        <c:majorUnit val="0.2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  <c:extLst/>
  </c:chart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75027702303627"/>
          <c:y val="3.6708889156042979E-2"/>
          <c:w val="0.74249733487870628"/>
          <c:h val="0.75042292473521544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B$5</c:f>
              <c:strCache>
                <c:ptCount val="1"/>
                <c:pt idx="0">
                  <c:v>Control</c:v>
                </c:pt>
              </c:strCache>
            </c:strRef>
          </c:tx>
          <c:spPr>
            <a:ln w="12700" cap="rnd">
              <a:solidFill>
                <a:srgbClr val="0673C4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bg1"/>
              </a:solidFill>
              <a:ln w="3175">
                <a:solidFill>
                  <a:srgbClr val="0673C4"/>
                </a:solidFill>
              </a:ln>
              <a:effectLst/>
            </c:spPr>
          </c:marker>
          <c:xVal>
            <c:numRef>
              <c:f>Sheet1!$C$4:$Z$4</c:f>
              <c:numCache>
                <c:formatCode>General</c:formatCode>
                <c:ptCount val="24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30</c:v>
                </c:pt>
                <c:pt idx="14">
                  <c:v>34</c:v>
                </c:pt>
                <c:pt idx="15">
                  <c:v>36</c:v>
                </c:pt>
                <c:pt idx="16">
                  <c:v>38</c:v>
                </c:pt>
                <c:pt idx="17">
                  <c:v>40</c:v>
                </c:pt>
                <c:pt idx="18">
                  <c:v>42</c:v>
                </c:pt>
                <c:pt idx="19">
                  <c:v>45</c:v>
                </c:pt>
                <c:pt idx="20">
                  <c:v>47</c:v>
                </c:pt>
                <c:pt idx="21">
                  <c:v>49</c:v>
                </c:pt>
                <c:pt idx="22">
                  <c:v>55</c:v>
                </c:pt>
                <c:pt idx="23">
                  <c:v>59</c:v>
                </c:pt>
              </c:numCache>
            </c:numRef>
          </c:xVal>
          <c:yVal>
            <c:numRef>
              <c:f>Sheet1!$C$5:$Z$5</c:f>
              <c:numCache>
                <c:formatCode>General</c:formatCode>
                <c:ptCount val="24"/>
                <c:pt idx="0">
                  <c:v>1</c:v>
                </c:pt>
                <c:pt idx="1">
                  <c:v>0.9070696721</c:v>
                </c:pt>
                <c:pt idx="2">
                  <c:v>0.74754098359999999</c:v>
                </c:pt>
                <c:pt idx="3">
                  <c:v>0.69344262300000004</c:v>
                </c:pt>
                <c:pt idx="4">
                  <c:v>0.67418032790000004</c:v>
                </c:pt>
                <c:pt idx="5">
                  <c:v>0.52407786889999997</c:v>
                </c:pt>
                <c:pt idx="6">
                  <c:v>0.47008196720000001</c:v>
                </c:pt>
                <c:pt idx="7">
                  <c:v>0.3765368852</c:v>
                </c:pt>
                <c:pt idx="8">
                  <c:v>0.36649590160000001</c:v>
                </c:pt>
                <c:pt idx="9">
                  <c:v>0.23237704919999999</c:v>
                </c:pt>
                <c:pt idx="10">
                  <c:v>0.1319415984</c:v>
                </c:pt>
                <c:pt idx="11">
                  <c:v>8.0327868849999998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F30-FC47-A592-6FAD23CFE432}"/>
            </c:ext>
          </c:extLst>
        </c:ser>
        <c:ser>
          <c:idx val="1"/>
          <c:order val="1"/>
          <c:tx>
            <c:strRef>
              <c:f>Sheet1!$B$6</c:f>
              <c:strCache>
                <c:ptCount val="1"/>
                <c:pt idx="0">
                  <c:v>Control+SAM</c:v>
                </c:pt>
              </c:strCache>
            </c:strRef>
          </c:tx>
          <c:spPr>
            <a:ln w="12700" cap="rnd">
              <a:solidFill>
                <a:srgbClr val="F6D256"/>
              </a:solidFill>
              <a:round/>
            </a:ln>
            <a:effectLst/>
          </c:spPr>
          <c:marker>
            <c:symbol val="square"/>
            <c:size val="4"/>
            <c:spPr>
              <a:solidFill>
                <a:schemeClr val="bg1"/>
              </a:solidFill>
              <a:ln w="3175">
                <a:solidFill>
                  <a:srgbClr val="F6D256"/>
                </a:solidFill>
              </a:ln>
              <a:effectLst/>
            </c:spPr>
          </c:marker>
          <c:xVal>
            <c:numRef>
              <c:f>Sheet1!$C$4:$Z$4</c:f>
              <c:numCache>
                <c:formatCode>General</c:formatCode>
                <c:ptCount val="24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30</c:v>
                </c:pt>
                <c:pt idx="14">
                  <c:v>34</c:v>
                </c:pt>
                <c:pt idx="15">
                  <c:v>36</c:v>
                </c:pt>
                <c:pt idx="16">
                  <c:v>38</c:v>
                </c:pt>
                <c:pt idx="17">
                  <c:v>40</c:v>
                </c:pt>
                <c:pt idx="18">
                  <c:v>42</c:v>
                </c:pt>
                <c:pt idx="19">
                  <c:v>45</c:v>
                </c:pt>
                <c:pt idx="20">
                  <c:v>47</c:v>
                </c:pt>
                <c:pt idx="21">
                  <c:v>49</c:v>
                </c:pt>
                <c:pt idx="22">
                  <c:v>55</c:v>
                </c:pt>
                <c:pt idx="23">
                  <c:v>59</c:v>
                </c:pt>
              </c:numCache>
            </c:numRef>
          </c:xVal>
          <c:yVal>
            <c:numRef>
              <c:f>Sheet1!$C$6:$Z$6</c:f>
              <c:numCache>
                <c:formatCode>General</c:formatCode>
                <c:ptCount val="24"/>
                <c:pt idx="0">
                  <c:v>1</c:v>
                </c:pt>
                <c:pt idx="1">
                  <c:v>0.82188221709999998</c:v>
                </c:pt>
                <c:pt idx="2">
                  <c:v>0.71177829100000001</c:v>
                </c:pt>
                <c:pt idx="3">
                  <c:v>0.51167329100000003</c:v>
                </c:pt>
                <c:pt idx="4">
                  <c:v>0.40109699770000001</c:v>
                </c:pt>
                <c:pt idx="5">
                  <c:v>0.3838625866</c:v>
                </c:pt>
                <c:pt idx="6">
                  <c:v>0.29500577369999997</c:v>
                </c:pt>
                <c:pt idx="7">
                  <c:v>0.12563510389999999</c:v>
                </c:pt>
                <c:pt idx="8">
                  <c:v>9.6218244800000005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F30-FC47-A592-6FAD23CFE432}"/>
            </c:ext>
          </c:extLst>
        </c:ser>
        <c:ser>
          <c:idx val="2"/>
          <c:order val="2"/>
          <c:tx>
            <c:strRef>
              <c:f>Sheet1!$B$7</c:f>
              <c:strCache>
                <c:ptCount val="1"/>
                <c:pt idx="0">
                  <c:v>0.05% glucose</c:v>
                </c:pt>
              </c:strCache>
            </c:strRef>
          </c:tx>
          <c:spPr>
            <a:ln w="12700" cap="rnd">
              <a:solidFill>
                <a:srgbClr val="25B160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bg1"/>
              </a:solidFill>
              <a:ln w="3175">
                <a:solidFill>
                  <a:srgbClr val="25B160"/>
                </a:solidFill>
              </a:ln>
              <a:effectLst/>
            </c:spPr>
          </c:marker>
          <c:xVal>
            <c:numRef>
              <c:f>Sheet1!$C$4:$Z$4</c:f>
              <c:numCache>
                <c:formatCode>General</c:formatCode>
                <c:ptCount val="24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30</c:v>
                </c:pt>
                <c:pt idx="14">
                  <c:v>34</c:v>
                </c:pt>
                <c:pt idx="15">
                  <c:v>36</c:v>
                </c:pt>
                <c:pt idx="16">
                  <c:v>38</c:v>
                </c:pt>
                <c:pt idx="17">
                  <c:v>40</c:v>
                </c:pt>
                <c:pt idx="18">
                  <c:v>42</c:v>
                </c:pt>
                <c:pt idx="19">
                  <c:v>45</c:v>
                </c:pt>
                <c:pt idx="20">
                  <c:v>47</c:v>
                </c:pt>
                <c:pt idx="21">
                  <c:v>49</c:v>
                </c:pt>
                <c:pt idx="22">
                  <c:v>55</c:v>
                </c:pt>
                <c:pt idx="23">
                  <c:v>59</c:v>
                </c:pt>
              </c:numCache>
            </c:numRef>
          </c:xVal>
          <c:yVal>
            <c:numRef>
              <c:f>Sheet1!$C$7:$Z$7</c:f>
              <c:numCache>
                <c:formatCode>General</c:formatCode>
                <c:ptCount val="24"/>
                <c:pt idx="0">
                  <c:v>1</c:v>
                </c:pt>
                <c:pt idx="1">
                  <c:v>0.90307377050000004</c:v>
                </c:pt>
                <c:pt idx="2">
                  <c:v>0.88756091999999998</c:v>
                </c:pt>
                <c:pt idx="3">
                  <c:v>0.87894467210000005</c:v>
                </c:pt>
                <c:pt idx="4">
                  <c:v>0.87051741800000004</c:v>
                </c:pt>
                <c:pt idx="5">
                  <c:v>0.78865266389999999</c:v>
                </c:pt>
                <c:pt idx="6">
                  <c:v>0.70432889340000004</c:v>
                </c:pt>
                <c:pt idx="7">
                  <c:v>0.68775614750000003</c:v>
                </c:pt>
                <c:pt idx="8">
                  <c:v>0.61321721309999999</c:v>
                </c:pt>
                <c:pt idx="9">
                  <c:v>0.61206454919999997</c:v>
                </c:pt>
                <c:pt idx="10">
                  <c:v>0.56916495899999997</c:v>
                </c:pt>
                <c:pt idx="11">
                  <c:v>0.521039959</c:v>
                </c:pt>
                <c:pt idx="12">
                  <c:v>0.50017930330000004</c:v>
                </c:pt>
                <c:pt idx="13">
                  <c:v>0.3863422131</c:v>
                </c:pt>
                <c:pt idx="14">
                  <c:v>0.33099385250000002</c:v>
                </c:pt>
                <c:pt idx="15">
                  <c:v>0.29754098359999998</c:v>
                </c:pt>
                <c:pt idx="16">
                  <c:v>0.26839139340000001</c:v>
                </c:pt>
                <c:pt idx="17">
                  <c:v>0.25604508199999998</c:v>
                </c:pt>
                <c:pt idx="18">
                  <c:v>0.24774590160000001</c:v>
                </c:pt>
                <c:pt idx="19">
                  <c:v>0.20348360660000001</c:v>
                </c:pt>
                <c:pt idx="20">
                  <c:v>0.20619877049999999</c:v>
                </c:pt>
                <c:pt idx="21">
                  <c:v>0.17149077870000001</c:v>
                </c:pt>
                <c:pt idx="22">
                  <c:v>0.119585041</c:v>
                </c:pt>
                <c:pt idx="23">
                  <c:v>5.442622951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0F30-FC47-A592-6FAD23CFE432}"/>
            </c:ext>
          </c:extLst>
        </c:ser>
        <c:ser>
          <c:idx val="3"/>
          <c:order val="3"/>
          <c:tx>
            <c:strRef>
              <c:f>Sheet1!$B$8</c:f>
              <c:strCache>
                <c:ptCount val="1"/>
                <c:pt idx="0">
                  <c:v>0.05% glucose+SAM</c:v>
                </c:pt>
              </c:strCache>
            </c:strRef>
          </c:tx>
          <c:spPr>
            <a:ln w="12700" cap="rnd">
              <a:solidFill>
                <a:srgbClr val="F45000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bg1"/>
              </a:solidFill>
              <a:ln w="3175">
                <a:solidFill>
                  <a:srgbClr val="F45000"/>
                </a:solidFill>
              </a:ln>
              <a:effectLst/>
            </c:spPr>
          </c:marker>
          <c:xVal>
            <c:numRef>
              <c:f>Sheet1!$C$4:$Z$4</c:f>
              <c:numCache>
                <c:formatCode>General</c:formatCode>
                <c:ptCount val="24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30</c:v>
                </c:pt>
                <c:pt idx="14">
                  <c:v>34</c:v>
                </c:pt>
                <c:pt idx="15">
                  <c:v>36</c:v>
                </c:pt>
                <c:pt idx="16">
                  <c:v>38</c:v>
                </c:pt>
                <c:pt idx="17">
                  <c:v>40</c:v>
                </c:pt>
                <c:pt idx="18">
                  <c:v>42</c:v>
                </c:pt>
                <c:pt idx="19">
                  <c:v>45</c:v>
                </c:pt>
                <c:pt idx="20">
                  <c:v>47</c:v>
                </c:pt>
                <c:pt idx="21">
                  <c:v>49</c:v>
                </c:pt>
                <c:pt idx="22">
                  <c:v>55</c:v>
                </c:pt>
                <c:pt idx="23">
                  <c:v>59</c:v>
                </c:pt>
              </c:numCache>
            </c:numRef>
          </c:xVal>
          <c:yVal>
            <c:numRef>
              <c:f>Sheet1!$C$8:$Z$8</c:f>
              <c:numCache>
                <c:formatCode>General</c:formatCode>
                <c:ptCount val="24"/>
                <c:pt idx="0">
                  <c:v>1</c:v>
                </c:pt>
                <c:pt idx="1">
                  <c:v>0.88021221149999995</c:v>
                </c:pt>
                <c:pt idx="2">
                  <c:v>0.85740878629999995</c:v>
                </c:pt>
                <c:pt idx="3">
                  <c:v>0.82222635889999995</c:v>
                </c:pt>
                <c:pt idx="4">
                  <c:v>0.823194341</c:v>
                </c:pt>
                <c:pt idx="5">
                  <c:v>0.71941548769999997</c:v>
                </c:pt>
                <c:pt idx="6">
                  <c:v>0.62419334820000005</c:v>
                </c:pt>
                <c:pt idx="7">
                  <c:v>0.54380739639999998</c:v>
                </c:pt>
                <c:pt idx="8">
                  <c:v>0.52835691240000004</c:v>
                </c:pt>
                <c:pt idx="9">
                  <c:v>0.50037230079999995</c:v>
                </c:pt>
                <c:pt idx="10">
                  <c:v>0.48099032019999999</c:v>
                </c:pt>
                <c:pt idx="11">
                  <c:v>0.4738278729</c:v>
                </c:pt>
                <c:pt idx="12">
                  <c:v>0.44759865970000001</c:v>
                </c:pt>
                <c:pt idx="13">
                  <c:v>0.3852320675</c:v>
                </c:pt>
                <c:pt idx="14">
                  <c:v>0.30725986599999999</c:v>
                </c:pt>
                <c:pt idx="15">
                  <c:v>0.29754098359999998</c:v>
                </c:pt>
                <c:pt idx="16">
                  <c:v>0.2583913934</c:v>
                </c:pt>
                <c:pt idx="17">
                  <c:v>0.257259866</c:v>
                </c:pt>
                <c:pt idx="18">
                  <c:v>0.25815959300000002</c:v>
                </c:pt>
                <c:pt idx="19">
                  <c:v>0.22340592000000001</c:v>
                </c:pt>
                <c:pt idx="20">
                  <c:v>0.22727972199999999</c:v>
                </c:pt>
                <c:pt idx="21">
                  <c:v>0.1678456193</c:v>
                </c:pt>
                <c:pt idx="22">
                  <c:v>6.041201291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0F30-FC47-A592-6FAD23CFE4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29961279"/>
        <c:axId val="1229532863"/>
      </c:scatterChart>
      <c:valAx>
        <c:axId val="1229961279"/>
        <c:scaling>
          <c:orientation val="minMax"/>
          <c:max val="60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 sz="1000" b="0"/>
                </a:pPr>
                <a:r>
                  <a:rPr lang="en-US" sz="1000" b="0"/>
                  <a:t>Time (day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sz="900"/>
            </a:pPr>
            <a:endParaRPr lang="en-US"/>
          </a:p>
        </c:txPr>
        <c:crossAx val="1229532863"/>
        <c:crosses val="autoZero"/>
        <c:crossBetween val="midCat"/>
        <c:majorUnit val="10"/>
      </c:valAx>
      <c:valAx>
        <c:axId val="1229532863"/>
        <c:scaling>
          <c:orientation val="minMax"/>
          <c:max val="1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 b="0"/>
                </a:pPr>
                <a:r>
                  <a:rPr lang="en-US" sz="1000" b="0"/>
                  <a:t>Surviva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sz="900"/>
            </a:pPr>
            <a:endParaRPr lang="en-US"/>
          </a:p>
        </c:txPr>
        <c:crossAx val="1229961279"/>
        <c:crosses val="autoZero"/>
        <c:crossBetween val="midCat"/>
        <c:majorUnit val="0.2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  <c:extLst/>
  </c:chart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825064529837256"/>
          <c:y val="3.6781666028010238E-2"/>
          <c:w val="0.73339899095009087"/>
          <c:h val="0.71835633438412405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C$6</c:f>
              <c:strCache>
                <c:ptCount val="1"/>
                <c:pt idx="0">
                  <c:v>Control</c:v>
                </c:pt>
              </c:strCache>
            </c:strRef>
          </c:tx>
          <c:spPr>
            <a:ln w="9525" cap="rnd">
              <a:solidFill>
                <a:srgbClr val="0673C4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bg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D$5:$R$5</c:f>
              <c:numCache>
                <c:formatCode>General</c:formatCode>
                <c:ptCount val="15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9</c:v>
                </c:pt>
                <c:pt idx="4">
                  <c:v>11</c:v>
                </c:pt>
                <c:pt idx="5">
                  <c:v>13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1</c:v>
                </c:pt>
                <c:pt idx="10">
                  <c:v>23</c:v>
                </c:pt>
                <c:pt idx="11">
                  <c:v>25</c:v>
                </c:pt>
                <c:pt idx="12">
                  <c:v>27</c:v>
                </c:pt>
                <c:pt idx="13">
                  <c:v>29</c:v>
                </c:pt>
                <c:pt idx="14">
                  <c:v>31</c:v>
                </c:pt>
              </c:numCache>
            </c:numRef>
          </c:xVal>
          <c:yVal>
            <c:numRef>
              <c:f>Sheet1!$D$6:$R$6</c:f>
              <c:numCache>
                <c:formatCode>General</c:formatCode>
                <c:ptCount val="15"/>
                <c:pt idx="0">
                  <c:v>1</c:v>
                </c:pt>
                <c:pt idx="1">
                  <c:v>0.85762892079999997</c:v>
                </c:pt>
                <c:pt idx="2">
                  <c:v>0.70334928230000004</c:v>
                </c:pt>
                <c:pt idx="3">
                  <c:v>0.68070175440000003</c:v>
                </c:pt>
                <c:pt idx="4">
                  <c:v>0.63936735779999998</c:v>
                </c:pt>
                <c:pt idx="5">
                  <c:v>0.59883040939999999</c:v>
                </c:pt>
                <c:pt idx="6">
                  <c:v>0.35805422650000002</c:v>
                </c:pt>
                <c:pt idx="7">
                  <c:v>0.27597022859999998</c:v>
                </c:pt>
                <c:pt idx="8">
                  <c:v>9.5587453480000001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4F5-6E49-B784-71A03AA45DF1}"/>
            </c:ext>
          </c:extLst>
        </c:ser>
        <c:ser>
          <c:idx val="1"/>
          <c:order val="1"/>
          <c:tx>
            <c:strRef>
              <c:f>Sheet1!$C$7</c:f>
              <c:strCache>
                <c:ptCount val="1"/>
                <c:pt idx="0">
                  <c:v>met15∆</c:v>
                </c:pt>
              </c:strCache>
            </c:strRef>
          </c:tx>
          <c:spPr>
            <a:ln w="9525" cap="rnd">
              <a:solidFill>
                <a:srgbClr val="25B160"/>
              </a:solidFill>
              <a:round/>
            </a:ln>
            <a:effectLst/>
          </c:spPr>
          <c:marker>
            <c:symbol val="square"/>
            <c:size val="4"/>
            <c:spPr>
              <a:solidFill>
                <a:schemeClr val="bg1"/>
              </a:solidFill>
              <a:ln w="9525">
                <a:solidFill>
                  <a:srgbClr val="25B160"/>
                </a:solidFill>
              </a:ln>
              <a:effectLst/>
            </c:spPr>
          </c:marker>
          <c:xVal>
            <c:numRef>
              <c:f>Sheet1!$D$5:$R$5</c:f>
              <c:numCache>
                <c:formatCode>General</c:formatCode>
                <c:ptCount val="15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9</c:v>
                </c:pt>
                <c:pt idx="4">
                  <c:v>11</c:v>
                </c:pt>
                <c:pt idx="5">
                  <c:v>13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1</c:v>
                </c:pt>
                <c:pt idx="10">
                  <c:v>23</c:v>
                </c:pt>
                <c:pt idx="11">
                  <c:v>25</c:v>
                </c:pt>
                <c:pt idx="12">
                  <c:v>27</c:v>
                </c:pt>
                <c:pt idx="13">
                  <c:v>29</c:v>
                </c:pt>
                <c:pt idx="14">
                  <c:v>31</c:v>
                </c:pt>
              </c:numCache>
            </c:numRef>
          </c:xVal>
          <c:yVal>
            <c:numRef>
              <c:f>Sheet1!$D$7:$R$7</c:f>
              <c:numCache>
                <c:formatCode>General</c:formatCode>
                <c:ptCount val="15"/>
                <c:pt idx="0">
                  <c:v>1</c:v>
                </c:pt>
                <c:pt idx="1">
                  <c:v>0.93362206950000004</c:v>
                </c:pt>
                <c:pt idx="2">
                  <c:v>0.80571509269999997</c:v>
                </c:pt>
                <c:pt idx="3">
                  <c:v>0.78919122490000004</c:v>
                </c:pt>
                <c:pt idx="4">
                  <c:v>0.74437435269999996</c:v>
                </c:pt>
                <c:pt idx="5">
                  <c:v>0.72309575370000001</c:v>
                </c:pt>
                <c:pt idx="6">
                  <c:v>0.61999811689999995</c:v>
                </c:pt>
                <c:pt idx="7">
                  <c:v>0.55427925810000001</c:v>
                </c:pt>
                <c:pt idx="8">
                  <c:v>0.55018359849999998</c:v>
                </c:pt>
                <c:pt idx="9">
                  <c:v>0.42580736279999998</c:v>
                </c:pt>
                <c:pt idx="10">
                  <c:v>0.3205206666</c:v>
                </c:pt>
                <c:pt idx="11">
                  <c:v>0.3205206666</c:v>
                </c:pt>
                <c:pt idx="12">
                  <c:v>0.28084690709999999</c:v>
                </c:pt>
                <c:pt idx="13">
                  <c:v>0.16674512759999999</c:v>
                </c:pt>
                <c:pt idx="14">
                  <c:v>8.1409231299999996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4F5-6E49-B784-71A03AA45DF1}"/>
            </c:ext>
          </c:extLst>
        </c:ser>
        <c:ser>
          <c:idx val="2"/>
          <c:order val="2"/>
          <c:tx>
            <c:strRef>
              <c:f>Sheet1!$C$8</c:f>
              <c:strCache>
                <c:ptCount val="1"/>
                <c:pt idx="0">
                  <c:v>met2∆</c:v>
                </c:pt>
              </c:strCache>
            </c:strRef>
          </c:tx>
          <c:spPr>
            <a:ln w="9525" cap="rnd">
              <a:solidFill>
                <a:srgbClr val="F6D256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bg1"/>
              </a:solidFill>
              <a:ln w="9525">
                <a:solidFill>
                  <a:srgbClr val="F6D256"/>
                </a:solidFill>
              </a:ln>
              <a:effectLst/>
            </c:spPr>
          </c:marker>
          <c:xVal>
            <c:numRef>
              <c:f>Sheet1!$D$5:$R$5</c:f>
              <c:numCache>
                <c:formatCode>General</c:formatCode>
                <c:ptCount val="15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9</c:v>
                </c:pt>
                <c:pt idx="4">
                  <c:v>11</c:v>
                </c:pt>
                <c:pt idx="5">
                  <c:v>13</c:v>
                </c:pt>
                <c:pt idx="6">
                  <c:v>15</c:v>
                </c:pt>
                <c:pt idx="7">
                  <c:v>17</c:v>
                </c:pt>
                <c:pt idx="8">
                  <c:v>19</c:v>
                </c:pt>
                <c:pt idx="9">
                  <c:v>21</c:v>
                </c:pt>
                <c:pt idx="10">
                  <c:v>23</c:v>
                </c:pt>
                <c:pt idx="11">
                  <c:v>25</c:v>
                </c:pt>
                <c:pt idx="12">
                  <c:v>27</c:v>
                </c:pt>
                <c:pt idx="13">
                  <c:v>29</c:v>
                </c:pt>
                <c:pt idx="14">
                  <c:v>31</c:v>
                </c:pt>
              </c:numCache>
            </c:numRef>
          </c:xVal>
          <c:yVal>
            <c:numRef>
              <c:f>Sheet1!$D$8:$R$8</c:f>
              <c:numCache>
                <c:formatCode>General</c:formatCode>
                <c:ptCount val="15"/>
                <c:pt idx="0">
                  <c:v>1</c:v>
                </c:pt>
                <c:pt idx="1">
                  <c:v>0.89738805970000002</c:v>
                </c:pt>
                <c:pt idx="2">
                  <c:v>0.85575412409999996</c:v>
                </c:pt>
                <c:pt idx="3">
                  <c:v>0.85361842109999997</c:v>
                </c:pt>
                <c:pt idx="4">
                  <c:v>0.77445011779999995</c:v>
                </c:pt>
                <c:pt idx="5">
                  <c:v>0.69756480750000005</c:v>
                </c:pt>
                <c:pt idx="6">
                  <c:v>0.46396307930000003</c:v>
                </c:pt>
                <c:pt idx="7">
                  <c:v>0.45134524739999998</c:v>
                </c:pt>
                <c:pt idx="8">
                  <c:v>0.39018853100000001</c:v>
                </c:pt>
                <c:pt idx="9">
                  <c:v>0.38102906520000002</c:v>
                </c:pt>
                <c:pt idx="10">
                  <c:v>0.2428809898</c:v>
                </c:pt>
                <c:pt idx="11">
                  <c:v>0.2428809898</c:v>
                </c:pt>
                <c:pt idx="12">
                  <c:v>0.22192900630000001</c:v>
                </c:pt>
                <c:pt idx="13">
                  <c:v>0.12691476830000001</c:v>
                </c:pt>
                <c:pt idx="14">
                  <c:v>7.8123984320000006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04F5-6E49-B784-71A03AA45D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6295519"/>
        <c:axId val="86275135"/>
      </c:scatterChart>
      <c:valAx>
        <c:axId val="86295519"/>
        <c:scaling>
          <c:orientation val="minMax"/>
          <c:max val="4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b="0">
                    <a:solidFill>
                      <a:schemeClr val="tx1"/>
                    </a:solidFill>
                  </a:rPr>
                  <a:t>Time (days)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275135"/>
        <c:crosses val="autoZero"/>
        <c:crossBetween val="midCat"/>
        <c:majorUnit val="10"/>
      </c:valAx>
      <c:valAx>
        <c:axId val="86275135"/>
        <c:scaling>
          <c:orientation val="minMax"/>
          <c:max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dirty="0">
                    <a:solidFill>
                      <a:schemeClr val="tx1"/>
                    </a:solidFill>
                  </a:rPr>
                  <a:t>Surviva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295519"/>
        <c:crosses val="autoZero"/>
        <c:crossBetween val="midCat"/>
        <c:majorUnit val="0.2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  <c:extLst/>
  </c:chart>
  <c:txPr>
    <a:bodyPr/>
    <a:lstStyle/>
    <a:p>
      <a:pPr>
        <a:defRPr sz="11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75027702303627"/>
          <c:y val="3.6708889156042979E-2"/>
          <c:w val="0.74764018844737368"/>
          <c:h val="0.75042292473521544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C$48</c:f>
              <c:strCache>
                <c:ptCount val="1"/>
                <c:pt idx="0">
                  <c:v>Control</c:v>
                </c:pt>
              </c:strCache>
            </c:strRef>
          </c:tx>
          <c:spPr>
            <a:ln w="12700" cap="rnd">
              <a:solidFill>
                <a:srgbClr val="0673C4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bg1"/>
              </a:solidFill>
              <a:ln w="3175">
                <a:solidFill>
                  <a:srgbClr val="0673C4"/>
                </a:solidFill>
              </a:ln>
              <a:effectLst/>
            </c:spPr>
          </c:marker>
          <c:xVal>
            <c:numRef>
              <c:f>Sheet1!$D$47:$S$47</c:f>
              <c:numCache>
                <c:formatCode>General</c:formatCode>
                <c:ptCount val="16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10</c:v>
                </c:pt>
                <c:pt idx="4">
                  <c:v>12</c:v>
                </c:pt>
                <c:pt idx="5">
                  <c:v>14</c:v>
                </c:pt>
                <c:pt idx="6">
                  <c:v>16</c:v>
                </c:pt>
                <c:pt idx="7">
                  <c:v>18</c:v>
                </c:pt>
                <c:pt idx="8">
                  <c:v>20</c:v>
                </c:pt>
                <c:pt idx="9">
                  <c:v>22</c:v>
                </c:pt>
                <c:pt idx="10">
                  <c:v>24</c:v>
                </c:pt>
                <c:pt idx="11">
                  <c:v>26</c:v>
                </c:pt>
                <c:pt idx="12">
                  <c:v>28</c:v>
                </c:pt>
                <c:pt idx="13">
                  <c:v>30</c:v>
                </c:pt>
                <c:pt idx="14">
                  <c:v>32</c:v>
                </c:pt>
                <c:pt idx="15">
                  <c:v>34</c:v>
                </c:pt>
              </c:numCache>
            </c:numRef>
          </c:xVal>
          <c:yVal>
            <c:numRef>
              <c:f>Sheet1!$D$48:$S$48</c:f>
              <c:numCache>
                <c:formatCode>General</c:formatCode>
                <c:ptCount val="16"/>
                <c:pt idx="0">
                  <c:v>1</c:v>
                </c:pt>
                <c:pt idx="1">
                  <c:v>0.97658198610000002</c:v>
                </c:pt>
                <c:pt idx="2">
                  <c:v>0.89752886840000001</c:v>
                </c:pt>
                <c:pt idx="3">
                  <c:v>0.80159353349999996</c:v>
                </c:pt>
                <c:pt idx="4">
                  <c:v>0.70071593529999998</c:v>
                </c:pt>
                <c:pt idx="5">
                  <c:v>0.54563972289999996</c:v>
                </c:pt>
                <c:pt idx="6">
                  <c:v>0.50773672059999997</c:v>
                </c:pt>
                <c:pt idx="7">
                  <c:v>0.43709299540000002</c:v>
                </c:pt>
                <c:pt idx="8">
                  <c:v>0.308785643</c:v>
                </c:pt>
                <c:pt idx="9">
                  <c:v>0.1996766744</c:v>
                </c:pt>
                <c:pt idx="10">
                  <c:v>9.7430715939999996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ED5-4047-AD37-7F1A516C0BC3}"/>
            </c:ext>
          </c:extLst>
        </c:ser>
        <c:ser>
          <c:idx val="1"/>
          <c:order val="1"/>
          <c:tx>
            <c:strRef>
              <c:f>Sheet1!$C$49</c:f>
              <c:strCache>
                <c:ptCount val="1"/>
                <c:pt idx="0">
                  <c:v>MR</c:v>
                </c:pt>
              </c:strCache>
            </c:strRef>
          </c:tx>
          <c:spPr>
            <a:ln w="12700" cap="rnd">
              <a:solidFill>
                <a:srgbClr val="25B160"/>
              </a:solidFill>
              <a:round/>
            </a:ln>
            <a:effectLst/>
          </c:spPr>
          <c:marker>
            <c:symbol val="square"/>
            <c:size val="4"/>
            <c:spPr>
              <a:solidFill>
                <a:schemeClr val="bg1"/>
              </a:solidFill>
              <a:ln w="3175">
                <a:solidFill>
                  <a:srgbClr val="25B160"/>
                </a:solidFill>
              </a:ln>
              <a:effectLst/>
            </c:spPr>
          </c:marker>
          <c:xVal>
            <c:numRef>
              <c:f>Sheet1!$D$47:$S$47</c:f>
              <c:numCache>
                <c:formatCode>General</c:formatCode>
                <c:ptCount val="16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10</c:v>
                </c:pt>
                <c:pt idx="4">
                  <c:v>12</c:v>
                </c:pt>
                <c:pt idx="5">
                  <c:v>14</c:v>
                </c:pt>
                <c:pt idx="6">
                  <c:v>16</c:v>
                </c:pt>
                <c:pt idx="7">
                  <c:v>18</c:v>
                </c:pt>
                <c:pt idx="8">
                  <c:v>20</c:v>
                </c:pt>
                <c:pt idx="9">
                  <c:v>22</c:v>
                </c:pt>
                <c:pt idx="10">
                  <c:v>24</c:v>
                </c:pt>
                <c:pt idx="11">
                  <c:v>26</c:v>
                </c:pt>
                <c:pt idx="12">
                  <c:v>28</c:v>
                </c:pt>
                <c:pt idx="13">
                  <c:v>30</c:v>
                </c:pt>
                <c:pt idx="14">
                  <c:v>32</c:v>
                </c:pt>
                <c:pt idx="15">
                  <c:v>34</c:v>
                </c:pt>
              </c:numCache>
            </c:numRef>
          </c:xVal>
          <c:yVal>
            <c:numRef>
              <c:f>Sheet1!$D$49:$S$49</c:f>
              <c:numCache>
                <c:formatCode>General</c:formatCode>
                <c:ptCount val="16"/>
                <c:pt idx="0">
                  <c:v>1</c:v>
                </c:pt>
                <c:pt idx="1">
                  <c:v>0.9751754386</c:v>
                </c:pt>
                <c:pt idx="2">
                  <c:v>0.93030214420000001</c:v>
                </c:pt>
                <c:pt idx="3">
                  <c:v>0.90078947369999995</c:v>
                </c:pt>
                <c:pt idx="4">
                  <c:v>0.88231237819999997</c:v>
                </c:pt>
                <c:pt idx="5">
                  <c:v>0.82774853800000003</c:v>
                </c:pt>
                <c:pt idx="6">
                  <c:v>0.7824227279</c:v>
                </c:pt>
                <c:pt idx="7">
                  <c:v>0.67017041190000004</c:v>
                </c:pt>
                <c:pt idx="8">
                  <c:v>0.55868442949999997</c:v>
                </c:pt>
                <c:pt idx="9">
                  <c:v>0.48758528270000001</c:v>
                </c:pt>
                <c:pt idx="10">
                  <c:v>0.37081794950000002</c:v>
                </c:pt>
                <c:pt idx="11">
                  <c:v>0.33402472979999998</c:v>
                </c:pt>
                <c:pt idx="12">
                  <c:v>0.27695540940000002</c:v>
                </c:pt>
                <c:pt idx="13">
                  <c:v>0.19249512669999999</c:v>
                </c:pt>
                <c:pt idx="14">
                  <c:v>0.1442495127</c:v>
                </c:pt>
                <c:pt idx="15">
                  <c:v>9.4755116959999997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ED5-4047-AD37-7F1A516C0BC3}"/>
            </c:ext>
          </c:extLst>
        </c:ser>
        <c:ser>
          <c:idx val="2"/>
          <c:order val="2"/>
          <c:tx>
            <c:strRef>
              <c:f>Sheet1!$C$50</c:f>
              <c:strCache>
                <c:ptCount val="1"/>
                <c:pt idx="0">
                  <c:v>rph1∆</c:v>
                </c:pt>
              </c:strCache>
            </c:strRef>
          </c:tx>
          <c:spPr>
            <a:ln w="12700" cap="rnd">
              <a:solidFill>
                <a:srgbClr val="F6D256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bg1"/>
              </a:solidFill>
              <a:ln w="3175">
                <a:solidFill>
                  <a:srgbClr val="F6D256"/>
                </a:solidFill>
              </a:ln>
              <a:effectLst/>
            </c:spPr>
          </c:marker>
          <c:xVal>
            <c:numRef>
              <c:f>Sheet1!$D$47:$S$47</c:f>
              <c:numCache>
                <c:formatCode>General</c:formatCode>
                <c:ptCount val="16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10</c:v>
                </c:pt>
                <c:pt idx="4">
                  <c:v>12</c:v>
                </c:pt>
                <c:pt idx="5">
                  <c:v>14</c:v>
                </c:pt>
                <c:pt idx="6">
                  <c:v>16</c:v>
                </c:pt>
                <c:pt idx="7">
                  <c:v>18</c:v>
                </c:pt>
                <c:pt idx="8">
                  <c:v>20</c:v>
                </c:pt>
                <c:pt idx="9">
                  <c:v>22</c:v>
                </c:pt>
                <c:pt idx="10">
                  <c:v>24</c:v>
                </c:pt>
                <c:pt idx="11">
                  <c:v>26</c:v>
                </c:pt>
                <c:pt idx="12">
                  <c:v>28</c:v>
                </c:pt>
                <c:pt idx="13">
                  <c:v>30</c:v>
                </c:pt>
                <c:pt idx="14">
                  <c:v>32</c:v>
                </c:pt>
                <c:pt idx="15">
                  <c:v>34</c:v>
                </c:pt>
              </c:numCache>
            </c:numRef>
          </c:xVal>
          <c:yVal>
            <c:numRef>
              <c:f>Sheet1!$D$50:$S$50</c:f>
              <c:numCache>
                <c:formatCode>General</c:formatCode>
                <c:ptCount val="16"/>
                <c:pt idx="0">
                  <c:v>1</c:v>
                </c:pt>
                <c:pt idx="1">
                  <c:v>0.98613541530000004</c:v>
                </c:pt>
                <c:pt idx="2">
                  <c:v>0.87414187639999996</c:v>
                </c:pt>
                <c:pt idx="3">
                  <c:v>0.83288464129999995</c:v>
                </c:pt>
                <c:pt idx="4">
                  <c:v>0.67182662540000004</c:v>
                </c:pt>
                <c:pt idx="5">
                  <c:v>0.63804011309999997</c:v>
                </c:pt>
                <c:pt idx="6">
                  <c:v>0.38363171359999998</c:v>
                </c:pt>
                <c:pt idx="7">
                  <c:v>0.25911966619999999</c:v>
                </c:pt>
                <c:pt idx="8">
                  <c:v>0.15661596450000001</c:v>
                </c:pt>
                <c:pt idx="9">
                  <c:v>9.4875487950000004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FED5-4047-AD37-7F1A516C0BC3}"/>
            </c:ext>
          </c:extLst>
        </c:ser>
        <c:ser>
          <c:idx val="3"/>
          <c:order val="3"/>
          <c:tx>
            <c:strRef>
              <c:f>Sheet1!$C$51</c:f>
              <c:strCache>
                <c:ptCount val="1"/>
                <c:pt idx="0">
                  <c:v>rph1∆ MR</c:v>
                </c:pt>
              </c:strCache>
            </c:strRef>
          </c:tx>
          <c:spPr>
            <a:ln w="12700" cap="rnd">
              <a:solidFill>
                <a:srgbClr val="F45000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bg1"/>
              </a:solidFill>
              <a:ln w="3175">
                <a:solidFill>
                  <a:srgbClr val="F45000"/>
                </a:solidFill>
              </a:ln>
              <a:effectLst/>
            </c:spPr>
          </c:marker>
          <c:xVal>
            <c:numRef>
              <c:f>Sheet1!$D$47:$S$47</c:f>
              <c:numCache>
                <c:formatCode>General</c:formatCode>
                <c:ptCount val="16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10</c:v>
                </c:pt>
                <c:pt idx="4">
                  <c:v>12</c:v>
                </c:pt>
                <c:pt idx="5">
                  <c:v>14</c:v>
                </c:pt>
                <c:pt idx="6">
                  <c:v>16</c:v>
                </c:pt>
                <c:pt idx="7">
                  <c:v>18</c:v>
                </c:pt>
                <c:pt idx="8">
                  <c:v>20</c:v>
                </c:pt>
                <c:pt idx="9">
                  <c:v>22</c:v>
                </c:pt>
                <c:pt idx="10">
                  <c:v>24</c:v>
                </c:pt>
                <c:pt idx="11">
                  <c:v>26</c:v>
                </c:pt>
                <c:pt idx="12">
                  <c:v>28</c:v>
                </c:pt>
                <c:pt idx="13">
                  <c:v>30</c:v>
                </c:pt>
                <c:pt idx="14">
                  <c:v>32</c:v>
                </c:pt>
                <c:pt idx="15">
                  <c:v>34</c:v>
                </c:pt>
              </c:numCache>
            </c:numRef>
          </c:xVal>
          <c:yVal>
            <c:numRef>
              <c:f>Sheet1!$D$51:$S$51</c:f>
              <c:numCache>
                <c:formatCode>General</c:formatCode>
                <c:ptCount val="16"/>
                <c:pt idx="0">
                  <c:v>1</c:v>
                </c:pt>
                <c:pt idx="1">
                  <c:v>0.99890919010000001</c:v>
                </c:pt>
                <c:pt idx="2">
                  <c:v>0.98745568579999998</c:v>
                </c:pt>
                <c:pt idx="3">
                  <c:v>0.99215980370000001</c:v>
                </c:pt>
                <c:pt idx="4">
                  <c:v>0.90455413139999996</c:v>
                </c:pt>
                <c:pt idx="5">
                  <c:v>0.8999181893</c:v>
                </c:pt>
                <c:pt idx="6">
                  <c:v>0.79455958550000005</c:v>
                </c:pt>
                <c:pt idx="7">
                  <c:v>0.57932233430000002</c:v>
                </c:pt>
                <c:pt idx="8">
                  <c:v>0.57253886009999999</c:v>
                </c:pt>
                <c:pt idx="9">
                  <c:v>0.42950640849999999</c:v>
                </c:pt>
                <c:pt idx="10">
                  <c:v>0.30200095449999997</c:v>
                </c:pt>
                <c:pt idx="11">
                  <c:v>0.25080106349999998</c:v>
                </c:pt>
                <c:pt idx="12">
                  <c:v>0.1610649032</c:v>
                </c:pt>
                <c:pt idx="13">
                  <c:v>0.1199890919</c:v>
                </c:pt>
                <c:pt idx="14">
                  <c:v>8.6215571310000003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FED5-4047-AD37-7F1A516C0B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29961279"/>
        <c:axId val="1229532863"/>
      </c:scatterChart>
      <c:valAx>
        <c:axId val="1229961279"/>
        <c:scaling>
          <c:orientation val="minMax"/>
          <c:max val="40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 sz="1000"/>
                </a:pPr>
                <a:r>
                  <a:rPr lang="en-US" sz="1000"/>
                  <a:t>Time (day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sz="900"/>
            </a:pPr>
            <a:endParaRPr lang="en-US"/>
          </a:p>
        </c:txPr>
        <c:crossAx val="1229532863"/>
        <c:crosses val="autoZero"/>
        <c:crossBetween val="midCat"/>
        <c:majorUnit val="10"/>
      </c:valAx>
      <c:valAx>
        <c:axId val="1229532863"/>
        <c:scaling>
          <c:orientation val="minMax"/>
          <c:max val="1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/>
                  <a:t>Surviva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sz="900"/>
            </a:pPr>
            <a:endParaRPr lang="en-US"/>
          </a:p>
        </c:txPr>
        <c:crossAx val="1229961279"/>
        <c:crosses val="autoZero"/>
        <c:crossBetween val="midCat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  <c:extLst/>
  </c:chart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029575726519506"/>
          <c:y val="0.11924413081187875"/>
          <c:w val="0.63397933479402613"/>
          <c:h val="0.60389798223764124"/>
        </c:manualLayout>
      </c:layout>
      <c:scatterChart>
        <c:scatterStyle val="lineMarker"/>
        <c:varyColors val="0"/>
        <c:ser>
          <c:idx val="8"/>
          <c:order val="0"/>
          <c:tx>
            <c:strRef>
              <c:f>Sheet1!$C$30</c:f>
              <c:strCache>
                <c:ptCount val="1"/>
                <c:pt idx="0">
                  <c:v>Control</c:v>
                </c:pt>
              </c:strCache>
            </c:strRef>
          </c:tx>
          <c:spPr>
            <a:ln w="9525" cap="rnd">
              <a:solidFill>
                <a:srgbClr val="0673C4"/>
              </a:solidFill>
              <a:round/>
            </a:ln>
            <a:effectLst/>
          </c:spPr>
          <c:xVal>
            <c:numRef>
              <c:f>Sheet1!$D$29:$T$29</c:f>
              <c:numCache>
                <c:formatCode>General</c:formatCode>
                <c:ptCount val="17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9</c:v>
                </c:pt>
                <c:pt idx="4">
                  <c:v>11</c:v>
                </c:pt>
                <c:pt idx="5">
                  <c:v>14</c:v>
                </c:pt>
                <c:pt idx="6">
                  <c:v>17</c:v>
                </c:pt>
                <c:pt idx="7">
                  <c:v>19</c:v>
                </c:pt>
                <c:pt idx="8">
                  <c:v>21</c:v>
                </c:pt>
                <c:pt idx="9">
                  <c:v>23</c:v>
                </c:pt>
                <c:pt idx="10">
                  <c:v>25</c:v>
                </c:pt>
                <c:pt idx="11">
                  <c:v>27</c:v>
                </c:pt>
                <c:pt idx="12">
                  <c:v>29</c:v>
                </c:pt>
                <c:pt idx="13">
                  <c:v>31</c:v>
                </c:pt>
                <c:pt idx="14">
                  <c:v>33</c:v>
                </c:pt>
                <c:pt idx="15">
                  <c:v>35</c:v>
                </c:pt>
                <c:pt idx="16">
                  <c:v>37</c:v>
                </c:pt>
              </c:numCache>
            </c:numRef>
          </c:xVal>
          <c:yVal>
            <c:numRef>
              <c:f>Sheet1!$D$30:$T$30</c:f>
              <c:numCache>
                <c:formatCode>General</c:formatCode>
                <c:ptCount val="17"/>
                <c:pt idx="0">
                  <c:v>1</c:v>
                </c:pt>
                <c:pt idx="1">
                  <c:v>0.98333740979999995</c:v>
                </c:pt>
                <c:pt idx="2">
                  <c:v>0.84346337289999995</c:v>
                </c:pt>
                <c:pt idx="3">
                  <c:v>0.7833374098</c:v>
                </c:pt>
                <c:pt idx="4">
                  <c:v>0.74220374219999996</c:v>
                </c:pt>
                <c:pt idx="5">
                  <c:v>0.61244955359999997</c:v>
                </c:pt>
                <c:pt idx="6">
                  <c:v>0.36833496389999998</c:v>
                </c:pt>
                <c:pt idx="7">
                  <c:v>0.31747584690000002</c:v>
                </c:pt>
                <c:pt idx="8">
                  <c:v>0.17775467780000001</c:v>
                </c:pt>
                <c:pt idx="9">
                  <c:v>9.575638987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D6C-1943-8018-581A37B009BC}"/>
            </c:ext>
          </c:extLst>
        </c:ser>
        <c:ser>
          <c:idx val="10"/>
          <c:order val="1"/>
          <c:tx>
            <c:strRef>
              <c:f>Sheet1!$C$32</c:f>
              <c:strCache>
                <c:ptCount val="1"/>
                <c:pt idx="0">
                  <c:v>MR</c:v>
                </c:pt>
              </c:strCache>
            </c:strRef>
          </c:tx>
          <c:spPr>
            <a:ln w="9525" cap="rnd">
              <a:solidFill>
                <a:srgbClr val="25B160"/>
              </a:solidFill>
              <a:round/>
            </a:ln>
            <a:effectLst/>
          </c:spPr>
          <c:xVal>
            <c:numRef>
              <c:f>Sheet1!$D$29:$T$29</c:f>
              <c:numCache>
                <c:formatCode>General</c:formatCode>
                <c:ptCount val="17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9</c:v>
                </c:pt>
                <c:pt idx="4">
                  <c:v>11</c:v>
                </c:pt>
                <c:pt idx="5">
                  <c:v>14</c:v>
                </c:pt>
                <c:pt idx="6">
                  <c:v>17</c:v>
                </c:pt>
                <c:pt idx="7">
                  <c:v>19</c:v>
                </c:pt>
                <c:pt idx="8">
                  <c:v>21</c:v>
                </c:pt>
                <c:pt idx="9">
                  <c:v>23</c:v>
                </c:pt>
                <c:pt idx="10">
                  <c:v>25</c:v>
                </c:pt>
                <c:pt idx="11">
                  <c:v>27</c:v>
                </c:pt>
                <c:pt idx="12">
                  <c:v>29</c:v>
                </c:pt>
                <c:pt idx="13">
                  <c:v>31</c:v>
                </c:pt>
                <c:pt idx="14">
                  <c:v>33</c:v>
                </c:pt>
                <c:pt idx="15">
                  <c:v>35</c:v>
                </c:pt>
                <c:pt idx="16">
                  <c:v>37</c:v>
                </c:pt>
              </c:numCache>
            </c:numRef>
          </c:xVal>
          <c:yVal>
            <c:numRef>
              <c:f>Sheet1!$D$32:$T$32</c:f>
              <c:numCache>
                <c:formatCode>General</c:formatCode>
                <c:ptCount val="17"/>
                <c:pt idx="0">
                  <c:v>1</c:v>
                </c:pt>
                <c:pt idx="1">
                  <c:v>0.95601655350000003</c:v>
                </c:pt>
                <c:pt idx="2">
                  <c:v>0.93601655350000001</c:v>
                </c:pt>
                <c:pt idx="3">
                  <c:v>0.8532205008</c:v>
                </c:pt>
                <c:pt idx="4">
                  <c:v>0.84242359929999999</c:v>
                </c:pt>
                <c:pt idx="5">
                  <c:v>0.78947368419999997</c:v>
                </c:pt>
                <c:pt idx="6">
                  <c:v>0.74930922099999997</c:v>
                </c:pt>
                <c:pt idx="7">
                  <c:v>0.68502082310000001</c:v>
                </c:pt>
                <c:pt idx="8">
                  <c:v>0.61092182510000004</c:v>
                </c:pt>
                <c:pt idx="9">
                  <c:v>0.6001618259</c:v>
                </c:pt>
                <c:pt idx="10">
                  <c:v>0.51013682589999998</c:v>
                </c:pt>
                <c:pt idx="11">
                  <c:v>0.31015652830000001</c:v>
                </c:pt>
                <c:pt idx="12">
                  <c:v>0.23905630999999999</c:v>
                </c:pt>
                <c:pt idx="13">
                  <c:v>0.15045352889999999</c:v>
                </c:pt>
                <c:pt idx="14">
                  <c:v>9.0453528899999996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8D6C-1943-8018-581A37B009BC}"/>
            </c:ext>
          </c:extLst>
        </c:ser>
        <c:ser>
          <c:idx val="12"/>
          <c:order val="2"/>
          <c:tx>
            <c:strRef>
              <c:f>Sheet1!$C$34</c:f>
              <c:strCache>
                <c:ptCount val="1"/>
                <c:pt idx="0">
                  <c:v>ppm1∆</c:v>
                </c:pt>
              </c:strCache>
            </c:strRef>
          </c:tx>
          <c:spPr>
            <a:ln w="9525" cap="rnd">
              <a:solidFill>
                <a:srgbClr val="F6D256"/>
              </a:solidFill>
              <a:round/>
            </a:ln>
            <a:effectLst/>
          </c:spPr>
          <c:xVal>
            <c:numRef>
              <c:f>Sheet1!$D$29:$T$29</c:f>
              <c:numCache>
                <c:formatCode>General</c:formatCode>
                <c:ptCount val="17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9</c:v>
                </c:pt>
                <c:pt idx="4">
                  <c:v>11</c:v>
                </c:pt>
                <c:pt idx="5">
                  <c:v>14</c:v>
                </c:pt>
                <c:pt idx="6">
                  <c:v>17</c:v>
                </c:pt>
                <c:pt idx="7">
                  <c:v>19</c:v>
                </c:pt>
                <c:pt idx="8">
                  <c:v>21</c:v>
                </c:pt>
                <c:pt idx="9">
                  <c:v>23</c:v>
                </c:pt>
                <c:pt idx="10">
                  <c:v>25</c:v>
                </c:pt>
                <c:pt idx="11">
                  <c:v>27</c:v>
                </c:pt>
                <c:pt idx="12">
                  <c:v>29</c:v>
                </c:pt>
                <c:pt idx="13">
                  <c:v>31</c:v>
                </c:pt>
                <c:pt idx="14">
                  <c:v>33</c:v>
                </c:pt>
                <c:pt idx="15">
                  <c:v>35</c:v>
                </c:pt>
                <c:pt idx="16">
                  <c:v>37</c:v>
                </c:pt>
              </c:numCache>
            </c:numRef>
          </c:xVal>
          <c:yVal>
            <c:numRef>
              <c:f>Sheet1!$D$34:$T$34</c:f>
              <c:numCache>
                <c:formatCode>General</c:formatCode>
                <c:ptCount val="17"/>
                <c:pt idx="0">
                  <c:v>1</c:v>
                </c:pt>
                <c:pt idx="1">
                  <c:v>0.95</c:v>
                </c:pt>
                <c:pt idx="2">
                  <c:v>0.95390624999999996</c:v>
                </c:pt>
                <c:pt idx="3">
                  <c:v>0.94801136360000005</c:v>
                </c:pt>
                <c:pt idx="4">
                  <c:v>0.87045454550000001</c:v>
                </c:pt>
                <c:pt idx="5">
                  <c:v>0.77045454550000003</c:v>
                </c:pt>
                <c:pt idx="6">
                  <c:v>0.50472301139999998</c:v>
                </c:pt>
                <c:pt idx="7">
                  <c:v>0.39493963069999999</c:v>
                </c:pt>
                <c:pt idx="8">
                  <c:v>0.24492187500000001</c:v>
                </c:pt>
                <c:pt idx="9">
                  <c:v>9.3963068179999998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8D6C-1943-8018-581A37B009BC}"/>
            </c:ext>
          </c:extLst>
        </c:ser>
        <c:ser>
          <c:idx val="14"/>
          <c:order val="3"/>
          <c:tx>
            <c:strRef>
              <c:f>Sheet1!$C$36</c:f>
              <c:strCache>
                <c:ptCount val="1"/>
                <c:pt idx="0">
                  <c:v>ppm1∆ MR</c:v>
                </c:pt>
              </c:strCache>
            </c:strRef>
          </c:tx>
          <c:spPr>
            <a:ln w="9525" cap="rnd">
              <a:solidFill>
                <a:srgbClr val="F54F00"/>
              </a:solidFill>
              <a:round/>
            </a:ln>
            <a:effectLst/>
          </c:spPr>
          <c:xVal>
            <c:numRef>
              <c:f>Sheet1!$D$29:$T$29</c:f>
              <c:numCache>
                <c:formatCode>General</c:formatCode>
                <c:ptCount val="17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9</c:v>
                </c:pt>
                <c:pt idx="4">
                  <c:v>11</c:v>
                </c:pt>
                <c:pt idx="5">
                  <c:v>14</c:v>
                </c:pt>
                <c:pt idx="6">
                  <c:v>17</c:v>
                </c:pt>
                <c:pt idx="7">
                  <c:v>19</c:v>
                </c:pt>
                <c:pt idx="8">
                  <c:v>21</c:v>
                </c:pt>
                <c:pt idx="9">
                  <c:v>23</c:v>
                </c:pt>
                <c:pt idx="10">
                  <c:v>25</c:v>
                </c:pt>
                <c:pt idx="11">
                  <c:v>27</c:v>
                </c:pt>
                <c:pt idx="12">
                  <c:v>29</c:v>
                </c:pt>
                <c:pt idx="13">
                  <c:v>31</c:v>
                </c:pt>
                <c:pt idx="14">
                  <c:v>33</c:v>
                </c:pt>
                <c:pt idx="15">
                  <c:v>35</c:v>
                </c:pt>
                <c:pt idx="16">
                  <c:v>37</c:v>
                </c:pt>
              </c:numCache>
            </c:numRef>
          </c:xVal>
          <c:yVal>
            <c:numRef>
              <c:f>Sheet1!$D$36:$T$36</c:f>
              <c:numCache>
                <c:formatCode>General</c:formatCode>
                <c:ptCount val="17"/>
                <c:pt idx="0">
                  <c:v>1</c:v>
                </c:pt>
                <c:pt idx="1">
                  <c:v>0.93605390290000001</c:v>
                </c:pt>
                <c:pt idx="2">
                  <c:v>0.93705340390000003</c:v>
                </c:pt>
                <c:pt idx="3">
                  <c:v>0.82341723870000005</c:v>
                </c:pt>
                <c:pt idx="4">
                  <c:v>0.7688787185</c:v>
                </c:pt>
                <c:pt idx="5">
                  <c:v>0.75887871849999999</c:v>
                </c:pt>
                <c:pt idx="6">
                  <c:v>0.459013212</c:v>
                </c:pt>
                <c:pt idx="7">
                  <c:v>0.39308342029999999</c:v>
                </c:pt>
                <c:pt idx="8">
                  <c:v>0.33102932000000002</c:v>
                </c:pt>
                <c:pt idx="9">
                  <c:v>0.20301922999999999</c:v>
                </c:pt>
                <c:pt idx="10">
                  <c:v>9.1203923000000006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8D6C-1943-8018-581A37B009BC}"/>
            </c:ext>
          </c:extLst>
        </c:ser>
        <c:ser>
          <c:idx val="0"/>
          <c:order val="4"/>
          <c:tx>
            <c:strRef>
              <c:f>Sheet1!$C$30</c:f>
              <c:strCache>
                <c:ptCount val="1"/>
                <c:pt idx="0">
                  <c:v>Control</c:v>
                </c:pt>
              </c:strCache>
            </c:strRef>
          </c:tx>
          <c:spPr>
            <a:ln w="9525" cap="rnd">
              <a:solidFill>
                <a:srgbClr val="0673C4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bg1"/>
              </a:solidFill>
              <a:ln w="9525">
                <a:solidFill>
                  <a:srgbClr val="0673C4"/>
                </a:solidFill>
              </a:ln>
              <a:effectLst/>
            </c:spPr>
          </c:marker>
          <c:xVal>
            <c:numRef>
              <c:f>Sheet1!$D$29:$T$29</c:f>
              <c:numCache>
                <c:formatCode>General</c:formatCode>
                <c:ptCount val="17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9</c:v>
                </c:pt>
                <c:pt idx="4">
                  <c:v>11</c:v>
                </c:pt>
                <c:pt idx="5">
                  <c:v>14</c:v>
                </c:pt>
                <c:pt idx="6">
                  <c:v>17</c:v>
                </c:pt>
                <c:pt idx="7">
                  <c:v>19</c:v>
                </c:pt>
                <c:pt idx="8">
                  <c:v>21</c:v>
                </c:pt>
                <c:pt idx="9">
                  <c:v>23</c:v>
                </c:pt>
                <c:pt idx="10">
                  <c:v>25</c:v>
                </c:pt>
                <c:pt idx="11">
                  <c:v>27</c:v>
                </c:pt>
                <c:pt idx="12">
                  <c:v>29</c:v>
                </c:pt>
                <c:pt idx="13">
                  <c:v>31</c:v>
                </c:pt>
                <c:pt idx="14">
                  <c:v>33</c:v>
                </c:pt>
                <c:pt idx="15">
                  <c:v>35</c:v>
                </c:pt>
                <c:pt idx="16">
                  <c:v>37</c:v>
                </c:pt>
              </c:numCache>
            </c:numRef>
          </c:xVal>
          <c:yVal>
            <c:numRef>
              <c:f>Sheet1!$D$30:$T$30</c:f>
              <c:numCache>
                <c:formatCode>General</c:formatCode>
                <c:ptCount val="17"/>
                <c:pt idx="0">
                  <c:v>1</c:v>
                </c:pt>
                <c:pt idx="1">
                  <c:v>0.98333740979999995</c:v>
                </c:pt>
                <c:pt idx="2">
                  <c:v>0.84346337289999995</c:v>
                </c:pt>
                <c:pt idx="3">
                  <c:v>0.7833374098</c:v>
                </c:pt>
                <c:pt idx="4">
                  <c:v>0.74220374219999996</c:v>
                </c:pt>
                <c:pt idx="5">
                  <c:v>0.61244955359999997</c:v>
                </c:pt>
                <c:pt idx="6">
                  <c:v>0.36833496389999998</c:v>
                </c:pt>
                <c:pt idx="7">
                  <c:v>0.31747584690000002</c:v>
                </c:pt>
                <c:pt idx="8">
                  <c:v>0.17775467780000001</c:v>
                </c:pt>
                <c:pt idx="9">
                  <c:v>9.575638987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8D6C-1943-8018-581A37B009BC}"/>
            </c:ext>
          </c:extLst>
        </c:ser>
        <c:ser>
          <c:idx val="2"/>
          <c:order val="5"/>
          <c:tx>
            <c:strRef>
              <c:f>Sheet1!$C$32</c:f>
              <c:strCache>
                <c:ptCount val="1"/>
                <c:pt idx="0">
                  <c:v>MR</c:v>
                </c:pt>
              </c:strCache>
            </c:strRef>
          </c:tx>
          <c:spPr>
            <a:ln w="9525" cap="rnd">
              <a:solidFill>
                <a:srgbClr val="25B160"/>
              </a:solidFill>
              <a:round/>
            </a:ln>
            <a:effectLst/>
          </c:spPr>
          <c:marker>
            <c:symbol val="square"/>
            <c:size val="4"/>
            <c:spPr>
              <a:solidFill>
                <a:schemeClr val="bg1"/>
              </a:solidFill>
              <a:ln w="9525">
                <a:solidFill>
                  <a:srgbClr val="25B160"/>
                </a:solidFill>
              </a:ln>
              <a:effectLst/>
            </c:spPr>
          </c:marker>
          <c:xVal>
            <c:numRef>
              <c:f>Sheet1!$D$29:$T$29</c:f>
              <c:numCache>
                <c:formatCode>General</c:formatCode>
                <c:ptCount val="17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9</c:v>
                </c:pt>
                <c:pt idx="4">
                  <c:v>11</c:v>
                </c:pt>
                <c:pt idx="5">
                  <c:v>14</c:v>
                </c:pt>
                <c:pt idx="6">
                  <c:v>17</c:v>
                </c:pt>
                <c:pt idx="7">
                  <c:v>19</c:v>
                </c:pt>
                <c:pt idx="8">
                  <c:v>21</c:v>
                </c:pt>
                <c:pt idx="9">
                  <c:v>23</c:v>
                </c:pt>
                <c:pt idx="10">
                  <c:v>25</c:v>
                </c:pt>
                <c:pt idx="11">
                  <c:v>27</c:v>
                </c:pt>
                <c:pt idx="12">
                  <c:v>29</c:v>
                </c:pt>
                <c:pt idx="13">
                  <c:v>31</c:v>
                </c:pt>
                <c:pt idx="14">
                  <c:v>33</c:v>
                </c:pt>
                <c:pt idx="15">
                  <c:v>35</c:v>
                </c:pt>
                <c:pt idx="16">
                  <c:v>37</c:v>
                </c:pt>
              </c:numCache>
            </c:numRef>
          </c:xVal>
          <c:yVal>
            <c:numRef>
              <c:f>Sheet1!$D$32:$T$32</c:f>
              <c:numCache>
                <c:formatCode>General</c:formatCode>
                <c:ptCount val="17"/>
                <c:pt idx="0">
                  <c:v>1</c:v>
                </c:pt>
                <c:pt idx="1">
                  <c:v>0.95601655350000003</c:v>
                </c:pt>
                <c:pt idx="2">
                  <c:v>0.93601655350000001</c:v>
                </c:pt>
                <c:pt idx="3">
                  <c:v>0.8532205008</c:v>
                </c:pt>
                <c:pt idx="4">
                  <c:v>0.84242359929999999</c:v>
                </c:pt>
                <c:pt idx="5">
                  <c:v>0.78947368419999997</c:v>
                </c:pt>
                <c:pt idx="6">
                  <c:v>0.74930922099999997</c:v>
                </c:pt>
                <c:pt idx="7">
                  <c:v>0.68502082310000001</c:v>
                </c:pt>
                <c:pt idx="8">
                  <c:v>0.61092182510000004</c:v>
                </c:pt>
                <c:pt idx="9">
                  <c:v>0.6001618259</c:v>
                </c:pt>
                <c:pt idx="10">
                  <c:v>0.51013682589999998</c:v>
                </c:pt>
                <c:pt idx="11">
                  <c:v>0.31015652830000001</c:v>
                </c:pt>
                <c:pt idx="12">
                  <c:v>0.23905630999999999</c:v>
                </c:pt>
                <c:pt idx="13">
                  <c:v>0.15045352889999999</c:v>
                </c:pt>
                <c:pt idx="14">
                  <c:v>9.0453528899999996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8D6C-1943-8018-581A37B009BC}"/>
            </c:ext>
          </c:extLst>
        </c:ser>
        <c:ser>
          <c:idx val="4"/>
          <c:order val="6"/>
          <c:tx>
            <c:strRef>
              <c:f>Sheet1!$C$34</c:f>
              <c:strCache>
                <c:ptCount val="1"/>
                <c:pt idx="0">
                  <c:v>ppm1∆</c:v>
                </c:pt>
              </c:strCache>
            </c:strRef>
          </c:tx>
          <c:spPr>
            <a:ln w="9525" cap="rnd">
              <a:solidFill>
                <a:srgbClr val="F6D256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bg1"/>
              </a:solidFill>
              <a:ln w="9525">
                <a:solidFill>
                  <a:srgbClr val="F6D256"/>
                </a:solidFill>
              </a:ln>
              <a:effectLst/>
            </c:spPr>
          </c:marker>
          <c:xVal>
            <c:numRef>
              <c:f>Sheet1!$D$29:$T$29</c:f>
              <c:numCache>
                <c:formatCode>General</c:formatCode>
                <c:ptCount val="17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9</c:v>
                </c:pt>
                <c:pt idx="4">
                  <c:v>11</c:v>
                </c:pt>
                <c:pt idx="5">
                  <c:v>14</c:v>
                </c:pt>
                <c:pt idx="6">
                  <c:v>17</c:v>
                </c:pt>
                <c:pt idx="7">
                  <c:v>19</c:v>
                </c:pt>
                <c:pt idx="8">
                  <c:v>21</c:v>
                </c:pt>
                <c:pt idx="9">
                  <c:v>23</c:v>
                </c:pt>
                <c:pt idx="10">
                  <c:v>25</c:v>
                </c:pt>
                <c:pt idx="11">
                  <c:v>27</c:v>
                </c:pt>
                <c:pt idx="12">
                  <c:v>29</c:v>
                </c:pt>
                <c:pt idx="13">
                  <c:v>31</c:v>
                </c:pt>
                <c:pt idx="14">
                  <c:v>33</c:v>
                </c:pt>
                <c:pt idx="15">
                  <c:v>35</c:v>
                </c:pt>
                <c:pt idx="16">
                  <c:v>37</c:v>
                </c:pt>
              </c:numCache>
            </c:numRef>
          </c:xVal>
          <c:yVal>
            <c:numRef>
              <c:f>Sheet1!$D$34:$T$34</c:f>
              <c:numCache>
                <c:formatCode>General</c:formatCode>
                <c:ptCount val="17"/>
                <c:pt idx="0">
                  <c:v>1</c:v>
                </c:pt>
                <c:pt idx="1">
                  <c:v>0.95</c:v>
                </c:pt>
                <c:pt idx="2">
                  <c:v>0.95390624999999996</c:v>
                </c:pt>
                <c:pt idx="3">
                  <c:v>0.94801136360000005</c:v>
                </c:pt>
                <c:pt idx="4">
                  <c:v>0.87045454550000001</c:v>
                </c:pt>
                <c:pt idx="5">
                  <c:v>0.77045454550000003</c:v>
                </c:pt>
                <c:pt idx="6">
                  <c:v>0.50472301139999998</c:v>
                </c:pt>
                <c:pt idx="7">
                  <c:v>0.39493963069999999</c:v>
                </c:pt>
                <c:pt idx="8">
                  <c:v>0.24492187500000001</c:v>
                </c:pt>
                <c:pt idx="9">
                  <c:v>9.3963068179999998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8D6C-1943-8018-581A37B009BC}"/>
            </c:ext>
          </c:extLst>
        </c:ser>
        <c:ser>
          <c:idx val="6"/>
          <c:order val="7"/>
          <c:tx>
            <c:strRef>
              <c:f>Sheet1!$C$36</c:f>
              <c:strCache>
                <c:ptCount val="1"/>
                <c:pt idx="0">
                  <c:v>ppm1∆ MR</c:v>
                </c:pt>
              </c:strCache>
            </c:strRef>
          </c:tx>
          <c:spPr>
            <a:ln w="9525" cap="rnd">
              <a:solidFill>
                <a:srgbClr val="F54F00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bg1"/>
              </a:solidFill>
              <a:ln w="9525">
                <a:solidFill>
                  <a:srgbClr val="F54F00"/>
                </a:solidFill>
              </a:ln>
              <a:effectLst/>
            </c:spPr>
          </c:marker>
          <c:xVal>
            <c:numRef>
              <c:f>Sheet1!$D$29:$T$29</c:f>
              <c:numCache>
                <c:formatCode>General</c:formatCode>
                <c:ptCount val="17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9</c:v>
                </c:pt>
                <c:pt idx="4">
                  <c:v>11</c:v>
                </c:pt>
                <c:pt idx="5">
                  <c:v>14</c:v>
                </c:pt>
                <c:pt idx="6">
                  <c:v>17</c:v>
                </c:pt>
                <c:pt idx="7">
                  <c:v>19</c:v>
                </c:pt>
                <c:pt idx="8">
                  <c:v>21</c:v>
                </c:pt>
                <c:pt idx="9">
                  <c:v>23</c:v>
                </c:pt>
                <c:pt idx="10">
                  <c:v>25</c:v>
                </c:pt>
                <c:pt idx="11">
                  <c:v>27</c:v>
                </c:pt>
                <c:pt idx="12">
                  <c:v>29</c:v>
                </c:pt>
                <c:pt idx="13">
                  <c:v>31</c:v>
                </c:pt>
                <c:pt idx="14">
                  <c:v>33</c:v>
                </c:pt>
                <c:pt idx="15">
                  <c:v>35</c:v>
                </c:pt>
                <c:pt idx="16">
                  <c:v>37</c:v>
                </c:pt>
              </c:numCache>
            </c:numRef>
          </c:xVal>
          <c:yVal>
            <c:numRef>
              <c:f>Sheet1!$D$36:$T$36</c:f>
              <c:numCache>
                <c:formatCode>General</c:formatCode>
                <c:ptCount val="17"/>
                <c:pt idx="0">
                  <c:v>1</c:v>
                </c:pt>
                <c:pt idx="1">
                  <c:v>0.93605390290000001</c:v>
                </c:pt>
                <c:pt idx="2">
                  <c:v>0.93705340390000003</c:v>
                </c:pt>
                <c:pt idx="3">
                  <c:v>0.82341723870000005</c:v>
                </c:pt>
                <c:pt idx="4">
                  <c:v>0.7688787185</c:v>
                </c:pt>
                <c:pt idx="5">
                  <c:v>0.75887871849999999</c:v>
                </c:pt>
                <c:pt idx="6">
                  <c:v>0.459013212</c:v>
                </c:pt>
                <c:pt idx="7">
                  <c:v>0.39308342029999999</c:v>
                </c:pt>
                <c:pt idx="8">
                  <c:v>0.33102932000000002</c:v>
                </c:pt>
                <c:pt idx="9">
                  <c:v>0.20301922999999999</c:v>
                </c:pt>
                <c:pt idx="10">
                  <c:v>9.1203923000000006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8D6C-1943-8018-581A37B009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16195023"/>
        <c:axId val="665116976"/>
      </c:scatterChart>
      <c:valAx>
        <c:axId val="616195023"/>
        <c:scaling>
          <c:orientation val="minMax"/>
          <c:max val="40"/>
        </c:scaling>
        <c:delete val="0"/>
        <c:axPos val="b"/>
        <c:title>
          <c:tx>
            <c:rich>
              <a:bodyPr/>
              <a:lstStyle/>
              <a:p>
                <a:pPr>
                  <a:defRPr b="1"/>
                </a:pPr>
                <a:r>
                  <a:rPr lang="en-US" b="1"/>
                  <a:t>Time (days)</a:t>
                </a:r>
              </a:p>
            </c:rich>
          </c:tx>
          <c:layout>
            <c:manualLayout>
              <c:xMode val="edge"/>
              <c:yMode val="edge"/>
              <c:x val="0.45957436361181242"/>
              <c:y val="0.83711520009831231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sz="900"/>
            </a:pPr>
            <a:endParaRPr lang="en-US"/>
          </a:p>
        </c:txPr>
        <c:crossAx val="665116976"/>
        <c:crosses val="autoZero"/>
        <c:crossBetween val="midCat"/>
        <c:majorUnit val="10"/>
      </c:valAx>
      <c:valAx>
        <c:axId val="665116976"/>
        <c:scaling>
          <c:orientation val="minMax"/>
          <c:max val="1"/>
        </c:scaling>
        <c:delete val="0"/>
        <c:axPos val="l"/>
        <c:title>
          <c:tx>
            <c:rich>
              <a:bodyPr/>
              <a:lstStyle/>
              <a:p>
                <a:pPr>
                  <a:defRPr sz="1000" b="1"/>
                </a:pPr>
                <a:r>
                  <a:rPr lang="en-US" sz="1000" b="1" dirty="0"/>
                  <a:t>Survival</a:t>
                </a:r>
              </a:p>
            </c:rich>
          </c:tx>
          <c:layout>
            <c:manualLayout>
              <c:xMode val="edge"/>
              <c:yMode val="edge"/>
              <c:x val="0.1223249001977003"/>
              <c:y val="0.28109192658729221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sz="900"/>
            </a:pPr>
            <a:endParaRPr lang="en-US"/>
          </a:p>
        </c:txPr>
        <c:crossAx val="616195023"/>
        <c:crosses val="autoZero"/>
        <c:crossBetween val="midCat"/>
        <c:majorUnit val="0.2"/>
      </c:valAx>
      <c:spPr>
        <a:noFill/>
        <a:ln w="9525">
          <a:solidFill>
            <a:schemeClr val="tx1"/>
          </a:solidFill>
        </a:ln>
      </c:spPr>
    </c:plotArea>
    <c:plotVisOnly val="1"/>
    <c:dispBlanksAs val="gap"/>
    <c:showDLblsOverMax val="0"/>
    <c:extLst/>
  </c:chart>
  <c:txPr>
    <a:bodyPr/>
    <a:lstStyle/>
    <a:p>
      <a:pPr>
        <a:defRPr sz="1050" b="0"/>
      </a:pPr>
      <a:endParaRPr lang="en-US"/>
    </a:p>
  </c:txPr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199207377712537"/>
          <c:y val="3.6781666028010238E-2"/>
          <c:w val="0.74671320693758947"/>
          <c:h val="0.73839371355437211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E$11</c:f>
              <c:strCache>
                <c:ptCount val="1"/>
                <c:pt idx="0">
                  <c:v>Control</c:v>
                </c:pt>
              </c:strCache>
            </c:strRef>
          </c:tx>
          <c:spPr>
            <a:ln w="9525" cap="rnd">
              <a:solidFill>
                <a:srgbClr val="0673C4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bg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F$10:$R$10</c:f>
              <c:numCache>
                <c:formatCode>General</c:formatCode>
                <c:ptCount val="13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10</c:v>
                </c:pt>
                <c:pt idx="4">
                  <c:v>12</c:v>
                </c:pt>
                <c:pt idx="5">
                  <c:v>14</c:v>
                </c:pt>
                <c:pt idx="6">
                  <c:v>17</c:v>
                </c:pt>
                <c:pt idx="7">
                  <c:v>19</c:v>
                </c:pt>
                <c:pt idx="8">
                  <c:v>21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1</c:v>
                </c:pt>
              </c:numCache>
            </c:numRef>
          </c:xVal>
          <c:yVal>
            <c:numRef>
              <c:f>Sheet1!$F$11:$R$11</c:f>
              <c:numCache>
                <c:formatCode>General</c:formatCode>
                <c:ptCount val="13"/>
                <c:pt idx="0">
                  <c:v>1</c:v>
                </c:pt>
                <c:pt idx="1">
                  <c:v>0.98406862750000001</c:v>
                </c:pt>
                <c:pt idx="2">
                  <c:v>0.91008771929999999</c:v>
                </c:pt>
                <c:pt idx="3">
                  <c:v>0.76093266250000002</c:v>
                </c:pt>
                <c:pt idx="4">
                  <c:v>0.67982456140000003</c:v>
                </c:pt>
                <c:pt idx="5">
                  <c:v>0.39189886480000002</c:v>
                </c:pt>
                <c:pt idx="6">
                  <c:v>0.20123904179999999</c:v>
                </c:pt>
                <c:pt idx="7">
                  <c:v>0.12309843400000001</c:v>
                </c:pt>
                <c:pt idx="8">
                  <c:v>8.2349823000000003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529-FA4E-8098-D05397896A99}"/>
            </c:ext>
          </c:extLst>
        </c:ser>
        <c:ser>
          <c:idx val="1"/>
          <c:order val="1"/>
          <c:tx>
            <c:strRef>
              <c:f>Sheet1!$E$12</c:f>
              <c:strCache>
                <c:ptCount val="1"/>
                <c:pt idx="0">
                  <c:v>MR</c:v>
                </c:pt>
              </c:strCache>
            </c:strRef>
          </c:tx>
          <c:spPr>
            <a:ln w="9525" cap="rnd">
              <a:solidFill>
                <a:srgbClr val="25B160"/>
              </a:solidFill>
              <a:round/>
            </a:ln>
            <a:effectLst/>
          </c:spPr>
          <c:marker>
            <c:symbol val="square"/>
            <c:size val="4"/>
            <c:spPr>
              <a:solidFill>
                <a:schemeClr val="bg1"/>
              </a:solidFill>
              <a:ln w="9525">
                <a:solidFill>
                  <a:srgbClr val="25B160"/>
                </a:solidFill>
              </a:ln>
              <a:effectLst/>
            </c:spPr>
          </c:marker>
          <c:xVal>
            <c:numRef>
              <c:f>Sheet1!$F$10:$R$10</c:f>
              <c:numCache>
                <c:formatCode>General</c:formatCode>
                <c:ptCount val="13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10</c:v>
                </c:pt>
                <c:pt idx="4">
                  <c:v>12</c:v>
                </c:pt>
                <c:pt idx="5">
                  <c:v>14</c:v>
                </c:pt>
                <c:pt idx="6">
                  <c:v>17</c:v>
                </c:pt>
                <c:pt idx="7">
                  <c:v>19</c:v>
                </c:pt>
                <c:pt idx="8">
                  <c:v>21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1</c:v>
                </c:pt>
              </c:numCache>
            </c:numRef>
          </c:xVal>
          <c:yVal>
            <c:numRef>
              <c:f>Sheet1!$F$12:$R$12</c:f>
              <c:numCache>
                <c:formatCode>General</c:formatCode>
                <c:ptCount val="13"/>
                <c:pt idx="0">
                  <c:v>1</c:v>
                </c:pt>
                <c:pt idx="1">
                  <c:v>0.96312154699999997</c:v>
                </c:pt>
                <c:pt idx="2">
                  <c:v>0.95031077350000004</c:v>
                </c:pt>
                <c:pt idx="3">
                  <c:v>0.92513812149999997</c:v>
                </c:pt>
                <c:pt idx="4">
                  <c:v>0.92472375689999997</c:v>
                </c:pt>
                <c:pt idx="5">
                  <c:v>0.70220994479999999</c:v>
                </c:pt>
                <c:pt idx="6">
                  <c:v>0.66795580109999997</c:v>
                </c:pt>
                <c:pt idx="7">
                  <c:v>0.55234234000000004</c:v>
                </c:pt>
                <c:pt idx="8">
                  <c:v>0.43391034000000001</c:v>
                </c:pt>
                <c:pt idx="9">
                  <c:v>0.40234091</c:v>
                </c:pt>
                <c:pt idx="10">
                  <c:v>0.38340912379999997</c:v>
                </c:pt>
                <c:pt idx="11">
                  <c:v>0.20139042339999999</c:v>
                </c:pt>
                <c:pt idx="12">
                  <c:v>9.2384229999999998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529-FA4E-8098-D05397896A99}"/>
            </c:ext>
          </c:extLst>
        </c:ser>
        <c:ser>
          <c:idx val="2"/>
          <c:order val="2"/>
          <c:tx>
            <c:strRef>
              <c:f>Sheet1!$E$13</c:f>
              <c:strCache>
                <c:ptCount val="1"/>
                <c:pt idx="0">
                  <c:v>rts1</c:v>
                </c:pt>
              </c:strCache>
            </c:strRef>
          </c:tx>
          <c:spPr>
            <a:ln w="9525" cap="rnd">
              <a:solidFill>
                <a:srgbClr val="F6D256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bg1"/>
              </a:solidFill>
              <a:ln w="9525">
                <a:solidFill>
                  <a:srgbClr val="F6D256"/>
                </a:solidFill>
              </a:ln>
              <a:effectLst/>
            </c:spPr>
          </c:marker>
          <c:xVal>
            <c:numRef>
              <c:f>Sheet1!$F$10:$R$10</c:f>
              <c:numCache>
                <c:formatCode>General</c:formatCode>
                <c:ptCount val="13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10</c:v>
                </c:pt>
                <c:pt idx="4">
                  <c:v>12</c:v>
                </c:pt>
                <c:pt idx="5">
                  <c:v>14</c:v>
                </c:pt>
                <c:pt idx="6">
                  <c:v>17</c:v>
                </c:pt>
                <c:pt idx="7">
                  <c:v>19</c:v>
                </c:pt>
                <c:pt idx="8">
                  <c:v>21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1</c:v>
                </c:pt>
              </c:numCache>
            </c:numRef>
          </c:xVal>
          <c:yVal>
            <c:numRef>
              <c:f>Sheet1!$F$13:$R$13</c:f>
              <c:numCache>
                <c:formatCode>General</c:formatCode>
                <c:ptCount val="13"/>
                <c:pt idx="0">
                  <c:v>1</c:v>
                </c:pt>
                <c:pt idx="1">
                  <c:v>0.97085365850000005</c:v>
                </c:pt>
                <c:pt idx="2">
                  <c:v>0.89246951220000004</c:v>
                </c:pt>
                <c:pt idx="3">
                  <c:v>0.69865853659999999</c:v>
                </c:pt>
                <c:pt idx="4">
                  <c:v>0.53307926829999996</c:v>
                </c:pt>
                <c:pt idx="5">
                  <c:v>0.3742682927</c:v>
                </c:pt>
                <c:pt idx="6">
                  <c:v>0.117195122</c:v>
                </c:pt>
                <c:pt idx="7">
                  <c:v>9.2384229999999998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B529-FA4E-8098-D05397896A99}"/>
            </c:ext>
          </c:extLst>
        </c:ser>
        <c:ser>
          <c:idx val="3"/>
          <c:order val="3"/>
          <c:tx>
            <c:strRef>
              <c:f>Sheet1!$E$14</c:f>
              <c:strCache>
                <c:ptCount val="1"/>
                <c:pt idx="0">
                  <c:v>cdc55</c:v>
                </c:pt>
              </c:strCache>
            </c:strRef>
          </c:tx>
          <c:spPr>
            <a:ln w="9525" cap="rnd">
              <a:solidFill>
                <a:srgbClr val="F64F00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bg1"/>
              </a:solidFill>
              <a:ln w="9525">
                <a:solidFill>
                  <a:srgbClr val="F64F00"/>
                </a:solidFill>
              </a:ln>
              <a:effectLst/>
            </c:spPr>
          </c:marker>
          <c:xVal>
            <c:numRef>
              <c:f>Sheet1!$F$10:$R$10</c:f>
              <c:numCache>
                <c:formatCode>General</c:formatCode>
                <c:ptCount val="13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10</c:v>
                </c:pt>
                <c:pt idx="4">
                  <c:v>12</c:v>
                </c:pt>
                <c:pt idx="5">
                  <c:v>14</c:v>
                </c:pt>
                <c:pt idx="6">
                  <c:v>17</c:v>
                </c:pt>
                <c:pt idx="7">
                  <c:v>19</c:v>
                </c:pt>
                <c:pt idx="8">
                  <c:v>21</c:v>
                </c:pt>
                <c:pt idx="9">
                  <c:v>24</c:v>
                </c:pt>
                <c:pt idx="10">
                  <c:v>26</c:v>
                </c:pt>
                <c:pt idx="11">
                  <c:v>28</c:v>
                </c:pt>
                <c:pt idx="12">
                  <c:v>31</c:v>
                </c:pt>
              </c:numCache>
            </c:numRef>
          </c:xVal>
          <c:yVal>
            <c:numRef>
              <c:f>Sheet1!$F$14:$R$14</c:f>
              <c:numCache>
                <c:formatCode>General</c:formatCode>
                <c:ptCount val="13"/>
                <c:pt idx="0">
                  <c:v>1</c:v>
                </c:pt>
                <c:pt idx="1">
                  <c:v>0.94026204749999998</c:v>
                </c:pt>
                <c:pt idx="2">
                  <c:v>0.36620031089999999</c:v>
                </c:pt>
                <c:pt idx="3">
                  <c:v>8.3000222070000004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B529-FA4E-8098-D05397896A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6295519"/>
        <c:axId val="86275135"/>
      </c:scatterChart>
      <c:valAx>
        <c:axId val="86295519"/>
        <c:scaling>
          <c:orientation val="minMax"/>
          <c:max val="4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b="0">
                    <a:solidFill>
                      <a:schemeClr val="tx1"/>
                    </a:solidFill>
                  </a:rPr>
                  <a:t>Time (days)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275135"/>
        <c:crosses val="autoZero"/>
        <c:crossBetween val="midCat"/>
        <c:majorUnit val="10"/>
      </c:valAx>
      <c:valAx>
        <c:axId val="86275135"/>
        <c:scaling>
          <c:orientation val="minMax"/>
          <c:max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b="0" dirty="0">
                    <a:solidFill>
                      <a:schemeClr val="tx1"/>
                    </a:solidFill>
                  </a:rPr>
                  <a:t>Surviva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295519"/>
        <c:crosses val="autoZero"/>
        <c:crossBetween val="midCat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  <c:extLst/>
  </c:chart>
  <c:txPr>
    <a:bodyPr/>
    <a:lstStyle/>
    <a:p>
      <a:pPr>
        <a:defRPr sz="11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509761975770955"/>
          <c:y val="5.0483565046080016E-2"/>
          <c:w val="0.66297661734620084"/>
          <c:h val="0.67754616093372722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B$5</c:f>
              <c:strCache>
                <c:ptCount val="1"/>
                <c:pt idx="0">
                  <c:v>Control</c:v>
                </c:pt>
              </c:strCache>
            </c:strRef>
          </c:tx>
          <c:spPr>
            <a:ln w="9525" cap="rnd">
              <a:solidFill>
                <a:srgbClr val="0673C4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bg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C$4:$Q$4</c:f>
              <c:numCache>
                <c:formatCode>General</c:formatCode>
                <c:ptCount val="15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10</c:v>
                </c:pt>
                <c:pt idx="4">
                  <c:v>12</c:v>
                </c:pt>
                <c:pt idx="5">
                  <c:v>14</c:v>
                </c:pt>
                <c:pt idx="6">
                  <c:v>17</c:v>
                </c:pt>
                <c:pt idx="7">
                  <c:v>19</c:v>
                </c:pt>
                <c:pt idx="8">
                  <c:v>21</c:v>
                </c:pt>
                <c:pt idx="9">
                  <c:v>23</c:v>
                </c:pt>
                <c:pt idx="10">
                  <c:v>25</c:v>
                </c:pt>
                <c:pt idx="11">
                  <c:v>27</c:v>
                </c:pt>
                <c:pt idx="12">
                  <c:v>29</c:v>
                </c:pt>
                <c:pt idx="13">
                  <c:v>31</c:v>
                </c:pt>
                <c:pt idx="14">
                  <c:v>33</c:v>
                </c:pt>
              </c:numCache>
            </c:numRef>
          </c:xVal>
          <c:yVal>
            <c:numRef>
              <c:f>Sheet1!$C$5:$Q$5</c:f>
              <c:numCache>
                <c:formatCode>General</c:formatCode>
                <c:ptCount val="15"/>
                <c:pt idx="0">
                  <c:v>1</c:v>
                </c:pt>
                <c:pt idx="1">
                  <c:v>0.87757847529999999</c:v>
                </c:pt>
                <c:pt idx="2">
                  <c:v>0.7570067265</c:v>
                </c:pt>
                <c:pt idx="3">
                  <c:v>0.5277466368</c:v>
                </c:pt>
                <c:pt idx="4">
                  <c:v>0.31446188339999998</c:v>
                </c:pt>
                <c:pt idx="5">
                  <c:v>0.23856502239999999</c:v>
                </c:pt>
                <c:pt idx="6">
                  <c:v>0.16123787410000001</c:v>
                </c:pt>
                <c:pt idx="7">
                  <c:v>8.8621076229999998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268-894B-A390-B3CCB2A391E6}"/>
            </c:ext>
          </c:extLst>
        </c:ser>
        <c:ser>
          <c:idx val="1"/>
          <c:order val="1"/>
          <c:tx>
            <c:strRef>
              <c:f>Sheet1!$B$6</c:f>
              <c:strCache>
                <c:ptCount val="1"/>
                <c:pt idx="0">
                  <c:v>MR</c:v>
                </c:pt>
              </c:strCache>
            </c:strRef>
          </c:tx>
          <c:spPr>
            <a:ln w="9525" cap="rnd">
              <a:solidFill>
                <a:srgbClr val="25B160"/>
              </a:solidFill>
              <a:round/>
            </a:ln>
            <a:effectLst/>
          </c:spPr>
          <c:marker>
            <c:symbol val="square"/>
            <c:size val="4"/>
            <c:spPr>
              <a:solidFill>
                <a:schemeClr val="bg1"/>
              </a:solidFill>
              <a:ln w="9525">
                <a:solidFill>
                  <a:srgbClr val="25B160"/>
                </a:solidFill>
              </a:ln>
              <a:effectLst/>
            </c:spPr>
          </c:marker>
          <c:xVal>
            <c:numRef>
              <c:f>Sheet1!$C$4:$Q$4</c:f>
              <c:numCache>
                <c:formatCode>General</c:formatCode>
                <c:ptCount val="15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10</c:v>
                </c:pt>
                <c:pt idx="4">
                  <c:v>12</c:v>
                </c:pt>
                <c:pt idx="5">
                  <c:v>14</c:v>
                </c:pt>
                <c:pt idx="6">
                  <c:v>17</c:v>
                </c:pt>
                <c:pt idx="7">
                  <c:v>19</c:v>
                </c:pt>
                <c:pt idx="8">
                  <c:v>21</c:v>
                </c:pt>
                <c:pt idx="9">
                  <c:v>23</c:v>
                </c:pt>
                <c:pt idx="10">
                  <c:v>25</c:v>
                </c:pt>
                <c:pt idx="11">
                  <c:v>27</c:v>
                </c:pt>
                <c:pt idx="12">
                  <c:v>29</c:v>
                </c:pt>
                <c:pt idx="13">
                  <c:v>31</c:v>
                </c:pt>
                <c:pt idx="14">
                  <c:v>33</c:v>
                </c:pt>
              </c:numCache>
            </c:numRef>
          </c:xVal>
          <c:yVal>
            <c:numRef>
              <c:f>Sheet1!$C$6:$Q$6</c:f>
              <c:numCache>
                <c:formatCode>General</c:formatCode>
                <c:ptCount val="15"/>
                <c:pt idx="0">
                  <c:v>1</c:v>
                </c:pt>
                <c:pt idx="1">
                  <c:v>0.97449856729999995</c:v>
                </c:pt>
                <c:pt idx="2">
                  <c:v>0.95109238409999997</c:v>
                </c:pt>
                <c:pt idx="3">
                  <c:v>0.80102934810000004</c:v>
                </c:pt>
                <c:pt idx="4">
                  <c:v>0.72309148229999998</c:v>
                </c:pt>
                <c:pt idx="5">
                  <c:v>0.69012384120000003</c:v>
                </c:pt>
                <c:pt idx="6">
                  <c:v>0.67585959890000002</c:v>
                </c:pt>
                <c:pt idx="7">
                  <c:v>0.43373925499999999</c:v>
                </c:pt>
                <c:pt idx="8">
                  <c:v>0.34340974210000003</c:v>
                </c:pt>
                <c:pt idx="9">
                  <c:v>0.27123408100000002</c:v>
                </c:pt>
                <c:pt idx="10">
                  <c:v>0.24091312000000001</c:v>
                </c:pt>
                <c:pt idx="11">
                  <c:v>0.19128934</c:v>
                </c:pt>
                <c:pt idx="12">
                  <c:v>0.15091234100000001</c:v>
                </c:pt>
                <c:pt idx="13">
                  <c:v>8.1324981199999993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268-894B-A390-B3CCB2A391E6}"/>
            </c:ext>
          </c:extLst>
        </c:ser>
        <c:ser>
          <c:idx val="2"/>
          <c:order val="2"/>
          <c:tx>
            <c:strRef>
              <c:f>Sheet1!$B$7</c:f>
              <c:strCache>
                <c:ptCount val="1"/>
                <c:pt idx="0">
                  <c:v>S362D</c:v>
                </c:pt>
              </c:strCache>
            </c:strRef>
          </c:tx>
          <c:spPr>
            <a:ln w="9525" cap="rnd">
              <a:solidFill>
                <a:srgbClr val="F6D256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bg1"/>
              </a:solidFill>
              <a:ln w="9525">
                <a:solidFill>
                  <a:srgbClr val="F6D256"/>
                </a:solidFill>
              </a:ln>
              <a:effectLst/>
            </c:spPr>
          </c:marker>
          <c:xVal>
            <c:numRef>
              <c:f>Sheet1!$C$4:$Q$4</c:f>
              <c:numCache>
                <c:formatCode>General</c:formatCode>
                <c:ptCount val="15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10</c:v>
                </c:pt>
                <c:pt idx="4">
                  <c:v>12</c:v>
                </c:pt>
                <c:pt idx="5">
                  <c:v>14</c:v>
                </c:pt>
                <c:pt idx="6">
                  <c:v>17</c:v>
                </c:pt>
                <c:pt idx="7">
                  <c:v>19</c:v>
                </c:pt>
                <c:pt idx="8">
                  <c:v>21</c:v>
                </c:pt>
                <c:pt idx="9">
                  <c:v>23</c:v>
                </c:pt>
                <c:pt idx="10">
                  <c:v>25</c:v>
                </c:pt>
                <c:pt idx="11">
                  <c:v>27</c:v>
                </c:pt>
                <c:pt idx="12">
                  <c:v>29</c:v>
                </c:pt>
                <c:pt idx="13">
                  <c:v>31</c:v>
                </c:pt>
                <c:pt idx="14">
                  <c:v>33</c:v>
                </c:pt>
              </c:numCache>
            </c:numRef>
          </c:xVal>
          <c:yVal>
            <c:numRef>
              <c:f>Sheet1!$C$7:$Q$7</c:f>
              <c:numCache>
                <c:formatCode>General</c:formatCode>
                <c:ptCount val="15"/>
                <c:pt idx="0">
                  <c:v>1</c:v>
                </c:pt>
                <c:pt idx="1">
                  <c:v>0.87864806870000001</c:v>
                </c:pt>
                <c:pt idx="2">
                  <c:v>0.86192385410000005</c:v>
                </c:pt>
                <c:pt idx="3">
                  <c:v>0.79399141630000003</c:v>
                </c:pt>
                <c:pt idx="4">
                  <c:v>0.6834763948</c:v>
                </c:pt>
                <c:pt idx="5">
                  <c:v>0.5910923481</c:v>
                </c:pt>
                <c:pt idx="6">
                  <c:v>0.55902348120000001</c:v>
                </c:pt>
                <c:pt idx="7">
                  <c:v>0.485193133</c:v>
                </c:pt>
                <c:pt idx="8">
                  <c:v>0.40923418210000001</c:v>
                </c:pt>
                <c:pt idx="9">
                  <c:v>0.40129303999999999</c:v>
                </c:pt>
                <c:pt idx="10">
                  <c:v>0.29391933999999997</c:v>
                </c:pt>
                <c:pt idx="11">
                  <c:v>0.174892348</c:v>
                </c:pt>
                <c:pt idx="12">
                  <c:v>0.120940213</c:v>
                </c:pt>
                <c:pt idx="13">
                  <c:v>7.4893234000000003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8268-894B-A390-B3CCB2A391E6}"/>
            </c:ext>
          </c:extLst>
        </c:ser>
        <c:ser>
          <c:idx val="3"/>
          <c:order val="3"/>
          <c:tx>
            <c:strRef>
              <c:f>Sheet1!$B$8</c:f>
              <c:strCache>
                <c:ptCount val="1"/>
                <c:pt idx="0">
                  <c:v>S362D MR</c:v>
                </c:pt>
              </c:strCache>
            </c:strRef>
          </c:tx>
          <c:spPr>
            <a:ln w="9525" cap="rnd">
              <a:solidFill>
                <a:srgbClr val="F64F00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bg1"/>
              </a:solidFill>
              <a:ln w="9525">
                <a:solidFill>
                  <a:srgbClr val="F64F00"/>
                </a:solidFill>
              </a:ln>
              <a:effectLst/>
            </c:spPr>
          </c:marker>
          <c:xVal>
            <c:numRef>
              <c:f>Sheet1!$C$4:$Q$4</c:f>
              <c:numCache>
                <c:formatCode>General</c:formatCode>
                <c:ptCount val="15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10</c:v>
                </c:pt>
                <c:pt idx="4">
                  <c:v>12</c:v>
                </c:pt>
                <c:pt idx="5">
                  <c:v>14</c:v>
                </c:pt>
                <c:pt idx="6">
                  <c:v>17</c:v>
                </c:pt>
                <c:pt idx="7">
                  <c:v>19</c:v>
                </c:pt>
                <c:pt idx="8">
                  <c:v>21</c:v>
                </c:pt>
                <c:pt idx="9">
                  <c:v>23</c:v>
                </c:pt>
                <c:pt idx="10">
                  <c:v>25</c:v>
                </c:pt>
                <c:pt idx="11">
                  <c:v>27</c:v>
                </c:pt>
                <c:pt idx="12">
                  <c:v>29</c:v>
                </c:pt>
                <c:pt idx="13">
                  <c:v>31</c:v>
                </c:pt>
                <c:pt idx="14">
                  <c:v>33</c:v>
                </c:pt>
              </c:numCache>
            </c:numRef>
          </c:xVal>
          <c:yVal>
            <c:numRef>
              <c:f>Sheet1!$C$8:$Q$8</c:f>
              <c:numCache>
                <c:formatCode>General</c:formatCode>
                <c:ptCount val="15"/>
                <c:pt idx="0">
                  <c:v>1</c:v>
                </c:pt>
                <c:pt idx="1">
                  <c:v>0.95</c:v>
                </c:pt>
                <c:pt idx="2">
                  <c:v>0.90592783509999997</c:v>
                </c:pt>
                <c:pt idx="3">
                  <c:v>0.89755154640000001</c:v>
                </c:pt>
                <c:pt idx="4">
                  <c:v>0.76314432990000003</c:v>
                </c:pt>
                <c:pt idx="5">
                  <c:v>0.62319042840000005</c:v>
                </c:pt>
                <c:pt idx="6">
                  <c:v>0.58129341820000002</c:v>
                </c:pt>
                <c:pt idx="7">
                  <c:v>0.44905890209999999</c:v>
                </c:pt>
                <c:pt idx="8">
                  <c:v>0.30992268039999998</c:v>
                </c:pt>
                <c:pt idx="9">
                  <c:v>0.28390394229999999</c:v>
                </c:pt>
                <c:pt idx="10">
                  <c:v>0.20129304000000001</c:v>
                </c:pt>
                <c:pt idx="11">
                  <c:v>0.16904192300000001</c:v>
                </c:pt>
                <c:pt idx="12">
                  <c:v>9.4910234900000001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8268-894B-A390-B3CCB2A391E6}"/>
            </c:ext>
          </c:extLst>
        </c:ser>
        <c:ser>
          <c:idx val="4"/>
          <c:order val="4"/>
          <c:tx>
            <c:strRef>
              <c:f>Sheet1!$B$9</c:f>
              <c:strCache>
                <c:ptCount val="1"/>
                <c:pt idx="0">
                  <c:v>Control + SAM</c:v>
                </c:pt>
              </c:strCache>
            </c:strRef>
          </c:tx>
          <c:spPr>
            <a:ln w="9525" cap="rnd">
              <a:solidFill>
                <a:srgbClr val="F736E4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bg1"/>
              </a:solidFill>
              <a:ln w="9525">
                <a:solidFill>
                  <a:srgbClr val="F736E4"/>
                </a:solidFill>
              </a:ln>
              <a:effectLst/>
            </c:spPr>
          </c:marker>
          <c:xVal>
            <c:numRef>
              <c:f>Sheet1!$C$4:$Q$4</c:f>
              <c:numCache>
                <c:formatCode>General</c:formatCode>
                <c:ptCount val="15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10</c:v>
                </c:pt>
                <c:pt idx="4">
                  <c:v>12</c:v>
                </c:pt>
                <c:pt idx="5">
                  <c:v>14</c:v>
                </c:pt>
                <c:pt idx="6">
                  <c:v>17</c:v>
                </c:pt>
                <c:pt idx="7">
                  <c:v>19</c:v>
                </c:pt>
                <c:pt idx="8">
                  <c:v>21</c:v>
                </c:pt>
                <c:pt idx="9">
                  <c:v>23</c:v>
                </c:pt>
                <c:pt idx="10">
                  <c:v>25</c:v>
                </c:pt>
                <c:pt idx="11">
                  <c:v>27</c:v>
                </c:pt>
                <c:pt idx="12">
                  <c:v>29</c:v>
                </c:pt>
                <c:pt idx="13">
                  <c:v>31</c:v>
                </c:pt>
                <c:pt idx="14">
                  <c:v>33</c:v>
                </c:pt>
              </c:numCache>
            </c:numRef>
          </c:xVal>
          <c:yVal>
            <c:numRef>
              <c:f>Sheet1!$C$9:$Q$9</c:f>
              <c:numCache>
                <c:formatCode>General</c:formatCode>
                <c:ptCount val="15"/>
                <c:pt idx="0">
                  <c:v>1</c:v>
                </c:pt>
                <c:pt idx="1">
                  <c:v>0.98361635970000005</c:v>
                </c:pt>
                <c:pt idx="2">
                  <c:v>0.85792872519999996</c:v>
                </c:pt>
                <c:pt idx="3">
                  <c:v>0.60129034130000003</c:v>
                </c:pt>
                <c:pt idx="4">
                  <c:v>0.2509238412</c:v>
                </c:pt>
                <c:pt idx="5">
                  <c:v>9.2093482399999996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8268-894B-A390-B3CCB2A391E6}"/>
            </c:ext>
          </c:extLst>
        </c:ser>
        <c:ser>
          <c:idx val="5"/>
          <c:order val="5"/>
          <c:tx>
            <c:strRef>
              <c:f>Sheet1!$B$10</c:f>
              <c:strCache>
                <c:ptCount val="1"/>
                <c:pt idx="0">
                  <c:v>MR + SAM</c:v>
                </c:pt>
              </c:strCache>
            </c:strRef>
          </c:tx>
          <c:spPr>
            <a:ln w="9525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4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C$4:$Q$4</c:f>
              <c:numCache>
                <c:formatCode>General</c:formatCode>
                <c:ptCount val="15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10</c:v>
                </c:pt>
                <c:pt idx="4">
                  <c:v>12</c:v>
                </c:pt>
                <c:pt idx="5">
                  <c:v>14</c:v>
                </c:pt>
                <c:pt idx="6">
                  <c:v>17</c:v>
                </c:pt>
                <c:pt idx="7">
                  <c:v>19</c:v>
                </c:pt>
                <c:pt idx="8">
                  <c:v>21</c:v>
                </c:pt>
                <c:pt idx="9">
                  <c:v>23</c:v>
                </c:pt>
                <c:pt idx="10">
                  <c:v>25</c:v>
                </c:pt>
                <c:pt idx="11">
                  <c:v>27</c:v>
                </c:pt>
                <c:pt idx="12">
                  <c:v>29</c:v>
                </c:pt>
                <c:pt idx="13">
                  <c:v>31</c:v>
                </c:pt>
                <c:pt idx="14">
                  <c:v>33</c:v>
                </c:pt>
              </c:numCache>
            </c:numRef>
          </c:xVal>
          <c:yVal>
            <c:numRef>
              <c:f>Sheet1!$C$10:$Q$10</c:f>
              <c:numCache>
                <c:formatCode>General</c:formatCode>
                <c:ptCount val="15"/>
                <c:pt idx="0">
                  <c:v>1</c:v>
                </c:pt>
                <c:pt idx="1">
                  <c:v>0.98352104330000001</c:v>
                </c:pt>
                <c:pt idx="2">
                  <c:v>0.70129034810000002</c:v>
                </c:pt>
                <c:pt idx="3">
                  <c:v>0.4950921834</c:v>
                </c:pt>
                <c:pt idx="4">
                  <c:v>0.20341902379999999</c:v>
                </c:pt>
                <c:pt idx="5">
                  <c:v>9.2109348120000004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8268-894B-A390-B3CCB2A391E6}"/>
            </c:ext>
          </c:extLst>
        </c:ser>
        <c:ser>
          <c:idx val="6"/>
          <c:order val="6"/>
          <c:tx>
            <c:strRef>
              <c:f>Sheet1!$B$11</c:f>
              <c:strCache>
                <c:ptCount val="1"/>
                <c:pt idx="0">
                  <c:v>S362D + SAM</c:v>
                </c:pt>
              </c:strCache>
            </c:strRef>
          </c:tx>
          <c:spPr>
            <a:ln w="9525" cap="rnd">
              <a:solidFill>
                <a:srgbClr val="7132A1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bg1"/>
              </a:solidFill>
              <a:ln w="9525">
                <a:solidFill>
                  <a:srgbClr val="7132A1"/>
                </a:solidFill>
              </a:ln>
              <a:effectLst/>
            </c:spPr>
          </c:marker>
          <c:xVal>
            <c:numRef>
              <c:f>Sheet1!$C$4:$Q$4</c:f>
              <c:numCache>
                <c:formatCode>General</c:formatCode>
                <c:ptCount val="15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10</c:v>
                </c:pt>
                <c:pt idx="4">
                  <c:v>12</c:v>
                </c:pt>
                <c:pt idx="5">
                  <c:v>14</c:v>
                </c:pt>
                <c:pt idx="6">
                  <c:v>17</c:v>
                </c:pt>
                <c:pt idx="7">
                  <c:v>19</c:v>
                </c:pt>
                <c:pt idx="8">
                  <c:v>21</c:v>
                </c:pt>
                <c:pt idx="9">
                  <c:v>23</c:v>
                </c:pt>
                <c:pt idx="10">
                  <c:v>25</c:v>
                </c:pt>
                <c:pt idx="11">
                  <c:v>27</c:v>
                </c:pt>
                <c:pt idx="12">
                  <c:v>29</c:v>
                </c:pt>
                <c:pt idx="13">
                  <c:v>31</c:v>
                </c:pt>
                <c:pt idx="14">
                  <c:v>33</c:v>
                </c:pt>
              </c:numCache>
            </c:numRef>
          </c:xVal>
          <c:yVal>
            <c:numRef>
              <c:f>Sheet1!$C$11:$Q$11</c:f>
              <c:numCache>
                <c:formatCode>General</c:formatCode>
                <c:ptCount val="15"/>
                <c:pt idx="0">
                  <c:v>1</c:v>
                </c:pt>
                <c:pt idx="1">
                  <c:v>0.94781105990000003</c:v>
                </c:pt>
                <c:pt idx="2">
                  <c:v>0.83122119819999996</c:v>
                </c:pt>
                <c:pt idx="3">
                  <c:v>0.77822580649999995</c:v>
                </c:pt>
                <c:pt idx="4">
                  <c:v>0.70902384929999995</c:v>
                </c:pt>
                <c:pt idx="5">
                  <c:v>0.66129034809999998</c:v>
                </c:pt>
                <c:pt idx="6">
                  <c:v>0.51509216589999995</c:v>
                </c:pt>
                <c:pt idx="7">
                  <c:v>0.50129034809999995</c:v>
                </c:pt>
                <c:pt idx="8">
                  <c:v>0.39102394810000002</c:v>
                </c:pt>
                <c:pt idx="9">
                  <c:v>0.34904930000000001</c:v>
                </c:pt>
                <c:pt idx="10">
                  <c:v>0.30349034000000003</c:v>
                </c:pt>
                <c:pt idx="11">
                  <c:v>0.19489339999999999</c:v>
                </c:pt>
                <c:pt idx="12">
                  <c:v>8.8123489200000002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8268-894B-A390-B3CCB2A391E6}"/>
            </c:ext>
          </c:extLst>
        </c:ser>
        <c:ser>
          <c:idx val="7"/>
          <c:order val="7"/>
          <c:tx>
            <c:strRef>
              <c:f>Sheet1!$B$12</c:f>
              <c:strCache>
                <c:ptCount val="1"/>
                <c:pt idx="0">
                  <c:v>S362D MR + SAM</c:v>
                </c:pt>
              </c:strCache>
            </c:strRef>
          </c:tx>
          <c:spPr>
            <a:ln w="9525" cap="rnd">
              <a:solidFill>
                <a:srgbClr val="A67728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bg1"/>
              </a:solidFill>
              <a:ln w="9525">
                <a:solidFill>
                  <a:srgbClr val="A67829"/>
                </a:solidFill>
              </a:ln>
              <a:effectLst/>
            </c:spPr>
          </c:marker>
          <c:xVal>
            <c:numRef>
              <c:f>Sheet1!$C$4:$Q$4</c:f>
              <c:numCache>
                <c:formatCode>General</c:formatCode>
                <c:ptCount val="15"/>
                <c:pt idx="0">
                  <c:v>3</c:v>
                </c:pt>
                <c:pt idx="1">
                  <c:v>5</c:v>
                </c:pt>
                <c:pt idx="2">
                  <c:v>7</c:v>
                </c:pt>
                <c:pt idx="3">
                  <c:v>10</c:v>
                </c:pt>
                <c:pt idx="4">
                  <c:v>12</c:v>
                </c:pt>
                <c:pt idx="5">
                  <c:v>14</c:v>
                </c:pt>
                <c:pt idx="6">
                  <c:v>17</c:v>
                </c:pt>
                <c:pt idx="7">
                  <c:v>19</c:v>
                </c:pt>
                <c:pt idx="8">
                  <c:v>21</c:v>
                </c:pt>
                <c:pt idx="9">
                  <c:v>23</c:v>
                </c:pt>
                <c:pt idx="10">
                  <c:v>25</c:v>
                </c:pt>
                <c:pt idx="11">
                  <c:v>27</c:v>
                </c:pt>
                <c:pt idx="12">
                  <c:v>29</c:v>
                </c:pt>
                <c:pt idx="13">
                  <c:v>31</c:v>
                </c:pt>
                <c:pt idx="14">
                  <c:v>33</c:v>
                </c:pt>
              </c:numCache>
            </c:numRef>
          </c:xVal>
          <c:yVal>
            <c:numRef>
              <c:f>Sheet1!$C$12:$Q$12</c:f>
              <c:numCache>
                <c:formatCode>General</c:formatCode>
                <c:ptCount val="15"/>
                <c:pt idx="0">
                  <c:v>1</c:v>
                </c:pt>
                <c:pt idx="1">
                  <c:v>0.99979035640000002</c:v>
                </c:pt>
                <c:pt idx="2">
                  <c:v>0.87264150939999996</c:v>
                </c:pt>
                <c:pt idx="3">
                  <c:v>0.84748427670000004</c:v>
                </c:pt>
                <c:pt idx="4">
                  <c:v>0.7912093483</c:v>
                </c:pt>
                <c:pt idx="5">
                  <c:v>0.60102934809999997</c:v>
                </c:pt>
                <c:pt idx="6">
                  <c:v>0.56488469600000002</c:v>
                </c:pt>
                <c:pt idx="7">
                  <c:v>0.40251572330000002</c:v>
                </c:pt>
                <c:pt idx="8">
                  <c:v>0.35190238410000002</c:v>
                </c:pt>
                <c:pt idx="9">
                  <c:v>0.35012903400000001</c:v>
                </c:pt>
                <c:pt idx="10">
                  <c:v>0.33941902299999999</c:v>
                </c:pt>
                <c:pt idx="11">
                  <c:v>0.30129033999999999</c:v>
                </c:pt>
                <c:pt idx="12">
                  <c:v>0.15349012300000001</c:v>
                </c:pt>
                <c:pt idx="13">
                  <c:v>0.12904189999999999</c:v>
                </c:pt>
                <c:pt idx="14">
                  <c:v>7.5823490100000002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8268-894B-A390-B3CCB2A391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6295519"/>
        <c:axId val="86275135"/>
      </c:scatterChart>
      <c:valAx>
        <c:axId val="86295519"/>
        <c:scaling>
          <c:orientation val="minMax"/>
          <c:max val="4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b="0">
                    <a:solidFill>
                      <a:schemeClr val="tx1"/>
                    </a:solidFill>
                  </a:rPr>
                  <a:t>Time (days)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275135"/>
        <c:crosses val="autoZero"/>
        <c:crossBetween val="midCat"/>
        <c:majorUnit val="10"/>
      </c:valAx>
      <c:valAx>
        <c:axId val="86275135"/>
        <c:scaling>
          <c:orientation val="minMax"/>
          <c:max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b="0" dirty="0">
                    <a:solidFill>
                      <a:schemeClr val="tx1"/>
                    </a:solidFill>
                  </a:rPr>
                  <a:t> Survival</a:t>
                </a:r>
              </a:p>
            </c:rich>
          </c:tx>
          <c:layout>
            <c:manualLayout>
              <c:xMode val="edge"/>
              <c:yMode val="edge"/>
              <c:x val="0"/>
              <c:y val="0.26286431911408986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295519"/>
        <c:crosses val="autoZero"/>
        <c:crossBetween val="midCat"/>
        <c:majorUnit val="0.2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  <c:extLst/>
  </c:chart>
  <c:spPr>
    <a:ln w="9525">
      <a:noFill/>
    </a:ln>
  </c:spPr>
  <c:txPr>
    <a:bodyPr/>
    <a:lstStyle/>
    <a:p>
      <a:pPr>
        <a:defRPr sz="11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913717702749282"/>
          <c:y val="3.6781666028010238E-2"/>
          <c:w val="0.70831754902552502"/>
          <c:h val="0.74154911539807089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C$79</c:f>
              <c:strCache>
                <c:ptCount val="1"/>
                <c:pt idx="0">
                  <c:v>Control</c:v>
                </c:pt>
              </c:strCache>
            </c:strRef>
          </c:tx>
          <c:spPr>
            <a:ln w="9525" cap="rnd">
              <a:solidFill>
                <a:srgbClr val="0673C4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bg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D$78:$P$78</c:f>
              <c:numCache>
                <c:formatCode>General</c:formatCode>
                <c:ptCount val="13"/>
                <c:pt idx="0">
                  <c:v>4</c:v>
                </c:pt>
                <c:pt idx="1">
                  <c:v>7</c:v>
                </c:pt>
                <c:pt idx="2">
                  <c:v>9</c:v>
                </c:pt>
                <c:pt idx="3">
                  <c:v>10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3</c:v>
                </c:pt>
                <c:pt idx="9">
                  <c:v>25</c:v>
                </c:pt>
                <c:pt idx="10">
                  <c:v>28</c:v>
                </c:pt>
                <c:pt idx="11">
                  <c:v>31</c:v>
                </c:pt>
                <c:pt idx="12">
                  <c:v>33</c:v>
                </c:pt>
              </c:numCache>
            </c:numRef>
          </c:xVal>
          <c:yVal>
            <c:numRef>
              <c:f>Sheet1!$D$79:$P$79</c:f>
              <c:numCache>
                <c:formatCode>General</c:formatCode>
                <c:ptCount val="13"/>
                <c:pt idx="0">
                  <c:v>1</c:v>
                </c:pt>
                <c:pt idx="1">
                  <c:v>0.88984168870000002</c:v>
                </c:pt>
                <c:pt idx="2">
                  <c:v>0.86193931400000001</c:v>
                </c:pt>
                <c:pt idx="3">
                  <c:v>0.76339050129999997</c:v>
                </c:pt>
                <c:pt idx="4">
                  <c:v>0.58129038430000002</c:v>
                </c:pt>
                <c:pt idx="5">
                  <c:v>0.4200527704</c:v>
                </c:pt>
                <c:pt idx="6">
                  <c:v>0.22361477569999999</c:v>
                </c:pt>
                <c:pt idx="7">
                  <c:v>4.4327176779999998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733-AD4E-B092-A56980451B28}"/>
            </c:ext>
          </c:extLst>
        </c:ser>
        <c:ser>
          <c:idx val="1"/>
          <c:order val="1"/>
          <c:tx>
            <c:strRef>
              <c:f>Sheet1!$C$80</c:f>
              <c:strCache>
                <c:ptCount val="1"/>
                <c:pt idx="0">
                  <c:v>MR</c:v>
                </c:pt>
              </c:strCache>
            </c:strRef>
          </c:tx>
          <c:spPr>
            <a:ln w="9525" cap="rnd">
              <a:solidFill>
                <a:srgbClr val="25B160"/>
              </a:solidFill>
              <a:round/>
            </a:ln>
            <a:effectLst/>
          </c:spPr>
          <c:marker>
            <c:symbol val="square"/>
            <c:size val="4"/>
            <c:spPr>
              <a:solidFill>
                <a:schemeClr val="bg1"/>
              </a:solidFill>
              <a:ln w="9525">
                <a:solidFill>
                  <a:srgbClr val="25B160"/>
                </a:solidFill>
              </a:ln>
              <a:effectLst/>
            </c:spPr>
          </c:marker>
          <c:xVal>
            <c:numRef>
              <c:f>Sheet1!$D$78:$P$78</c:f>
              <c:numCache>
                <c:formatCode>General</c:formatCode>
                <c:ptCount val="13"/>
                <c:pt idx="0">
                  <c:v>4</c:v>
                </c:pt>
                <c:pt idx="1">
                  <c:v>7</c:v>
                </c:pt>
                <c:pt idx="2">
                  <c:v>9</c:v>
                </c:pt>
                <c:pt idx="3">
                  <c:v>10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3</c:v>
                </c:pt>
                <c:pt idx="9">
                  <c:v>25</c:v>
                </c:pt>
                <c:pt idx="10">
                  <c:v>28</c:v>
                </c:pt>
                <c:pt idx="11">
                  <c:v>31</c:v>
                </c:pt>
                <c:pt idx="12">
                  <c:v>33</c:v>
                </c:pt>
              </c:numCache>
            </c:numRef>
          </c:xVal>
          <c:yVal>
            <c:numRef>
              <c:f>Sheet1!$D$80:$P$80</c:f>
              <c:numCache>
                <c:formatCode>General</c:formatCode>
                <c:ptCount val="13"/>
                <c:pt idx="0">
                  <c:v>1</c:v>
                </c:pt>
                <c:pt idx="1">
                  <c:v>0.91440922189999996</c:v>
                </c:pt>
                <c:pt idx="2">
                  <c:v>0.90668587899999997</c:v>
                </c:pt>
                <c:pt idx="3">
                  <c:v>0.87563400579999995</c:v>
                </c:pt>
                <c:pt idx="4">
                  <c:v>0.84190238419999996</c:v>
                </c:pt>
                <c:pt idx="5">
                  <c:v>0.82536023049999996</c:v>
                </c:pt>
                <c:pt idx="6">
                  <c:v>0.70461095100000004</c:v>
                </c:pt>
                <c:pt idx="7">
                  <c:v>0.55475504320000002</c:v>
                </c:pt>
                <c:pt idx="8">
                  <c:v>0.45918234812300002</c:v>
                </c:pt>
                <c:pt idx="9">
                  <c:v>0.30120392000000001</c:v>
                </c:pt>
                <c:pt idx="10">
                  <c:v>0.21349012394</c:v>
                </c:pt>
                <c:pt idx="11">
                  <c:v>0.13190349032000001</c:v>
                </c:pt>
                <c:pt idx="12">
                  <c:v>9.8910149320000001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733-AD4E-B092-A56980451B28}"/>
            </c:ext>
          </c:extLst>
        </c:ser>
        <c:ser>
          <c:idx val="2"/>
          <c:order val="2"/>
          <c:tx>
            <c:strRef>
              <c:f>Sheet1!$C$81</c:f>
              <c:strCache>
                <c:ptCount val="1"/>
                <c:pt idx="0">
                  <c:v>Control + met D0</c:v>
                </c:pt>
              </c:strCache>
            </c:strRef>
          </c:tx>
          <c:spPr>
            <a:ln w="9525" cap="rnd">
              <a:solidFill>
                <a:srgbClr val="F6D256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bg1"/>
              </a:solidFill>
              <a:ln w="9525">
                <a:solidFill>
                  <a:srgbClr val="F6D256"/>
                </a:solidFill>
              </a:ln>
              <a:effectLst/>
            </c:spPr>
          </c:marker>
          <c:xVal>
            <c:numRef>
              <c:f>Sheet1!$D$78:$P$78</c:f>
              <c:numCache>
                <c:formatCode>General</c:formatCode>
                <c:ptCount val="13"/>
                <c:pt idx="0">
                  <c:v>4</c:v>
                </c:pt>
                <c:pt idx="1">
                  <c:v>7</c:v>
                </c:pt>
                <c:pt idx="2">
                  <c:v>9</c:v>
                </c:pt>
                <c:pt idx="3">
                  <c:v>10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3</c:v>
                </c:pt>
                <c:pt idx="9">
                  <c:v>25</c:v>
                </c:pt>
                <c:pt idx="10">
                  <c:v>28</c:v>
                </c:pt>
                <c:pt idx="11">
                  <c:v>31</c:v>
                </c:pt>
                <c:pt idx="12">
                  <c:v>33</c:v>
                </c:pt>
              </c:numCache>
            </c:numRef>
          </c:xVal>
          <c:yVal>
            <c:numRef>
              <c:f>Sheet1!$D$81:$P$81</c:f>
              <c:numCache>
                <c:formatCode>General</c:formatCode>
                <c:ptCount val="13"/>
                <c:pt idx="0">
                  <c:v>1</c:v>
                </c:pt>
                <c:pt idx="1">
                  <c:v>0.74044117649999996</c:v>
                </c:pt>
                <c:pt idx="2">
                  <c:v>0.28180147059999999</c:v>
                </c:pt>
                <c:pt idx="3">
                  <c:v>9.1360294120000005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2733-AD4E-B092-A56980451B28}"/>
            </c:ext>
          </c:extLst>
        </c:ser>
        <c:ser>
          <c:idx val="3"/>
          <c:order val="3"/>
          <c:tx>
            <c:strRef>
              <c:f>Sheet1!$C$82</c:f>
              <c:strCache>
                <c:ptCount val="1"/>
                <c:pt idx="0">
                  <c:v>MR + met D0</c:v>
                </c:pt>
              </c:strCache>
            </c:strRef>
          </c:tx>
          <c:spPr>
            <a:ln w="9525" cap="rnd">
              <a:solidFill>
                <a:srgbClr val="F64F00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bg1"/>
              </a:solidFill>
              <a:ln w="9525">
                <a:solidFill>
                  <a:srgbClr val="F64F00"/>
                </a:solidFill>
              </a:ln>
              <a:effectLst/>
            </c:spPr>
          </c:marker>
          <c:xVal>
            <c:numRef>
              <c:f>Sheet1!$D$78:$P$78</c:f>
              <c:numCache>
                <c:formatCode>General</c:formatCode>
                <c:ptCount val="13"/>
                <c:pt idx="0">
                  <c:v>4</c:v>
                </c:pt>
                <c:pt idx="1">
                  <c:v>7</c:v>
                </c:pt>
                <c:pt idx="2">
                  <c:v>9</c:v>
                </c:pt>
                <c:pt idx="3">
                  <c:v>10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3</c:v>
                </c:pt>
                <c:pt idx="9">
                  <c:v>25</c:v>
                </c:pt>
                <c:pt idx="10">
                  <c:v>28</c:v>
                </c:pt>
                <c:pt idx="11">
                  <c:v>31</c:v>
                </c:pt>
                <c:pt idx="12">
                  <c:v>33</c:v>
                </c:pt>
              </c:numCache>
            </c:numRef>
          </c:xVal>
          <c:yVal>
            <c:numRef>
              <c:f>Sheet1!$D$82:$P$82</c:f>
              <c:numCache>
                <c:formatCode>General</c:formatCode>
                <c:ptCount val="13"/>
                <c:pt idx="0">
                  <c:v>1</c:v>
                </c:pt>
                <c:pt idx="1">
                  <c:v>0.91357594600000003</c:v>
                </c:pt>
                <c:pt idx="2">
                  <c:v>0.77628899129999995</c:v>
                </c:pt>
                <c:pt idx="3">
                  <c:v>0.54196591270000005</c:v>
                </c:pt>
                <c:pt idx="4">
                  <c:v>0.48139840210000001</c:v>
                </c:pt>
                <c:pt idx="5">
                  <c:v>0.38910922930000003</c:v>
                </c:pt>
                <c:pt idx="6">
                  <c:v>0.20559545500000001</c:v>
                </c:pt>
                <c:pt idx="7">
                  <c:v>8.1023941229999993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2733-AD4E-B092-A56980451B28}"/>
            </c:ext>
          </c:extLst>
        </c:ser>
        <c:ser>
          <c:idx val="4"/>
          <c:order val="4"/>
          <c:tx>
            <c:strRef>
              <c:f>Sheet1!$C$83</c:f>
              <c:strCache>
                <c:ptCount val="1"/>
                <c:pt idx="0">
                  <c:v>Control + met D4</c:v>
                </c:pt>
              </c:strCache>
            </c:strRef>
          </c:tx>
          <c:spPr>
            <a:ln w="9525" cap="rnd">
              <a:solidFill>
                <a:srgbClr val="F736E4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bg1"/>
              </a:solidFill>
              <a:ln w="9525">
                <a:solidFill>
                  <a:srgbClr val="F736E4"/>
                </a:solidFill>
              </a:ln>
              <a:effectLst/>
            </c:spPr>
          </c:marker>
          <c:xVal>
            <c:numRef>
              <c:f>Sheet1!$D$78:$P$78</c:f>
              <c:numCache>
                <c:formatCode>General</c:formatCode>
                <c:ptCount val="13"/>
                <c:pt idx="0">
                  <c:v>4</c:v>
                </c:pt>
                <c:pt idx="1">
                  <c:v>7</c:v>
                </c:pt>
                <c:pt idx="2">
                  <c:v>9</c:v>
                </c:pt>
                <c:pt idx="3">
                  <c:v>10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3</c:v>
                </c:pt>
                <c:pt idx="9">
                  <c:v>25</c:v>
                </c:pt>
                <c:pt idx="10">
                  <c:v>28</c:v>
                </c:pt>
                <c:pt idx="11">
                  <c:v>31</c:v>
                </c:pt>
                <c:pt idx="12">
                  <c:v>33</c:v>
                </c:pt>
              </c:numCache>
            </c:numRef>
          </c:xVal>
          <c:yVal>
            <c:numRef>
              <c:f>Sheet1!$D$83:$P$83</c:f>
              <c:numCache>
                <c:formatCode>General</c:formatCode>
                <c:ptCount val="13"/>
                <c:pt idx="0">
                  <c:v>1</c:v>
                </c:pt>
                <c:pt idx="1">
                  <c:v>0.64988636359999996</c:v>
                </c:pt>
                <c:pt idx="2">
                  <c:v>0.18664772730000001</c:v>
                </c:pt>
                <c:pt idx="3">
                  <c:v>7.0596590910000007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2733-AD4E-B092-A56980451B28}"/>
            </c:ext>
          </c:extLst>
        </c:ser>
        <c:ser>
          <c:idx val="5"/>
          <c:order val="5"/>
          <c:tx>
            <c:strRef>
              <c:f>Sheet1!$C$84</c:f>
              <c:strCache>
                <c:ptCount val="1"/>
                <c:pt idx="0">
                  <c:v>MR + met D4</c:v>
                </c:pt>
              </c:strCache>
            </c:strRef>
          </c:tx>
          <c:spPr>
            <a:ln w="9525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4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D$78:$P$78</c:f>
              <c:numCache>
                <c:formatCode>General</c:formatCode>
                <c:ptCount val="13"/>
                <c:pt idx="0">
                  <c:v>4</c:v>
                </c:pt>
                <c:pt idx="1">
                  <c:v>7</c:v>
                </c:pt>
                <c:pt idx="2">
                  <c:v>9</c:v>
                </c:pt>
                <c:pt idx="3">
                  <c:v>10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3</c:v>
                </c:pt>
                <c:pt idx="9">
                  <c:v>25</c:v>
                </c:pt>
                <c:pt idx="10">
                  <c:v>28</c:v>
                </c:pt>
                <c:pt idx="11">
                  <c:v>31</c:v>
                </c:pt>
                <c:pt idx="12">
                  <c:v>33</c:v>
                </c:pt>
              </c:numCache>
            </c:numRef>
          </c:xVal>
          <c:yVal>
            <c:numRef>
              <c:f>Sheet1!$D$84:$P$84</c:f>
              <c:numCache>
                <c:formatCode>General</c:formatCode>
                <c:ptCount val="13"/>
                <c:pt idx="0">
                  <c:v>1</c:v>
                </c:pt>
                <c:pt idx="1">
                  <c:v>0.99481132080000001</c:v>
                </c:pt>
                <c:pt idx="2">
                  <c:v>0.96630306600000004</c:v>
                </c:pt>
                <c:pt idx="3">
                  <c:v>0.95448113209999996</c:v>
                </c:pt>
                <c:pt idx="4">
                  <c:v>0.83091238410000001</c:v>
                </c:pt>
                <c:pt idx="5">
                  <c:v>0.56037735850000003</c:v>
                </c:pt>
                <c:pt idx="6">
                  <c:v>0.2564858491</c:v>
                </c:pt>
                <c:pt idx="7">
                  <c:v>0.1155660377</c:v>
                </c:pt>
                <c:pt idx="8">
                  <c:v>7.4128934300000004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2733-AD4E-B092-A56980451B2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6295519"/>
        <c:axId val="86275135"/>
      </c:scatterChart>
      <c:valAx>
        <c:axId val="86295519"/>
        <c:scaling>
          <c:orientation val="minMax"/>
          <c:max val="4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>
                    <a:solidFill>
                      <a:schemeClr val="tx1"/>
                    </a:solidFill>
                  </a:rPr>
                  <a:t>Time (days)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275135"/>
        <c:crosses val="autoZero"/>
        <c:crossBetween val="midCat"/>
      </c:valAx>
      <c:valAx>
        <c:axId val="86275135"/>
        <c:scaling>
          <c:orientation val="minMax"/>
          <c:max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dirty="0">
                    <a:solidFill>
                      <a:schemeClr val="tx1"/>
                    </a:solidFill>
                  </a:rPr>
                  <a:t>Surviva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295519"/>
        <c:crosses val="autoZero"/>
        <c:crossBetween val="midCat"/>
        <c:majorUnit val="0.2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  <c:extLst/>
  </c:chart>
  <c:txPr>
    <a:bodyPr/>
    <a:lstStyle/>
    <a:p>
      <a:pPr>
        <a:defRPr sz="11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2741</cdr:x>
      <cdr:y>0.04458</cdr:y>
    </cdr:from>
    <cdr:to>
      <cdr:x>0.96706</cdr:x>
      <cdr:y>0.3023</cdr:y>
    </cdr:to>
    <cdr:sp macro="" textlink="">
      <cdr:nvSpPr>
        <cdr:cNvPr id="2" name="TextBox 40">
          <a:extLst xmlns:a="http://schemas.openxmlformats.org/drawingml/2006/main">
            <a:ext uri="{FF2B5EF4-FFF2-40B4-BE49-F238E27FC236}">
              <a16:creationId xmlns:a16="http://schemas.microsoft.com/office/drawing/2014/main" id="{D4F42932-6101-F91A-E903-6F246EEF5B40}"/>
            </a:ext>
          </a:extLst>
        </cdr:cNvPr>
        <cdr:cNvSpPr txBox="1"/>
      </cdr:nvSpPr>
      <cdr:spPr>
        <a:xfrm xmlns:a="http://schemas.openxmlformats.org/drawingml/2006/main">
          <a:off x="1721009" y="79859"/>
          <a:ext cx="931665" cy="461665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n-US" sz="800" dirty="0">
              <a:solidFill>
                <a:srgbClr val="0673C4"/>
              </a:solidFill>
              <a:latin typeface="Arial" panose="020B0604020202020204" pitchFamily="34" charset="0"/>
              <a:cs typeface="Arial" panose="020B0604020202020204" pitchFamily="34" charset="0"/>
            </a:rPr>
            <a:t>BY4742</a:t>
          </a:r>
        </a:p>
        <a:p xmlns:a="http://schemas.openxmlformats.org/drawingml/2006/main">
          <a:pPr algn="r"/>
          <a:r>
            <a:rPr lang="en-US" sz="800" dirty="0">
              <a:solidFill>
                <a:srgbClr val="25B160"/>
              </a:solidFill>
              <a:latin typeface="Arial" panose="020B0604020202020204" pitchFamily="34" charset="0"/>
              <a:cs typeface="Arial" panose="020B0604020202020204" pitchFamily="34" charset="0"/>
            </a:rPr>
            <a:t>BY4742</a:t>
          </a:r>
          <a:r>
            <a:rPr lang="en-US" sz="800" baseline="0" dirty="0">
              <a:solidFill>
                <a:srgbClr val="25B160"/>
              </a:solidFill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n-US" sz="800" i="1" dirty="0">
              <a:solidFill>
                <a:srgbClr val="25B160"/>
              </a:solidFill>
              <a:latin typeface="Arial" panose="020B0604020202020204" pitchFamily="34" charset="0"/>
              <a:cs typeface="Arial" panose="020B0604020202020204" pitchFamily="34" charset="0"/>
            </a:rPr>
            <a:t>met15∆</a:t>
          </a:r>
          <a:endParaRPr lang="en-US" sz="800" dirty="0">
            <a:solidFill>
              <a:srgbClr val="25B160"/>
            </a:solidFill>
            <a:latin typeface="Arial" panose="020B0604020202020204" pitchFamily="34" charset="0"/>
            <a:cs typeface="Arial" panose="020B0604020202020204" pitchFamily="34" charset="0"/>
          </a:endParaRPr>
        </a:p>
        <a:p xmlns:a="http://schemas.openxmlformats.org/drawingml/2006/main">
          <a:pPr algn="r"/>
          <a:r>
            <a:rPr lang="en-US" sz="800" i="0" dirty="0">
              <a:solidFill>
                <a:srgbClr val="F6D256"/>
              </a:solidFill>
              <a:latin typeface="Arial" panose="020B0604020202020204" pitchFamily="34" charset="0"/>
              <a:cs typeface="Arial" panose="020B0604020202020204" pitchFamily="34" charset="0"/>
            </a:rPr>
            <a:t>BY4741</a:t>
          </a:r>
          <a:endParaRPr lang="en-US" sz="800" i="1" dirty="0">
            <a:solidFill>
              <a:srgbClr val="F6D256"/>
            </a:solidFill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6546</cdr:x>
      <cdr:y>0.03025</cdr:y>
    </cdr:from>
    <cdr:to>
      <cdr:x>0.95258</cdr:x>
      <cdr:y>0.39428</cdr:y>
    </cdr:to>
    <cdr:sp macro="" textlink="">
      <cdr:nvSpPr>
        <cdr:cNvPr id="2" name="TextBox 40">
          <a:extLst xmlns:a="http://schemas.openxmlformats.org/drawingml/2006/main">
            <a:ext uri="{FF2B5EF4-FFF2-40B4-BE49-F238E27FC236}">
              <a16:creationId xmlns:a16="http://schemas.microsoft.com/office/drawing/2014/main" id="{D4F42932-6101-F91A-E903-6F246EEF5B40}"/>
            </a:ext>
          </a:extLst>
        </cdr:cNvPr>
        <cdr:cNvSpPr txBox="1"/>
      </cdr:nvSpPr>
      <cdr:spPr>
        <a:xfrm xmlns:a="http://schemas.openxmlformats.org/drawingml/2006/main">
          <a:off x="1881355" y="58824"/>
          <a:ext cx="856388" cy="707886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n-US" sz="800" dirty="0">
              <a:solidFill>
                <a:srgbClr val="0673C4"/>
              </a:solidFill>
              <a:latin typeface="Arial" panose="020B0604020202020204" pitchFamily="34" charset="0"/>
              <a:cs typeface="Arial" panose="020B0604020202020204" pitchFamily="34" charset="0"/>
            </a:rPr>
            <a:t>Control</a:t>
          </a:r>
        </a:p>
        <a:p xmlns:a="http://schemas.openxmlformats.org/drawingml/2006/main">
          <a:pPr algn="r"/>
          <a:r>
            <a:rPr lang="en-US" sz="800" dirty="0">
              <a:solidFill>
                <a:srgbClr val="25B160"/>
              </a:solidFill>
              <a:latin typeface="Arial" panose="020B0604020202020204" pitchFamily="34" charset="0"/>
              <a:cs typeface="Arial" panose="020B0604020202020204" pitchFamily="34" charset="0"/>
            </a:rPr>
            <a:t>CR</a:t>
          </a:r>
        </a:p>
        <a:p xmlns:a="http://schemas.openxmlformats.org/drawingml/2006/main">
          <a:pPr algn="r"/>
          <a:r>
            <a:rPr lang="en-US" sz="800" dirty="0">
              <a:solidFill>
                <a:srgbClr val="F6D256"/>
              </a:solidFill>
              <a:latin typeface="Arial" panose="020B0604020202020204" pitchFamily="34" charset="0"/>
              <a:cs typeface="Arial" panose="020B0604020202020204" pitchFamily="34" charset="0"/>
            </a:rPr>
            <a:t>Control + SAM</a:t>
          </a:r>
        </a:p>
        <a:p xmlns:a="http://schemas.openxmlformats.org/drawingml/2006/main">
          <a:pPr algn="r"/>
          <a:r>
            <a:rPr lang="en-US" sz="800" dirty="0">
              <a:solidFill>
                <a:srgbClr val="F45000"/>
              </a:solidFill>
              <a:latin typeface="Arial" panose="020B0604020202020204" pitchFamily="34" charset="0"/>
              <a:cs typeface="Arial" panose="020B0604020202020204" pitchFamily="34" charset="0"/>
            </a:rPr>
            <a:t>CR + SAM</a:t>
          </a:r>
          <a:endParaRPr lang="en-US" sz="800" i="1" dirty="0">
            <a:solidFill>
              <a:srgbClr val="F45000"/>
            </a:solidFill>
            <a:latin typeface="Arial" panose="020B0604020202020204" pitchFamily="34" charset="0"/>
            <a:cs typeface="Arial" panose="020B0604020202020204" pitchFamily="34" charset="0"/>
          </a:endParaRPr>
        </a:p>
        <a:p xmlns:a="http://schemas.openxmlformats.org/drawingml/2006/main">
          <a:pPr algn="r"/>
          <a:endParaRPr lang="en-US" sz="8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76082</cdr:x>
      <cdr:y>0.04834</cdr:y>
    </cdr:from>
    <cdr:to>
      <cdr:x>1</cdr:x>
      <cdr:y>0.36057</cdr:y>
    </cdr:to>
    <cdr:sp macro="" textlink="">
      <cdr:nvSpPr>
        <cdr:cNvPr id="2" name="TextBox 6">
          <a:extLst xmlns:a="http://schemas.openxmlformats.org/drawingml/2006/main">
            <a:ext uri="{FF2B5EF4-FFF2-40B4-BE49-F238E27FC236}">
              <a16:creationId xmlns:a16="http://schemas.microsoft.com/office/drawing/2014/main" id="{9D735A4A-7D6A-FBC5-8683-BDE38D5CE844}"/>
            </a:ext>
          </a:extLst>
        </cdr:cNvPr>
        <cdr:cNvSpPr txBox="1"/>
      </cdr:nvSpPr>
      <cdr:spPr>
        <a:xfrm xmlns:a="http://schemas.openxmlformats.org/drawingml/2006/main">
          <a:off x="2215683" y="94824"/>
          <a:ext cx="696565" cy="612467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800" dirty="0">
              <a:solidFill>
                <a:srgbClr val="0673C4"/>
              </a:solidFill>
              <a:latin typeface="Arial" panose="020B0604020202020204" pitchFamily="34" charset="0"/>
              <a:cs typeface="Arial" panose="020B0604020202020204" pitchFamily="34" charset="0"/>
            </a:rPr>
            <a:t>Control</a:t>
          </a:r>
        </a:p>
        <a:p xmlns:a="http://schemas.openxmlformats.org/drawingml/2006/main">
          <a:r>
            <a:rPr lang="en-US" sz="800" i="1" dirty="0">
              <a:solidFill>
                <a:srgbClr val="25B160"/>
              </a:solidFill>
              <a:latin typeface="Arial" panose="020B0604020202020204" pitchFamily="34" charset="0"/>
              <a:cs typeface="Arial" panose="020B0604020202020204" pitchFamily="34" charset="0"/>
            </a:rPr>
            <a:t>met15∆</a:t>
          </a:r>
        </a:p>
        <a:p xmlns:a="http://schemas.openxmlformats.org/drawingml/2006/main">
          <a:r>
            <a:rPr lang="en-US" sz="800" i="1" dirty="0">
              <a:solidFill>
                <a:srgbClr val="FFC000"/>
              </a:solidFill>
              <a:latin typeface="Arial" panose="020B0604020202020204" pitchFamily="34" charset="0"/>
              <a:cs typeface="Arial" panose="020B0604020202020204" pitchFamily="34" charset="0"/>
            </a:rPr>
            <a:t>met2∆</a:t>
          </a: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68417</cdr:x>
      <cdr:y>0.04856</cdr:y>
    </cdr:from>
    <cdr:to>
      <cdr:x>0.95799</cdr:x>
      <cdr:y>0.50259</cdr:y>
    </cdr:to>
    <cdr:sp macro="" textlink="">
      <cdr:nvSpPr>
        <cdr:cNvPr id="2" name="TextBox 40">
          <a:extLst xmlns:a="http://schemas.openxmlformats.org/drawingml/2006/main">
            <a:ext uri="{FF2B5EF4-FFF2-40B4-BE49-F238E27FC236}">
              <a16:creationId xmlns:a16="http://schemas.microsoft.com/office/drawing/2014/main" id="{D4F42932-6101-F91A-E903-6F246EEF5B40}"/>
            </a:ext>
          </a:extLst>
        </cdr:cNvPr>
        <cdr:cNvSpPr txBox="1"/>
      </cdr:nvSpPr>
      <cdr:spPr>
        <a:xfrm xmlns:a="http://schemas.openxmlformats.org/drawingml/2006/main">
          <a:off x="1743108" y="83941"/>
          <a:ext cx="697629" cy="78483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n-US" sz="900" dirty="0">
              <a:solidFill>
                <a:srgbClr val="0673C4"/>
              </a:solidFill>
              <a:latin typeface="Arial" panose="020B0604020202020204" pitchFamily="34" charset="0"/>
              <a:cs typeface="Arial" panose="020B0604020202020204" pitchFamily="34" charset="0"/>
            </a:rPr>
            <a:t>Control</a:t>
          </a:r>
        </a:p>
        <a:p xmlns:a="http://schemas.openxmlformats.org/drawingml/2006/main">
          <a:pPr algn="r"/>
          <a:r>
            <a:rPr lang="en-US" sz="900" dirty="0">
              <a:solidFill>
                <a:srgbClr val="25B160"/>
              </a:solidFill>
              <a:latin typeface="Arial" panose="020B0604020202020204" pitchFamily="34" charset="0"/>
              <a:cs typeface="Arial" panose="020B0604020202020204" pitchFamily="34" charset="0"/>
            </a:rPr>
            <a:t>MR</a:t>
          </a:r>
        </a:p>
        <a:p xmlns:a="http://schemas.openxmlformats.org/drawingml/2006/main">
          <a:pPr algn="r"/>
          <a:r>
            <a:rPr lang="en-US" sz="900" i="1" dirty="0">
              <a:solidFill>
                <a:srgbClr val="F6D256"/>
              </a:solidFill>
              <a:latin typeface="Arial" panose="020B0604020202020204" pitchFamily="34" charset="0"/>
              <a:cs typeface="Arial" panose="020B0604020202020204" pitchFamily="34" charset="0"/>
            </a:rPr>
            <a:t>rph1∆</a:t>
          </a:r>
        </a:p>
        <a:p xmlns:a="http://schemas.openxmlformats.org/drawingml/2006/main">
          <a:pPr algn="r"/>
          <a:r>
            <a:rPr lang="en-US" sz="900" dirty="0">
              <a:solidFill>
                <a:srgbClr val="F45000"/>
              </a:solidFill>
              <a:latin typeface="Arial" panose="020B0604020202020204" pitchFamily="34" charset="0"/>
              <a:cs typeface="Arial" panose="020B0604020202020204" pitchFamily="34" charset="0"/>
            </a:rPr>
            <a:t>MR </a:t>
          </a:r>
          <a:r>
            <a:rPr lang="en-US" sz="900" i="1" dirty="0">
              <a:solidFill>
                <a:srgbClr val="F45000"/>
              </a:solidFill>
              <a:latin typeface="Arial" panose="020B0604020202020204" pitchFamily="34" charset="0"/>
              <a:cs typeface="Arial" panose="020B0604020202020204" pitchFamily="34" charset="0"/>
            </a:rPr>
            <a:t>rph1∆</a:t>
          </a:r>
        </a:p>
        <a:p xmlns:a="http://schemas.openxmlformats.org/drawingml/2006/main">
          <a:pPr algn="r"/>
          <a:endParaRPr lang="en-US" sz="9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53746</cdr:x>
      <cdr:y>0.11187</cdr:y>
    </cdr:from>
    <cdr:to>
      <cdr:x>0.92186</cdr:x>
      <cdr:y>0.48282</cdr:y>
    </cdr:to>
    <cdr:sp macro="" textlink="">
      <cdr:nvSpPr>
        <cdr:cNvPr id="3" name="TextBox 40">
          <a:extLst xmlns:a="http://schemas.openxmlformats.org/drawingml/2006/main">
            <a:ext uri="{FF2B5EF4-FFF2-40B4-BE49-F238E27FC236}">
              <a16:creationId xmlns:a16="http://schemas.microsoft.com/office/drawing/2014/main" id="{568B2BBC-74E4-688B-5E6F-9F83849B4D2E}"/>
            </a:ext>
          </a:extLst>
        </cdr:cNvPr>
        <cdr:cNvSpPr txBox="1"/>
      </cdr:nvSpPr>
      <cdr:spPr>
        <a:xfrm xmlns:a="http://schemas.openxmlformats.org/drawingml/2006/main">
          <a:off x="1707516" y="236685"/>
          <a:ext cx="1221251" cy="784830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n-US" sz="900" dirty="0">
              <a:solidFill>
                <a:srgbClr val="0673C4"/>
              </a:solidFill>
              <a:latin typeface="Arial" panose="020B0604020202020204" pitchFamily="34" charset="0"/>
              <a:cs typeface="Arial" panose="020B0604020202020204" pitchFamily="34" charset="0"/>
            </a:rPr>
            <a:t>Control</a:t>
          </a:r>
        </a:p>
        <a:p xmlns:a="http://schemas.openxmlformats.org/drawingml/2006/main">
          <a:pPr algn="r"/>
          <a:r>
            <a:rPr lang="en-US" sz="900" dirty="0">
              <a:solidFill>
                <a:srgbClr val="25B160"/>
              </a:solidFill>
              <a:latin typeface="Arial" panose="020B0604020202020204" pitchFamily="34" charset="0"/>
              <a:cs typeface="Arial" panose="020B0604020202020204" pitchFamily="34" charset="0"/>
            </a:rPr>
            <a:t>MR</a:t>
          </a:r>
        </a:p>
        <a:p xmlns:a="http://schemas.openxmlformats.org/drawingml/2006/main">
          <a:pPr algn="r"/>
          <a:r>
            <a:rPr lang="en-US" sz="900" i="1" dirty="0">
              <a:solidFill>
                <a:srgbClr val="F6D256"/>
              </a:solidFill>
              <a:latin typeface="Arial" panose="020B0604020202020204" pitchFamily="34" charset="0"/>
              <a:cs typeface="Arial" panose="020B0604020202020204" pitchFamily="34" charset="0"/>
            </a:rPr>
            <a:t>ppm1∆</a:t>
          </a:r>
          <a:r>
            <a:rPr lang="en-US" sz="900" i="1" baseline="0" dirty="0">
              <a:solidFill>
                <a:srgbClr val="F6D256"/>
              </a:solidFill>
              <a:latin typeface="Arial" panose="020B0604020202020204" pitchFamily="34" charset="0"/>
              <a:cs typeface="Arial" panose="020B0604020202020204" pitchFamily="34" charset="0"/>
            </a:rPr>
            <a:t> </a:t>
          </a:r>
        </a:p>
        <a:p xmlns:a="http://schemas.openxmlformats.org/drawingml/2006/main">
          <a:pPr algn="r"/>
          <a:r>
            <a:rPr lang="en-US" sz="900" i="1" baseline="0" dirty="0">
              <a:solidFill>
                <a:srgbClr val="F54F00"/>
              </a:solidFill>
              <a:latin typeface="Arial" panose="020B0604020202020204" pitchFamily="34" charset="0"/>
              <a:cs typeface="Arial" panose="020B0604020202020204" pitchFamily="34" charset="0"/>
            </a:rPr>
            <a:t>ppm1∆ MR</a:t>
          </a:r>
          <a:endParaRPr lang="en-US" sz="900" i="1" dirty="0">
            <a:solidFill>
              <a:srgbClr val="F54F00"/>
            </a:solidFill>
            <a:latin typeface="Arial" panose="020B0604020202020204" pitchFamily="34" charset="0"/>
            <a:cs typeface="Arial" panose="020B0604020202020204" pitchFamily="34" charset="0"/>
          </a:endParaRPr>
        </a:p>
        <a:p xmlns:a="http://schemas.openxmlformats.org/drawingml/2006/main">
          <a:pPr algn="r"/>
          <a:endParaRPr lang="en-US" sz="9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68019</cdr:x>
      <cdr:y>0.05133</cdr:y>
    </cdr:from>
    <cdr:to>
      <cdr:x>0.94918</cdr:x>
      <cdr:y>0.36356</cdr:y>
    </cdr:to>
    <cdr:sp macro="" textlink="">
      <cdr:nvSpPr>
        <cdr:cNvPr id="2" name="TextBox 6">
          <a:extLst xmlns:a="http://schemas.openxmlformats.org/drawingml/2006/main">
            <a:ext uri="{FF2B5EF4-FFF2-40B4-BE49-F238E27FC236}">
              <a16:creationId xmlns:a16="http://schemas.microsoft.com/office/drawing/2014/main" id="{9D735A4A-7D6A-FBC5-8683-BDE38D5CE844}"/>
            </a:ext>
          </a:extLst>
        </cdr:cNvPr>
        <cdr:cNvSpPr txBox="1"/>
      </cdr:nvSpPr>
      <cdr:spPr>
        <a:xfrm xmlns:a="http://schemas.openxmlformats.org/drawingml/2006/main">
          <a:off x="1648120" y="87082"/>
          <a:ext cx="651772" cy="52974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n-US" sz="900" dirty="0">
              <a:solidFill>
                <a:srgbClr val="0673C4"/>
              </a:solidFill>
              <a:latin typeface="Arial" panose="020B0604020202020204" pitchFamily="34" charset="0"/>
              <a:cs typeface="Arial" panose="020B0604020202020204" pitchFamily="34" charset="0"/>
            </a:rPr>
            <a:t>Control</a:t>
          </a:r>
        </a:p>
        <a:p xmlns:a="http://schemas.openxmlformats.org/drawingml/2006/main">
          <a:pPr algn="r"/>
          <a:r>
            <a:rPr lang="en-US" sz="900" dirty="0">
              <a:solidFill>
                <a:srgbClr val="25B160"/>
              </a:solidFill>
              <a:latin typeface="Arial" panose="020B0604020202020204" pitchFamily="34" charset="0"/>
              <a:cs typeface="Arial" panose="020B0604020202020204" pitchFamily="34" charset="0"/>
            </a:rPr>
            <a:t>MR</a:t>
          </a:r>
        </a:p>
        <a:p xmlns:a="http://schemas.openxmlformats.org/drawingml/2006/main">
          <a:pPr algn="r"/>
          <a:r>
            <a:rPr lang="en-US" sz="900" i="1" dirty="0">
              <a:solidFill>
                <a:srgbClr val="F6D256"/>
              </a:solidFill>
              <a:latin typeface="Arial" panose="020B0604020202020204" pitchFamily="34" charset="0"/>
              <a:cs typeface="Arial" panose="020B0604020202020204" pitchFamily="34" charset="0"/>
            </a:rPr>
            <a:t>rts1∆</a:t>
          </a:r>
        </a:p>
        <a:p xmlns:a="http://schemas.openxmlformats.org/drawingml/2006/main">
          <a:pPr algn="r"/>
          <a:r>
            <a:rPr lang="en-US" sz="900" i="1" dirty="0">
              <a:solidFill>
                <a:srgbClr val="F64F00"/>
              </a:solidFill>
              <a:latin typeface="Arial" panose="020B0604020202020204" pitchFamily="34" charset="0"/>
              <a:cs typeface="Arial" panose="020B0604020202020204" pitchFamily="34" charset="0"/>
            </a:rPr>
            <a:t>cdc55∆</a:t>
          </a:r>
        </a:p>
        <a:p xmlns:a="http://schemas.openxmlformats.org/drawingml/2006/main">
          <a:pPr algn="r"/>
          <a:endParaRPr lang="en-US" sz="900" dirty="0">
            <a:solidFill>
              <a:srgbClr val="0673C4"/>
            </a:solidFill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55883</cdr:x>
      <cdr:y>0.03134</cdr:y>
    </cdr:from>
    <cdr:to>
      <cdr:x>0.87102</cdr:x>
      <cdr:y>0.37087</cdr:y>
    </cdr:to>
    <cdr:sp macro="" textlink="">
      <cdr:nvSpPr>
        <cdr:cNvPr id="2" name="TextBox 6">
          <a:extLst xmlns:a="http://schemas.openxmlformats.org/drawingml/2006/main">
            <a:ext uri="{FF2B5EF4-FFF2-40B4-BE49-F238E27FC236}">
              <a16:creationId xmlns:a16="http://schemas.microsoft.com/office/drawing/2014/main" id="{9D735A4A-7D6A-FBC5-8683-BDE38D5CE844}"/>
            </a:ext>
          </a:extLst>
        </cdr:cNvPr>
        <cdr:cNvSpPr txBox="1"/>
      </cdr:nvSpPr>
      <cdr:spPr>
        <a:xfrm xmlns:a="http://schemas.openxmlformats.org/drawingml/2006/main">
          <a:off x="1549622" y="58095"/>
          <a:ext cx="865685" cy="629398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n-US" sz="700" dirty="0">
              <a:solidFill>
                <a:srgbClr val="0673C4"/>
              </a:solidFill>
              <a:latin typeface="Arial" panose="020B0604020202020204" pitchFamily="34" charset="0"/>
              <a:cs typeface="Arial" panose="020B0604020202020204" pitchFamily="34" charset="0"/>
            </a:rPr>
            <a:t>Control</a:t>
          </a:r>
        </a:p>
        <a:p xmlns:a="http://schemas.openxmlformats.org/drawingml/2006/main">
          <a:pPr algn="r"/>
          <a:r>
            <a:rPr lang="en-US" sz="700" dirty="0">
              <a:solidFill>
                <a:srgbClr val="25B160"/>
              </a:solidFill>
              <a:latin typeface="Arial" panose="020B0604020202020204" pitchFamily="34" charset="0"/>
              <a:cs typeface="Arial" panose="020B0604020202020204" pitchFamily="34" charset="0"/>
            </a:rPr>
            <a:t>MR</a:t>
          </a:r>
        </a:p>
        <a:p xmlns:a="http://schemas.openxmlformats.org/drawingml/2006/main">
          <a:pPr algn="r"/>
          <a:r>
            <a:rPr lang="en-US" sz="700" dirty="0">
              <a:solidFill>
                <a:srgbClr val="F6D256"/>
              </a:solidFill>
              <a:latin typeface="Arial" panose="020B0604020202020204" pitchFamily="34" charset="0"/>
              <a:cs typeface="Arial" panose="020B0604020202020204" pitchFamily="34" charset="0"/>
            </a:rPr>
            <a:t>S362D</a:t>
          </a:r>
        </a:p>
        <a:p xmlns:a="http://schemas.openxmlformats.org/drawingml/2006/main">
          <a:pPr algn="r"/>
          <a:r>
            <a:rPr lang="en-US" sz="700" dirty="0">
              <a:solidFill>
                <a:srgbClr val="F64F00"/>
              </a:solidFill>
              <a:latin typeface="Arial" panose="020B0604020202020204" pitchFamily="34" charset="0"/>
              <a:cs typeface="Arial" panose="020B0604020202020204" pitchFamily="34" charset="0"/>
            </a:rPr>
            <a:t>S362D MR</a:t>
          </a:r>
        </a:p>
        <a:p xmlns:a="http://schemas.openxmlformats.org/drawingml/2006/main">
          <a:pPr algn="r"/>
          <a:r>
            <a:rPr lang="en-US" sz="700" dirty="0">
              <a:solidFill>
                <a:srgbClr val="F736E4"/>
              </a:solidFill>
              <a:latin typeface="Arial" panose="020B0604020202020204" pitchFamily="34" charset="0"/>
              <a:cs typeface="Arial" panose="020B0604020202020204" pitchFamily="34" charset="0"/>
            </a:rPr>
            <a:t>Control</a:t>
          </a:r>
          <a:r>
            <a:rPr lang="en-US" sz="700" baseline="0" dirty="0">
              <a:solidFill>
                <a:srgbClr val="F736E4"/>
              </a:solidFill>
              <a:latin typeface="Arial" panose="020B0604020202020204" pitchFamily="34" charset="0"/>
              <a:cs typeface="Arial" panose="020B0604020202020204" pitchFamily="34" charset="0"/>
            </a:rPr>
            <a:t> + SAM</a:t>
          </a:r>
        </a:p>
        <a:p xmlns:a="http://schemas.openxmlformats.org/drawingml/2006/main">
          <a:pPr algn="r"/>
          <a:r>
            <a:rPr lang="en-US" sz="700" baseline="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MR + SAM</a:t>
          </a:r>
        </a:p>
        <a:p xmlns:a="http://schemas.openxmlformats.org/drawingml/2006/main">
          <a:pPr algn="r"/>
          <a:r>
            <a:rPr lang="en-US" sz="700" baseline="0" dirty="0">
              <a:solidFill>
                <a:srgbClr val="7132A1"/>
              </a:solidFill>
              <a:latin typeface="Arial" panose="020B0604020202020204" pitchFamily="34" charset="0"/>
              <a:cs typeface="Arial" panose="020B0604020202020204" pitchFamily="34" charset="0"/>
            </a:rPr>
            <a:t>S362D + SAM</a:t>
          </a:r>
        </a:p>
        <a:p xmlns:a="http://schemas.openxmlformats.org/drawingml/2006/main">
          <a:pPr algn="r"/>
          <a:r>
            <a:rPr lang="en-US" sz="700" baseline="0" dirty="0">
              <a:solidFill>
                <a:srgbClr val="A67829"/>
              </a:solidFill>
              <a:latin typeface="Arial" panose="020B0604020202020204" pitchFamily="34" charset="0"/>
              <a:cs typeface="Arial" panose="020B0604020202020204" pitchFamily="34" charset="0"/>
            </a:rPr>
            <a:t>S362D MR + SAM</a:t>
          </a:r>
        </a:p>
        <a:p xmlns:a="http://schemas.openxmlformats.org/drawingml/2006/main">
          <a:pPr algn="r"/>
          <a:endParaRPr lang="en-US" sz="700" dirty="0">
            <a:solidFill>
              <a:srgbClr val="0673C4"/>
            </a:solidFill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52745</cdr:x>
      <cdr:y>0.05411</cdr:y>
    </cdr:from>
    <cdr:to>
      <cdr:x>0.89737</cdr:x>
      <cdr:y>0.53096</cdr:y>
    </cdr:to>
    <cdr:sp macro="" textlink="">
      <cdr:nvSpPr>
        <cdr:cNvPr id="2" name="TextBox 6">
          <a:extLst xmlns:a="http://schemas.openxmlformats.org/drawingml/2006/main">
            <a:ext uri="{FF2B5EF4-FFF2-40B4-BE49-F238E27FC236}">
              <a16:creationId xmlns:a16="http://schemas.microsoft.com/office/drawing/2014/main" id="{9D735A4A-7D6A-FBC5-8683-BDE38D5CE844}"/>
            </a:ext>
          </a:extLst>
        </cdr:cNvPr>
        <cdr:cNvSpPr txBox="1"/>
      </cdr:nvSpPr>
      <cdr:spPr>
        <a:xfrm xmlns:a="http://schemas.openxmlformats.org/drawingml/2006/main">
          <a:off x="1642946" y="103941"/>
          <a:ext cx="1152293" cy="915964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n-US" sz="800" dirty="0">
              <a:solidFill>
                <a:srgbClr val="0673C4"/>
              </a:solidFill>
              <a:latin typeface="Arial" panose="020B0604020202020204" pitchFamily="34" charset="0"/>
              <a:cs typeface="Arial" panose="020B0604020202020204" pitchFamily="34" charset="0"/>
            </a:rPr>
            <a:t>Control</a:t>
          </a:r>
        </a:p>
        <a:p xmlns:a="http://schemas.openxmlformats.org/drawingml/2006/main">
          <a:pPr algn="r"/>
          <a:r>
            <a:rPr lang="en-US" sz="800" dirty="0">
              <a:solidFill>
                <a:srgbClr val="25B160"/>
              </a:solidFill>
              <a:latin typeface="Arial" panose="020B0604020202020204" pitchFamily="34" charset="0"/>
              <a:cs typeface="Arial" panose="020B0604020202020204" pitchFamily="34" charset="0"/>
            </a:rPr>
            <a:t>MR</a:t>
          </a:r>
        </a:p>
        <a:p xmlns:a="http://schemas.openxmlformats.org/drawingml/2006/main">
          <a:pPr algn="r"/>
          <a:r>
            <a:rPr lang="en-US" sz="800" dirty="0">
              <a:solidFill>
                <a:srgbClr val="F6D256"/>
              </a:solidFill>
              <a:latin typeface="Arial" panose="020B0604020202020204" pitchFamily="34" charset="0"/>
              <a:cs typeface="Arial" panose="020B0604020202020204" pitchFamily="34" charset="0"/>
            </a:rPr>
            <a:t>Control</a:t>
          </a:r>
          <a:r>
            <a:rPr lang="en-US" sz="800" baseline="0" dirty="0">
              <a:solidFill>
                <a:srgbClr val="F6D256"/>
              </a:solidFill>
              <a:latin typeface="Arial" panose="020B0604020202020204" pitchFamily="34" charset="0"/>
              <a:cs typeface="Arial" panose="020B0604020202020204" pitchFamily="34" charset="0"/>
            </a:rPr>
            <a:t> + met D0</a:t>
          </a:r>
          <a:endParaRPr lang="en-US" sz="800" dirty="0">
            <a:solidFill>
              <a:srgbClr val="F6D256"/>
            </a:solidFill>
            <a:latin typeface="Arial" panose="020B0604020202020204" pitchFamily="34" charset="0"/>
            <a:cs typeface="Arial" panose="020B0604020202020204" pitchFamily="34" charset="0"/>
          </a:endParaRPr>
        </a:p>
        <a:p xmlns:a="http://schemas.openxmlformats.org/drawingml/2006/main">
          <a:pPr algn="r"/>
          <a:r>
            <a:rPr lang="en-US" sz="800" dirty="0">
              <a:solidFill>
                <a:srgbClr val="F64F00"/>
              </a:solidFill>
              <a:latin typeface="Arial" panose="020B0604020202020204" pitchFamily="34" charset="0"/>
              <a:cs typeface="Arial" panose="020B0604020202020204" pitchFamily="34" charset="0"/>
            </a:rPr>
            <a:t>MR + met D0</a:t>
          </a:r>
        </a:p>
        <a:p xmlns:a="http://schemas.openxmlformats.org/drawingml/2006/main">
          <a:pPr algn="r"/>
          <a:r>
            <a:rPr lang="en-US" sz="800" dirty="0">
              <a:solidFill>
                <a:srgbClr val="F736E4"/>
              </a:solidFill>
              <a:latin typeface="Arial" panose="020B0604020202020204" pitchFamily="34" charset="0"/>
              <a:cs typeface="Arial" panose="020B0604020202020204" pitchFamily="34" charset="0"/>
            </a:rPr>
            <a:t>Control</a:t>
          </a:r>
          <a:r>
            <a:rPr lang="en-US" sz="800" baseline="0" dirty="0">
              <a:solidFill>
                <a:srgbClr val="F736E4"/>
              </a:solidFill>
              <a:latin typeface="Arial" panose="020B0604020202020204" pitchFamily="34" charset="0"/>
              <a:cs typeface="Arial" panose="020B0604020202020204" pitchFamily="34" charset="0"/>
            </a:rPr>
            <a:t> + met D4</a:t>
          </a:r>
        </a:p>
        <a:p xmlns:a="http://schemas.openxmlformats.org/drawingml/2006/main">
          <a:pPr algn="r"/>
          <a:r>
            <a:rPr lang="en-US" sz="800" baseline="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MR + D4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B09CD20-5008-6745-B100-F298E90EFC52}" type="datetimeFigureOut">
              <a:rPr lang="en-US" smtClean="0"/>
              <a:t>4/2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C07C87-F5F9-054E-A1A5-8A6C6054C6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9590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55422" rtl="0" eaLnBrk="1" latinLnBrk="0" hangingPunct="1">
      <a:defRPr sz="1122" kern="1200">
        <a:solidFill>
          <a:schemeClr val="tx1"/>
        </a:solidFill>
        <a:latin typeface="+mn-lt"/>
        <a:ea typeface="+mn-ea"/>
        <a:cs typeface="+mn-cs"/>
      </a:defRPr>
    </a:lvl1pPr>
    <a:lvl2pPr marL="427712" algn="l" defTabSz="855422" rtl="0" eaLnBrk="1" latinLnBrk="0" hangingPunct="1">
      <a:defRPr sz="1122" kern="1200">
        <a:solidFill>
          <a:schemeClr val="tx1"/>
        </a:solidFill>
        <a:latin typeface="+mn-lt"/>
        <a:ea typeface="+mn-ea"/>
        <a:cs typeface="+mn-cs"/>
      </a:defRPr>
    </a:lvl2pPr>
    <a:lvl3pPr marL="855422" algn="l" defTabSz="855422" rtl="0" eaLnBrk="1" latinLnBrk="0" hangingPunct="1">
      <a:defRPr sz="1122" kern="1200">
        <a:solidFill>
          <a:schemeClr val="tx1"/>
        </a:solidFill>
        <a:latin typeface="+mn-lt"/>
        <a:ea typeface="+mn-ea"/>
        <a:cs typeface="+mn-cs"/>
      </a:defRPr>
    </a:lvl3pPr>
    <a:lvl4pPr marL="1283134" algn="l" defTabSz="855422" rtl="0" eaLnBrk="1" latinLnBrk="0" hangingPunct="1">
      <a:defRPr sz="1122" kern="1200">
        <a:solidFill>
          <a:schemeClr val="tx1"/>
        </a:solidFill>
        <a:latin typeface="+mn-lt"/>
        <a:ea typeface="+mn-ea"/>
        <a:cs typeface="+mn-cs"/>
      </a:defRPr>
    </a:lvl4pPr>
    <a:lvl5pPr marL="1710846" algn="l" defTabSz="855422" rtl="0" eaLnBrk="1" latinLnBrk="0" hangingPunct="1">
      <a:defRPr sz="1122" kern="1200">
        <a:solidFill>
          <a:schemeClr val="tx1"/>
        </a:solidFill>
        <a:latin typeface="+mn-lt"/>
        <a:ea typeface="+mn-ea"/>
        <a:cs typeface="+mn-cs"/>
      </a:defRPr>
    </a:lvl5pPr>
    <a:lvl6pPr marL="2138557" algn="l" defTabSz="855422" rtl="0" eaLnBrk="1" latinLnBrk="0" hangingPunct="1">
      <a:defRPr sz="1122" kern="1200">
        <a:solidFill>
          <a:schemeClr val="tx1"/>
        </a:solidFill>
        <a:latin typeface="+mn-lt"/>
        <a:ea typeface="+mn-ea"/>
        <a:cs typeface="+mn-cs"/>
      </a:defRPr>
    </a:lvl6pPr>
    <a:lvl7pPr marL="2566268" algn="l" defTabSz="855422" rtl="0" eaLnBrk="1" latinLnBrk="0" hangingPunct="1">
      <a:defRPr sz="1122" kern="1200">
        <a:solidFill>
          <a:schemeClr val="tx1"/>
        </a:solidFill>
        <a:latin typeface="+mn-lt"/>
        <a:ea typeface="+mn-ea"/>
        <a:cs typeface="+mn-cs"/>
      </a:defRPr>
    </a:lvl7pPr>
    <a:lvl8pPr marL="2993981" algn="l" defTabSz="855422" rtl="0" eaLnBrk="1" latinLnBrk="0" hangingPunct="1">
      <a:defRPr sz="1122" kern="1200">
        <a:solidFill>
          <a:schemeClr val="tx1"/>
        </a:solidFill>
        <a:latin typeface="+mn-lt"/>
        <a:ea typeface="+mn-ea"/>
        <a:cs typeface="+mn-cs"/>
      </a:defRPr>
    </a:lvl8pPr>
    <a:lvl9pPr marL="3421691" algn="l" defTabSz="855422" rtl="0" eaLnBrk="1" latinLnBrk="0" hangingPunct="1">
      <a:defRPr sz="112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F902885-8993-5C24-8789-D0265D37C14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30460E4F-32B1-F3A9-FF8B-A61D129B8C73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69FBAA26-63F5-8045-B8F3-45299872F54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AEEEBFF-E0F0-70A1-43CB-6FAE542F8FB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2C07C87-F5F9-054E-A1A5-8A6C6054C60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320058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2C07C87-F5F9-054E-A1A5-8A6C6054C60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56019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2C07C87-F5F9-054E-A1A5-8A6C6054C60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06974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indent="-228600">
              <a:buAutoNum type="alphaUcParenBoth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2C07C87-F5F9-054E-A1A5-8A6C6054C60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509549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894598E-D5F2-43C7-E953-D8A3E28CEC8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004CD435-A883-C546-EA63-7999BE854302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7492F8EA-1905-0408-6764-83766CC332FB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 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3AD8F21-33FB-702E-0070-FD242FE2CD63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2C07C87-F5F9-054E-A1A5-8A6C6054C60C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23609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E5BB4A1-3B7B-DA3F-6BB3-3B4C7C18C02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1E2F2C38-A812-4525-C3CC-5089083C3FA4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22D4CE48-D955-3210-742B-A8DBA0108A0B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855422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615914-82E5-1B3C-7030-25165E1E17A2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2C07C87-F5F9-054E-A1A5-8A6C6054C60C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4210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E5ADE-1F30-8C4E-8CA5-785611CC4B15}" type="datetimeFigureOut">
              <a:rPr lang="en-US" smtClean="0"/>
              <a:t>4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13D69-528B-4242-8F41-BA5E83B2FF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5601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E5ADE-1F30-8C4E-8CA5-785611CC4B15}" type="datetimeFigureOut">
              <a:rPr lang="en-US" smtClean="0"/>
              <a:t>4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13D69-528B-4242-8F41-BA5E83B2FF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3518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E5ADE-1F30-8C4E-8CA5-785611CC4B15}" type="datetimeFigureOut">
              <a:rPr lang="en-US" smtClean="0"/>
              <a:t>4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13D69-528B-4242-8F41-BA5E83B2FF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8413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E5ADE-1F30-8C4E-8CA5-785611CC4B15}" type="datetimeFigureOut">
              <a:rPr lang="en-US" smtClean="0"/>
              <a:t>4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13D69-528B-4242-8F41-BA5E83B2FF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063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E5ADE-1F30-8C4E-8CA5-785611CC4B15}" type="datetimeFigureOut">
              <a:rPr lang="en-US" smtClean="0"/>
              <a:t>4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13D69-528B-4242-8F41-BA5E83B2FF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4193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E5ADE-1F30-8C4E-8CA5-785611CC4B15}" type="datetimeFigureOut">
              <a:rPr lang="en-US" smtClean="0"/>
              <a:t>4/2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13D69-528B-4242-8F41-BA5E83B2FF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9327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E5ADE-1F30-8C4E-8CA5-785611CC4B15}" type="datetimeFigureOut">
              <a:rPr lang="en-US" smtClean="0"/>
              <a:t>4/2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13D69-528B-4242-8F41-BA5E83B2FF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5487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E5ADE-1F30-8C4E-8CA5-785611CC4B15}" type="datetimeFigureOut">
              <a:rPr lang="en-US" smtClean="0"/>
              <a:t>4/2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13D69-528B-4242-8F41-BA5E83B2FF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3186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E5ADE-1F30-8C4E-8CA5-785611CC4B15}" type="datetimeFigureOut">
              <a:rPr lang="en-US" smtClean="0"/>
              <a:t>4/2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13D69-528B-4242-8F41-BA5E83B2FF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1448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E5ADE-1F30-8C4E-8CA5-785611CC4B15}" type="datetimeFigureOut">
              <a:rPr lang="en-US" smtClean="0"/>
              <a:t>4/2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13D69-528B-4242-8F41-BA5E83B2FF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718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E5ADE-1F30-8C4E-8CA5-785611CC4B15}" type="datetimeFigureOut">
              <a:rPr lang="en-US" smtClean="0"/>
              <a:t>4/2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13D69-528B-4242-8F41-BA5E83B2FF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7358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6E5ADE-1F30-8C4E-8CA5-785611CC4B15}" type="datetimeFigureOut">
              <a:rPr lang="en-US" smtClean="0"/>
              <a:t>4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913D69-528B-4242-8F41-BA5E83B2FF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52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em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emf"/><Relationship Id="rId4" Type="http://schemas.openxmlformats.org/officeDocument/2006/relationships/image" Target="../media/image2.emf"/><Relationship Id="rId9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3.png"/><Relationship Id="rId4" Type="http://schemas.openxmlformats.org/officeDocument/2006/relationships/chart" Target="../charts/chart5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jpg"/><Relationship Id="rId3" Type="http://schemas.openxmlformats.org/officeDocument/2006/relationships/chart" Target="../charts/chart6.xml"/><Relationship Id="rId7" Type="http://schemas.openxmlformats.org/officeDocument/2006/relationships/image" Target="../media/image16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chart" Target="../charts/char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chart" Target="../charts/chart8.xml"/><Relationship Id="rId7" Type="http://schemas.openxmlformats.org/officeDocument/2006/relationships/image" Target="../media/image21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Relationship Id="rId9" Type="http://schemas.openxmlformats.org/officeDocument/2006/relationships/image" Target="../media/image2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6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E880072-BE8C-06AE-ECA9-3D5E2EA982E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B368DDE5-12CD-6C40-44FD-2FB051E5E3CC}"/>
              </a:ext>
            </a:extLst>
          </p:cNvPr>
          <p:cNvSpPr txBox="1"/>
          <p:nvPr/>
        </p:nvSpPr>
        <p:spPr>
          <a:xfrm>
            <a:off x="0" y="0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</a:p>
        </p:txBody>
      </p:sp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0F343022-2480-24B1-FEB1-45C2CE78A8A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95217438"/>
              </p:ext>
            </p:extLst>
          </p:nvPr>
        </p:nvGraphicFramePr>
        <p:xfrm>
          <a:off x="2457650" y="2774069"/>
          <a:ext cx="2857100" cy="19088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2EA8A75F-2AAE-3A65-911E-BF4AB6EF0FE7}"/>
              </a:ext>
            </a:extLst>
          </p:cNvPr>
          <p:cNvSpPr txBox="1"/>
          <p:nvPr/>
        </p:nvSpPr>
        <p:spPr>
          <a:xfrm flipH="1">
            <a:off x="2432791" y="2429552"/>
            <a:ext cx="5915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</a:p>
        </p:txBody>
      </p:sp>
      <p:graphicFrame>
        <p:nvGraphicFramePr>
          <p:cNvPr id="20" name="Chart 19">
            <a:extLst>
              <a:ext uri="{FF2B5EF4-FFF2-40B4-BE49-F238E27FC236}">
                <a16:creationId xmlns:a16="http://schemas.microsoft.com/office/drawing/2014/main" id="{043645BB-B087-801D-121B-44851A0C975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98866263"/>
              </p:ext>
            </p:extLst>
          </p:nvPr>
        </p:nvGraphicFramePr>
        <p:xfrm>
          <a:off x="2449179" y="5213555"/>
          <a:ext cx="2874042" cy="19088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0907D64E-13EA-DAB1-3176-D87DB6F4F09F}"/>
              </a:ext>
            </a:extLst>
          </p:cNvPr>
          <p:cNvSpPr txBox="1"/>
          <p:nvPr/>
        </p:nvSpPr>
        <p:spPr>
          <a:xfrm flipH="1">
            <a:off x="2432791" y="4821406"/>
            <a:ext cx="5915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</a:p>
        </p:txBody>
      </p:sp>
    </p:spTree>
    <p:extLst>
      <p:ext uri="{BB962C8B-B14F-4D97-AF65-F5344CB8AC3E}">
        <p14:creationId xmlns:p14="http://schemas.microsoft.com/office/powerpoint/2010/main" val="37496697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B83651F-0CC1-9029-8104-9C427BAAC5C9}"/>
              </a:ext>
            </a:extLst>
          </p:cNvPr>
          <p:cNvSpPr txBox="1"/>
          <p:nvPr/>
        </p:nvSpPr>
        <p:spPr>
          <a:xfrm>
            <a:off x="0" y="0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2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50D2761-80E3-1196-A50E-67F6E07C8918}"/>
              </a:ext>
            </a:extLst>
          </p:cNvPr>
          <p:cNvSpPr txBox="1"/>
          <p:nvPr/>
        </p:nvSpPr>
        <p:spPr>
          <a:xfrm rot="16200000">
            <a:off x="2739525" y="4494562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709383A-2D1F-A2C3-3444-2442EBB35855}"/>
              </a:ext>
            </a:extLst>
          </p:cNvPr>
          <p:cNvSpPr txBox="1"/>
          <p:nvPr/>
        </p:nvSpPr>
        <p:spPr>
          <a:xfrm rot="16200000">
            <a:off x="3476222" y="4494562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F94F37D-FA8F-1A01-49B4-F5DAA97AE876}"/>
              </a:ext>
            </a:extLst>
          </p:cNvPr>
          <p:cNvSpPr txBox="1"/>
          <p:nvPr/>
        </p:nvSpPr>
        <p:spPr>
          <a:xfrm rot="16200000">
            <a:off x="4212631" y="4494562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82CD11A-69BD-7982-73FE-19E5A32D4A3B}"/>
              </a:ext>
            </a:extLst>
          </p:cNvPr>
          <p:cNvSpPr txBox="1"/>
          <p:nvPr/>
        </p:nvSpPr>
        <p:spPr>
          <a:xfrm rot="16200000">
            <a:off x="3096197" y="4600360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R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9811DA2-DCD1-764A-1645-AC873DAA5C36}"/>
              </a:ext>
            </a:extLst>
          </p:cNvPr>
          <p:cNvSpPr txBox="1"/>
          <p:nvPr/>
        </p:nvSpPr>
        <p:spPr>
          <a:xfrm rot="16200000">
            <a:off x="3823085" y="4600360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R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509ADBF-C385-9E8D-EC31-A1B462834E1E}"/>
              </a:ext>
            </a:extLst>
          </p:cNvPr>
          <p:cNvSpPr txBox="1"/>
          <p:nvPr/>
        </p:nvSpPr>
        <p:spPr>
          <a:xfrm rot="16200000">
            <a:off x="3270125" y="4533836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rph1∆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AAD7049-9B9D-D73E-27FB-586311E5AF51}"/>
              </a:ext>
            </a:extLst>
          </p:cNvPr>
          <p:cNvSpPr txBox="1"/>
          <p:nvPr/>
        </p:nvSpPr>
        <p:spPr>
          <a:xfrm rot="16200000">
            <a:off x="4010660" y="4533836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rph1∆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2BA31B9-20C9-25CD-13D9-86E6C46BBD65}"/>
              </a:ext>
            </a:extLst>
          </p:cNvPr>
          <p:cNvSpPr txBox="1"/>
          <p:nvPr/>
        </p:nvSpPr>
        <p:spPr>
          <a:xfrm rot="16200000">
            <a:off x="4713065" y="4533836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rph1∆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721B057-586F-75A2-D0AF-BA815B2653E0}"/>
              </a:ext>
            </a:extLst>
          </p:cNvPr>
          <p:cNvSpPr txBox="1"/>
          <p:nvPr/>
        </p:nvSpPr>
        <p:spPr>
          <a:xfrm>
            <a:off x="3050879" y="4082496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y 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AAB883F-CB40-6848-599B-35FDEDCD9527}"/>
              </a:ext>
            </a:extLst>
          </p:cNvPr>
          <p:cNvSpPr txBox="1"/>
          <p:nvPr/>
        </p:nvSpPr>
        <p:spPr>
          <a:xfrm>
            <a:off x="3802428" y="4069735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y 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1FD9492-1DEC-BB3F-4933-B1508809B9B3}"/>
              </a:ext>
            </a:extLst>
          </p:cNvPr>
          <p:cNvSpPr txBox="1"/>
          <p:nvPr/>
        </p:nvSpPr>
        <p:spPr>
          <a:xfrm>
            <a:off x="4511693" y="4073037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y 6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19D7229B-86C2-0F3B-80D5-4FB7B81DF1E9}"/>
              </a:ext>
            </a:extLst>
          </p:cNvPr>
          <p:cNvCxnSpPr>
            <a:cxnSpLocks/>
          </p:cNvCxnSpPr>
          <p:nvPr/>
        </p:nvCxnSpPr>
        <p:spPr>
          <a:xfrm>
            <a:off x="2992237" y="4329252"/>
            <a:ext cx="61742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FC3C43D9-39BC-1429-A72C-2F58C08E4AAB}"/>
              </a:ext>
            </a:extLst>
          </p:cNvPr>
          <p:cNvCxnSpPr>
            <a:cxnSpLocks/>
          </p:cNvCxnSpPr>
          <p:nvPr/>
        </p:nvCxnSpPr>
        <p:spPr>
          <a:xfrm>
            <a:off x="3695932" y="4329252"/>
            <a:ext cx="62332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551CF053-7933-E4B4-36CD-C0199261378F}"/>
              </a:ext>
            </a:extLst>
          </p:cNvPr>
          <p:cNvCxnSpPr>
            <a:cxnSpLocks/>
          </p:cNvCxnSpPr>
          <p:nvPr/>
        </p:nvCxnSpPr>
        <p:spPr>
          <a:xfrm>
            <a:off x="4423958" y="4329252"/>
            <a:ext cx="62332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608F4CFD-5A90-543B-842E-A3F9876A963A}"/>
              </a:ext>
            </a:extLst>
          </p:cNvPr>
          <p:cNvSpPr txBox="1"/>
          <p:nvPr/>
        </p:nvSpPr>
        <p:spPr>
          <a:xfrm>
            <a:off x="2149567" y="4951823"/>
            <a:ext cx="8226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3K36me3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33AD17D-9171-3EB2-AD94-091416659E30}"/>
              </a:ext>
            </a:extLst>
          </p:cNvPr>
          <p:cNvSpPr txBox="1"/>
          <p:nvPr/>
        </p:nvSpPr>
        <p:spPr>
          <a:xfrm>
            <a:off x="2332309" y="5320541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5691502-11DA-6B8A-B49B-FADB8E1A6611}"/>
              </a:ext>
            </a:extLst>
          </p:cNvPr>
          <p:cNvSpPr txBox="1"/>
          <p:nvPr/>
        </p:nvSpPr>
        <p:spPr>
          <a:xfrm>
            <a:off x="2347805" y="6281675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E5E94BF-5152-14B2-B38F-38D365D7B316}"/>
              </a:ext>
            </a:extLst>
          </p:cNvPr>
          <p:cNvSpPr txBox="1"/>
          <p:nvPr/>
        </p:nvSpPr>
        <p:spPr>
          <a:xfrm>
            <a:off x="2627443" y="5900359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CDE3870-CE5B-C711-EFB9-E8B114F05146}"/>
              </a:ext>
            </a:extLst>
          </p:cNvPr>
          <p:cNvSpPr txBox="1"/>
          <p:nvPr/>
        </p:nvSpPr>
        <p:spPr>
          <a:xfrm>
            <a:off x="848233" y="4081184"/>
            <a:ext cx="21329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ime into chronological lifespan: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C7A3E03-942D-7E72-7712-2CB2990C96A9}"/>
              </a:ext>
            </a:extLst>
          </p:cNvPr>
          <p:cNvSpPr txBox="1"/>
          <p:nvPr/>
        </p:nvSpPr>
        <p:spPr>
          <a:xfrm rot="16200000">
            <a:off x="4573927" y="4600360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R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75825B2-C33B-58EF-105A-8C5AABEABD70}"/>
              </a:ext>
            </a:extLst>
          </p:cNvPr>
          <p:cNvSpPr txBox="1"/>
          <p:nvPr/>
        </p:nvSpPr>
        <p:spPr>
          <a:xfrm flipH="1">
            <a:off x="90799" y="767035"/>
            <a:ext cx="5915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378F74F-8FDA-5115-6F02-EC3C6CB86E7A}"/>
              </a:ext>
            </a:extLst>
          </p:cNvPr>
          <p:cNvSpPr txBox="1"/>
          <p:nvPr/>
        </p:nvSpPr>
        <p:spPr>
          <a:xfrm flipH="1">
            <a:off x="220568" y="3702609"/>
            <a:ext cx="5915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F520219E-322D-0390-CF8C-99D247D3775E}"/>
              </a:ext>
            </a:extLst>
          </p:cNvPr>
          <p:cNvGrpSpPr/>
          <p:nvPr/>
        </p:nvGrpSpPr>
        <p:grpSpPr>
          <a:xfrm>
            <a:off x="468948" y="825901"/>
            <a:ext cx="7200124" cy="1961519"/>
            <a:chOff x="468948" y="825901"/>
            <a:chExt cx="7200124" cy="1961519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1F56ACA9-4B68-E283-F971-EF9E5BBF3E5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68948" y="1152593"/>
              <a:ext cx="2316586" cy="162304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48CCF894-9FB9-0317-C1AE-8E8A84147E0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915534" y="1157801"/>
              <a:ext cx="2273300" cy="1612623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162128A5-0247-B662-E65A-1E377BE223A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318834" y="1140803"/>
              <a:ext cx="2350238" cy="1646617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9A26EC7-FCA9-D910-FDF7-EAA25B5BB786}"/>
                </a:ext>
              </a:extLst>
            </p:cNvPr>
            <p:cNvSpPr txBox="1"/>
            <p:nvPr/>
          </p:nvSpPr>
          <p:spPr>
            <a:xfrm>
              <a:off x="1114443" y="825902"/>
              <a:ext cx="5741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3K36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6A743F78-0BA5-4500-DF7B-12D6641E61DB}"/>
                </a:ext>
              </a:extLst>
            </p:cNvPr>
            <p:cNvSpPr txBox="1"/>
            <p:nvPr/>
          </p:nvSpPr>
          <p:spPr>
            <a:xfrm>
              <a:off x="3599102" y="825902"/>
              <a:ext cx="5036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3K4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8EF52FFE-317E-F3E6-122B-6F414C48A31D}"/>
                </a:ext>
              </a:extLst>
            </p:cNvPr>
            <p:cNvSpPr txBox="1"/>
            <p:nvPr/>
          </p:nvSpPr>
          <p:spPr>
            <a:xfrm>
              <a:off x="6058381" y="825901"/>
              <a:ext cx="5741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3K79</a:t>
              </a:r>
            </a:p>
          </p:txBody>
        </p:sp>
      </p:grpSp>
      <p:pic>
        <p:nvPicPr>
          <p:cNvPr id="43" name="Picture 42">
            <a:extLst>
              <a:ext uri="{FF2B5EF4-FFF2-40B4-BE49-F238E27FC236}">
                <a16:creationId xmlns:a16="http://schemas.microsoft.com/office/drawing/2014/main" id="{F812D8FD-C934-4D6E-8D1C-233529CC71F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12571" y="4882739"/>
            <a:ext cx="2266950" cy="33482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04AA492D-C5F6-5ABF-5991-F197EE44687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921884" y="5865847"/>
            <a:ext cx="2266950" cy="33509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7C5668AC-65B1-961A-7066-BEE07626C7B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917940" y="5320541"/>
            <a:ext cx="2266950" cy="33482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F121F1F9-ACAC-72BE-0DFF-63B0D1E08A0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921884" y="6279410"/>
            <a:ext cx="2266950" cy="33509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6318004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-up of a test&#10;&#10;Description automatically generated">
            <a:extLst>
              <a:ext uri="{FF2B5EF4-FFF2-40B4-BE49-F238E27FC236}">
                <a16:creationId xmlns:a16="http://schemas.microsoft.com/office/drawing/2014/main" id="{C5E71BBD-8A41-0BE6-8583-7895189E33F0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6324" t="67564" r="37887" b="20002"/>
          <a:stretch/>
        </p:blipFill>
        <p:spPr>
          <a:xfrm>
            <a:off x="2583063" y="8078411"/>
            <a:ext cx="2514598" cy="91439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 descr="A close up of a test&#10;&#10;Description automatically generated">
            <a:extLst>
              <a:ext uri="{FF2B5EF4-FFF2-40B4-BE49-F238E27FC236}">
                <a16:creationId xmlns:a16="http://schemas.microsoft.com/office/drawing/2014/main" id="{CC9309F7-1829-3FC9-5670-AF7AEAE8900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37027" t="46114" r="36480" b="46892"/>
          <a:stretch/>
        </p:blipFill>
        <p:spPr>
          <a:xfrm>
            <a:off x="2583063" y="9064244"/>
            <a:ext cx="2514598" cy="50069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F58A93B-439E-0E93-B704-E7B5EC222AC5}"/>
              </a:ext>
            </a:extLst>
          </p:cNvPr>
          <p:cNvSpPr txBox="1"/>
          <p:nvPr/>
        </p:nvSpPr>
        <p:spPr>
          <a:xfrm rot="16200000">
            <a:off x="2434782" y="7470494"/>
            <a:ext cx="9333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2EF6C4C-2E4A-737E-85C9-65913AF8E07A}"/>
              </a:ext>
            </a:extLst>
          </p:cNvPr>
          <p:cNvSpPr txBox="1"/>
          <p:nvPr/>
        </p:nvSpPr>
        <p:spPr>
          <a:xfrm rot="16200000">
            <a:off x="3202108" y="7665290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R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1924B90-D8E0-2611-09F8-F1E4709551D2}"/>
              </a:ext>
            </a:extLst>
          </p:cNvPr>
          <p:cNvSpPr txBox="1"/>
          <p:nvPr/>
        </p:nvSpPr>
        <p:spPr>
          <a:xfrm rot="16200000">
            <a:off x="3079899" y="6992029"/>
            <a:ext cx="18902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rapamyc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60006AF-E651-3FC8-449D-BA57E99D6798}"/>
              </a:ext>
            </a:extLst>
          </p:cNvPr>
          <p:cNvSpPr txBox="1"/>
          <p:nvPr/>
        </p:nvSpPr>
        <p:spPr>
          <a:xfrm rot="16200000">
            <a:off x="3506820" y="6895849"/>
            <a:ext cx="20826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00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rapamycin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6A7CA88-925B-7A15-8C5A-B777631200BE}"/>
              </a:ext>
            </a:extLst>
          </p:cNvPr>
          <p:cNvSpPr txBox="1"/>
          <p:nvPr/>
        </p:nvSpPr>
        <p:spPr>
          <a:xfrm>
            <a:off x="5167077" y="8359269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tg13-H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F9E6EC7-D96B-DDE9-BFE4-000C69830281}"/>
              </a:ext>
            </a:extLst>
          </p:cNvPr>
          <p:cNvSpPr txBox="1"/>
          <p:nvPr/>
        </p:nvSpPr>
        <p:spPr>
          <a:xfrm>
            <a:off x="5167077" y="9075126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6PDH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05B257E-CA45-4136-56D0-5F7F1767C559}"/>
              </a:ext>
            </a:extLst>
          </p:cNvPr>
          <p:cNvSpPr txBox="1"/>
          <p:nvPr/>
        </p:nvSpPr>
        <p:spPr>
          <a:xfrm>
            <a:off x="2189176" y="5575988"/>
            <a:ext cx="1351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u="sng" dirty="0"/>
              <a:t>Log Phase: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59AD383-4AD3-81C6-9A24-10BCCE6060AA}"/>
              </a:ext>
            </a:extLst>
          </p:cNvPr>
          <p:cNvSpPr txBox="1"/>
          <p:nvPr/>
        </p:nvSpPr>
        <p:spPr>
          <a:xfrm>
            <a:off x="0" y="0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3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0D12AEE-4BEE-917B-ED4C-E2D1EBCF9E18}"/>
              </a:ext>
            </a:extLst>
          </p:cNvPr>
          <p:cNvSpPr txBox="1"/>
          <p:nvPr/>
        </p:nvSpPr>
        <p:spPr>
          <a:xfrm flipH="1">
            <a:off x="521452" y="4703904"/>
            <a:ext cx="5915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E64BDCB-1AA0-1822-68FC-E9C40A80BF03}"/>
              </a:ext>
            </a:extLst>
          </p:cNvPr>
          <p:cNvSpPr txBox="1"/>
          <p:nvPr/>
        </p:nvSpPr>
        <p:spPr>
          <a:xfrm flipH="1">
            <a:off x="521452" y="407901"/>
            <a:ext cx="5915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4" name="Picture 13" descr="A blurry image of a person's face&#10;&#10;AI-generated content may be incorrect.">
            <a:extLst>
              <a:ext uri="{FF2B5EF4-FFF2-40B4-BE49-F238E27FC236}">
                <a16:creationId xmlns:a16="http://schemas.microsoft.com/office/drawing/2014/main" id="{8EB6B290-D3DB-8D87-381E-45EECEBF4D32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7935" r="17484"/>
          <a:stretch>
            <a:fillRect/>
          </a:stretch>
        </p:blipFill>
        <p:spPr>
          <a:xfrm>
            <a:off x="2148142" y="3280863"/>
            <a:ext cx="2967320" cy="105604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9466F422-6032-AC01-9B5F-AFF126270DEB}"/>
              </a:ext>
            </a:extLst>
          </p:cNvPr>
          <p:cNvCxnSpPr>
            <a:cxnSpLocks/>
          </p:cNvCxnSpPr>
          <p:nvPr/>
        </p:nvCxnSpPr>
        <p:spPr>
          <a:xfrm>
            <a:off x="5148463" y="4212121"/>
            <a:ext cx="19277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2756FB95-5DE9-D4A9-A489-26DC00C931B6}"/>
              </a:ext>
            </a:extLst>
          </p:cNvPr>
          <p:cNvSpPr txBox="1"/>
          <p:nvPr/>
        </p:nvSpPr>
        <p:spPr>
          <a:xfrm>
            <a:off x="5341238" y="4006950"/>
            <a:ext cx="256479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free-GFP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F00D743-F6CD-1C04-97B5-ECF83ABDECA2}"/>
              </a:ext>
            </a:extLst>
          </p:cNvPr>
          <p:cNvSpPr txBox="1"/>
          <p:nvPr/>
        </p:nvSpPr>
        <p:spPr>
          <a:xfrm rot="16200000">
            <a:off x="1152382" y="1811560"/>
            <a:ext cx="262265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Day 0, 1 nM rapaymcin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C98AC25-C55A-DA5A-63B8-5D2F1639378E}"/>
              </a:ext>
            </a:extLst>
          </p:cNvPr>
          <p:cNvSpPr txBox="1"/>
          <p:nvPr/>
        </p:nvSpPr>
        <p:spPr>
          <a:xfrm rot="16200000">
            <a:off x="1189409" y="1068277"/>
            <a:ext cx="4109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Day 0, 200 nM rapamycin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3B692A5-84A5-0B88-7641-C98E1A14A640}"/>
              </a:ext>
            </a:extLst>
          </p:cNvPr>
          <p:cNvSpPr txBox="1"/>
          <p:nvPr/>
        </p:nvSpPr>
        <p:spPr>
          <a:xfrm rot="16200000">
            <a:off x="3201952" y="2296791"/>
            <a:ext cx="165219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Day 7 Control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BFF8E9D-266F-4C45-E57F-0FCFEBCE994B}"/>
              </a:ext>
            </a:extLst>
          </p:cNvPr>
          <p:cNvSpPr txBox="1"/>
          <p:nvPr/>
        </p:nvSpPr>
        <p:spPr>
          <a:xfrm rot="16200000">
            <a:off x="4001677" y="2320843"/>
            <a:ext cx="160408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Day 7 MR</a:t>
            </a:r>
          </a:p>
        </p:txBody>
      </p:sp>
      <p:pic>
        <p:nvPicPr>
          <p:cNvPr id="27" name="Picture 26" descr="A blurry image of a white object&#10;&#10;AI-generated content may be incorrect.">
            <a:extLst>
              <a:ext uri="{FF2B5EF4-FFF2-40B4-BE49-F238E27FC236}">
                <a16:creationId xmlns:a16="http://schemas.microsoft.com/office/drawing/2014/main" id="{5DFE3638-3209-358D-E846-5B87D4F74AB9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20635" t="25418" r="17961"/>
          <a:stretch>
            <a:fillRect/>
          </a:stretch>
        </p:blipFill>
        <p:spPr>
          <a:xfrm>
            <a:off x="2148142" y="4401682"/>
            <a:ext cx="2967319" cy="59394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09AFF052-9884-FBFA-7C67-2BE519905821}"/>
              </a:ext>
            </a:extLst>
          </p:cNvPr>
          <p:cNvSpPr txBox="1"/>
          <p:nvPr/>
        </p:nvSpPr>
        <p:spPr>
          <a:xfrm>
            <a:off x="5278485" y="3345970"/>
            <a:ext cx="256479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GFP-atg8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20CACBF-1A20-C2E3-F3CB-6389E10276E5}"/>
              </a:ext>
            </a:extLst>
          </p:cNvPr>
          <p:cNvSpPr txBox="1"/>
          <p:nvPr/>
        </p:nvSpPr>
        <p:spPr>
          <a:xfrm>
            <a:off x="5115461" y="4647184"/>
            <a:ext cx="256479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G6PDH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35B4444C-C330-AF30-B1E5-DB4EFC5119D1}"/>
              </a:ext>
            </a:extLst>
          </p:cNvPr>
          <p:cNvCxnSpPr>
            <a:cxnSpLocks/>
          </p:cNvCxnSpPr>
          <p:nvPr/>
        </p:nvCxnSpPr>
        <p:spPr>
          <a:xfrm>
            <a:off x="5148458" y="3539765"/>
            <a:ext cx="19277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933412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ADB8DD18-5C1E-BD04-D389-FED89FADF482}"/>
              </a:ext>
            </a:extLst>
          </p:cNvPr>
          <p:cNvSpPr txBox="1"/>
          <p:nvPr/>
        </p:nvSpPr>
        <p:spPr>
          <a:xfrm>
            <a:off x="0" y="0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4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2B5E14F-57F0-B6FD-FFB1-21FFDC003FF2}"/>
              </a:ext>
            </a:extLst>
          </p:cNvPr>
          <p:cNvSpPr txBox="1"/>
          <p:nvPr/>
        </p:nvSpPr>
        <p:spPr>
          <a:xfrm flipH="1">
            <a:off x="2090068" y="4274200"/>
            <a:ext cx="5915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FA22D424-749F-6426-D3BF-47700056BCC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08091786"/>
              </p:ext>
            </p:extLst>
          </p:nvPr>
        </p:nvGraphicFramePr>
        <p:xfrm>
          <a:off x="2304472" y="4487496"/>
          <a:ext cx="2912249" cy="19615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6BA533C8-4B88-EDCE-04B9-D670C7EB813C}"/>
              </a:ext>
            </a:extLst>
          </p:cNvPr>
          <p:cNvSpPr txBox="1"/>
          <p:nvPr/>
        </p:nvSpPr>
        <p:spPr>
          <a:xfrm>
            <a:off x="2834699" y="3858550"/>
            <a:ext cx="28396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0         8          16         24         32           40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2A7DF487-9296-3855-AEDE-71CBA0C8EBA9}"/>
              </a:ext>
            </a:extLst>
          </p:cNvPr>
          <p:cNvGrpSpPr/>
          <p:nvPr/>
        </p:nvGrpSpPr>
        <p:grpSpPr>
          <a:xfrm>
            <a:off x="2125108" y="2109167"/>
            <a:ext cx="2998702" cy="2178581"/>
            <a:chOff x="2104788" y="1560527"/>
            <a:chExt cx="2998702" cy="2178581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EF554549-06F5-969E-E537-5D3EF93CC9CA}"/>
                </a:ext>
              </a:extLst>
            </p:cNvPr>
            <p:cNvGrpSpPr/>
            <p:nvPr/>
          </p:nvGrpSpPr>
          <p:grpSpPr>
            <a:xfrm>
              <a:off x="2559354" y="1785782"/>
              <a:ext cx="2531493" cy="1615827"/>
              <a:chOff x="2559354" y="1785782"/>
              <a:chExt cx="2531493" cy="1615827"/>
            </a:xfrm>
          </p:grpSpPr>
          <p:pic>
            <p:nvPicPr>
              <p:cNvPr id="24" name="Picture 23" descr="A graph showing the growth of a stock market&#10;&#10;Description automatically generated">
                <a:extLst>
                  <a:ext uri="{FF2B5EF4-FFF2-40B4-BE49-F238E27FC236}">
                    <a16:creationId xmlns:a16="http://schemas.microsoft.com/office/drawing/2014/main" id="{8A448F8E-174F-AFF0-7A92-9E9C68B9DFA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860698" y="1857848"/>
                <a:ext cx="2230149" cy="1481405"/>
              </a:xfrm>
              <a:prstGeom prst="rect">
                <a:avLst/>
              </a:prstGeom>
            </p:spPr>
          </p:pic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16C54BBA-F4A5-81F5-F452-4F00B52B2303}"/>
                  </a:ext>
                </a:extLst>
              </p:cNvPr>
              <p:cNvSpPr txBox="1"/>
              <p:nvPr/>
            </p:nvSpPr>
            <p:spPr>
              <a:xfrm>
                <a:off x="2559354" y="1785782"/>
                <a:ext cx="557180" cy="16158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100</a:t>
                </a:r>
              </a:p>
              <a:p>
                <a:endParaRPr lang="en-US" sz="900" dirty="0"/>
              </a:p>
              <a:p>
                <a:r>
                  <a:rPr lang="en-US" sz="900" dirty="0"/>
                  <a:t>  80</a:t>
                </a:r>
              </a:p>
              <a:p>
                <a:endParaRPr lang="en-US" sz="900" dirty="0"/>
              </a:p>
              <a:p>
                <a:r>
                  <a:rPr lang="en-US" sz="900" dirty="0"/>
                  <a:t>  60</a:t>
                </a:r>
              </a:p>
              <a:p>
                <a:endParaRPr lang="en-US" sz="900" dirty="0"/>
              </a:p>
              <a:p>
                <a:r>
                  <a:rPr lang="en-US" sz="900" dirty="0"/>
                  <a:t>  40</a:t>
                </a:r>
              </a:p>
              <a:p>
                <a:endParaRPr lang="en-US" sz="900" dirty="0"/>
              </a:p>
              <a:p>
                <a:r>
                  <a:rPr lang="en-US" sz="900" dirty="0"/>
                  <a:t>  20</a:t>
                </a:r>
              </a:p>
              <a:p>
                <a:endParaRPr lang="en-US" sz="900" dirty="0"/>
              </a:p>
              <a:p>
                <a:r>
                  <a:rPr lang="en-US" sz="900" dirty="0"/>
                  <a:t>    0</a:t>
                </a:r>
              </a:p>
            </p:txBody>
          </p: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AE2FA7F5-7B69-9047-763B-BB31E9199E4E}"/>
                </a:ext>
              </a:extLst>
            </p:cNvPr>
            <p:cNvGrpSpPr/>
            <p:nvPr/>
          </p:nvGrpSpPr>
          <p:grpSpPr>
            <a:xfrm>
              <a:off x="2104788" y="1560527"/>
              <a:ext cx="2998702" cy="2178581"/>
              <a:chOff x="2484213" y="582800"/>
              <a:chExt cx="2825904" cy="1961801"/>
            </a:xfrm>
          </p:grpSpPr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EC6143B6-354E-FACE-DDFD-AF1C53D111E1}"/>
                  </a:ext>
                </a:extLst>
              </p:cNvPr>
              <p:cNvGrpSpPr/>
              <p:nvPr/>
            </p:nvGrpSpPr>
            <p:grpSpPr>
              <a:xfrm>
                <a:off x="2804960" y="707223"/>
                <a:ext cx="2505157" cy="1837378"/>
                <a:chOff x="3478334" y="2750213"/>
                <a:chExt cx="2505157" cy="1837378"/>
              </a:xfrm>
            </p:grpSpPr>
            <p:sp>
              <p:nvSpPr>
                <p:cNvPr id="18" name="TextBox 40">
                  <a:extLst>
                    <a:ext uri="{FF2B5EF4-FFF2-40B4-BE49-F238E27FC236}">
                      <a16:creationId xmlns:a16="http://schemas.microsoft.com/office/drawing/2014/main" id="{5074A6F1-CE86-7D0D-6737-913CD89F0E48}"/>
                    </a:ext>
                  </a:extLst>
                </p:cNvPr>
                <p:cNvSpPr txBox="1"/>
                <p:nvPr/>
              </p:nvSpPr>
              <p:spPr>
                <a:xfrm>
                  <a:off x="5119152" y="2927963"/>
                  <a:ext cx="864339" cy="50783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r"/>
                  <a:r>
                    <a:rPr lang="en-US" sz="900" dirty="0">
                      <a:solidFill>
                        <a:srgbClr val="0673C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</a:p>
                <a:p>
                  <a:pPr algn="r"/>
                  <a:r>
                    <a:rPr lang="en-US" sz="900" dirty="0">
                      <a:solidFill>
                        <a:srgbClr val="25B16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R (</a:t>
                  </a:r>
                  <a:r>
                    <a:rPr lang="en-US" sz="900" i="1" dirty="0">
                      <a:solidFill>
                        <a:srgbClr val="25B16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et15∆)</a:t>
                  </a:r>
                </a:p>
                <a:p>
                  <a:pPr algn="r"/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0A9D4D9E-20D4-4826-53A0-564752D68E1F}"/>
                    </a:ext>
                  </a:extLst>
                </p:cNvPr>
                <p:cNvSpPr txBox="1"/>
                <p:nvPr/>
              </p:nvSpPr>
              <p:spPr>
                <a:xfrm rot="16200000">
                  <a:off x="2837454" y="3391093"/>
                  <a:ext cx="152798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% Mothers Still Dividing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483B56D7-0B78-759A-5104-01306CD3B81F}"/>
                    </a:ext>
                  </a:extLst>
                </p:cNvPr>
                <p:cNvSpPr txBox="1"/>
                <p:nvPr/>
              </p:nvSpPr>
              <p:spPr>
                <a:xfrm>
                  <a:off x="4505364" y="4341370"/>
                  <a:ext cx="102143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ell Divisions</a:t>
                  </a:r>
                </a:p>
              </p:txBody>
            </p:sp>
          </p:grp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411498FD-63AF-A5E8-C67D-A15E0F7A7959}"/>
                  </a:ext>
                </a:extLst>
              </p:cNvPr>
              <p:cNvSpPr txBox="1"/>
              <p:nvPr/>
            </p:nvSpPr>
            <p:spPr>
              <a:xfrm flipH="1">
                <a:off x="2484213" y="582800"/>
                <a:ext cx="591546" cy="2494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 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0737424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562E5294-1B70-C9AE-25EE-6AF19BFC2350}"/>
              </a:ext>
            </a:extLst>
          </p:cNvPr>
          <p:cNvSpPr txBox="1"/>
          <p:nvPr/>
        </p:nvSpPr>
        <p:spPr>
          <a:xfrm flipH="1">
            <a:off x="2412853" y="1532023"/>
            <a:ext cx="3937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375C83C-F1A1-942A-0E80-D129E21D92B0}"/>
              </a:ext>
            </a:extLst>
          </p:cNvPr>
          <p:cNvSpPr txBox="1"/>
          <p:nvPr/>
        </p:nvSpPr>
        <p:spPr>
          <a:xfrm flipH="1">
            <a:off x="2405548" y="5722169"/>
            <a:ext cx="408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</a:p>
        </p:txBody>
      </p:sp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48F51214-DED8-87C3-A2B2-E3553428D59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2263219"/>
              </p:ext>
            </p:extLst>
          </p:nvPr>
        </p:nvGraphicFramePr>
        <p:xfrm>
          <a:off x="2548299" y="4017942"/>
          <a:ext cx="2675802" cy="17286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4" name="TextBox 33">
            <a:extLst>
              <a:ext uri="{FF2B5EF4-FFF2-40B4-BE49-F238E27FC236}">
                <a16:creationId xmlns:a16="http://schemas.microsoft.com/office/drawing/2014/main" id="{5E01AB36-7639-AE9B-635E-8D01B93E39A8}"/>
              </a:ext>
            </a:extLst>
          </p:cNvPr>
          <p:cNvSpPr txBox="1"/>
          <p:nvPr/>
        </p:nvSpPr>
        <p:spPr>
          <a:xfrm>
            <a:off x="0" y="0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5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5739A76-45A9-F49B-4654-7152654C0B74}"/>
              </a:ext>
            </a:extLst>
          </p:cNvPr>
          <p:cNvSpPr txBox="1"/>
          <p:nvPr/>
        </p:nvSpPr>
        <p:spPr>
          <a:xfrm flipH="1">
            <a:off x="2412853" y="3710165"/>
            <a:ext cx="3937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</a:p>
        </p:txBody>
      </p:sp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915006EB-7D51-D92A-612E-BB65CC0D8C4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48860239"/>
              </p:ext>
            </p:extLst>
          </p:nvPr>
        </p:nvGraphicFramePr>
        <p:xfrm>
          <a:off x="2223083" y="1594133"/>
          <a:ext cx="3177031" cy="21157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3" name="Group 2">
            <a:extLst>
              <a:ext uri="{FF2B5EF4-FFF2-40B4-BE49-F238E27FC236}">
                <a16:creationId xmlns:a16="http://schemas.microsoft.com/office/drawing/2014/main" id="{CF52E369-43AC-9683-7262-EB7180D9FDF8}"/>
              </a:ext>
            </a:extLst>
          </p:cNvPr>
          <p:cNvGrpSpPr/>
          <p:nvPr/>
        </p:nvGrpSpPr>
        <p:grpSpPr>
          <a:xfrm>
            <a:off x="2670708" y="6054320"/>
            <a:ext cx="2955985" cy="1888017"/>
            <a:chOff x="4188617" y="1267795"/>
            <a:chExt cx="2955985" cy="1888017"/>
          </a:xfrm>
        </p:grpSpPr>
        <p:pic>
          <p:nvPicPr>
            <p:cNvPr id="5" name="Picture 4" descr="A graph showing the growth of a stock market&#10;&#10;Description automatically generated with medium confidence">
              <a:extLst>
                <a:ext uri="{FF2B5EF4-FFF2-40B4-BE49-F238E27FC236}">
                  <a16:creationId xmlns:a16="http://schemas.microsoft.com/office/drawing/2014/main" id="{A4435FB5-0D41-8D42-F80D-C94616794F7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626049" y="1461612"/>
              <a:ext cx="2026569" cy="1361986"/>
            </a:xfrm>
            <a:prstGeom prst="rect">
              <a:avLst/>
            </a:prstGeom>
          </p:spPr>
        </p:pic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37991BCD-BEE1-45B2-D9DB-BB47FC489508}"/>
                </a:ext>
              </a:extLst>
            </p:cNvPr>
            <p:cNvGrpSpPr/>
            <p:nvPr/>
          </p:nvGrpSpPr>
          <p:grpSpPr>
            <a:xfrm>
              <a:off x="4188617" y="1267795"/>
              <a:ext cx="2955985" cy="1888017"/>
              <a:chOff x="711011" y="4414068"/>
              <a:chExt cx="2955985" cy="1888017"/>
            </a:xfrm>
          </p:grpSpPr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A63A91ED-4906-DBEE-AFDA-F32670C09E37}"/>
                  </a:ext>
                </a:extLst>
              </p:cNvPr>
              <p:cNvGrpSpPr/>
              <p:nvPr/>
            </p:nvGrpSpPr>
            <p:grpSpPr>
              <a:xfrm>
                <a:off x="711011" y="4414068"/>
                <a:ext cx="2955985" cy="1888017"/>
                <a:chOff x="1160852" y="4273149"/>
                <a:chExt cx="2955985" cy="1888017"/>
              </a:xfrm>
            </p:grpSpPr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97D517BB-3B3D-A334-0B68-2479F9B40BA3}"/>
                    </a:ext>
                  </a:extLst>
                </p:cNvPr>
                <p:cNvSpPr txBox="1"/>
                <p:nvPr/>
              </p:nvSpPr>
              <p:spPr>
                <a:xfrm rot="16200000">
                  <a:off x="463065" y="4970936"/>
                  <a:ext cx="16417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% Mothers Still Dividing</a:t>
                  </a:r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2D9DBDA2-C093-22E7-5F2A-CC4B8936B903}"/>
                    </a:ext>
                  </a:extLst>
                </p:cNvPr>
                <p:cNvSpPr txBox="1"/>
                <p:nvPr/>
              </p:nvSpPr>
              <p:spPr>
                <a:xfrm>
                  <a:off x="1294962" y="4343842"/>
                  <a:ext cx="530721" cy="150041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/>
                    <a:t>100</a:t>
                  </a:r>
                </a:p>
                <a:p>
                  <a:pPr>
                    <a:lnSpc>
                      <a:spcPts val="880"/>
                    </a:lnSpc>
                  </a:pPr>
                  <a:endParaRPr lang="en-US" sz="900" dirty="0"/>
                </a:p>
                <a:p>
                  <a:r>
                    <a:rPr lang="en-US" sz="900" dirty="0"/>
                    <a:t>  80</a:t>
                  </a:r>
                </a:p>
                <a:p>
                  <a:pPr>
                    <a:lnSpc>
                      <a:spcPts val="880"/>
                    </a:lnSpc>
                  </a:pPr>
                  <a:endParaRPr lang="en-US" sz="900" dirty="0"/>
                </a:p>
                <a:p>
                  <a:r>
                    <a:rPr lang="en-US" sz="900" dirty="0"/>
                    <a:t>  60</a:t>
                  </a:r>
                </a:p>
                <a:p>
                  <a:pPr>
                    <a:lnSpc>
                      <a:spcPts val="880"/>
                    </a:lnSpc>
                  </a:pPr>
                  <a:endParaRPr lang="en-US" sz="900" dirty="0"/>
                </a:p>
                <a:p>
                  <a:r>
                    <a:rPr lang="en-US" sz="900" dirty="0"/>
                    <a:t>  40</a:t>
                  </a:r>
                </a:p>
                <a:p>
                  <a:pPr>
                    <a:lnSpc>
                      <a:spcPts val="880"/>
                    </a:lnSpc>
                  </a:pPr>
                  <a:endParaRPr lang="en-US" sz="900" dirty="0"/>
                </a:p>
                <a:p>
                  <a:r>
                    <a:rPr lang="en-US" sz="900" dirty="0"/>
                    <a:t>  20</a:t>
                  </a:r>
                </a:p>
                <a:p>
                  <a:pPr>
                    <a:lnSpc>
                      <a:spcPts val="880"/>
                    </a:lnSpc>
                  </a:pPr>
                  <a:endParaRPr lang="en-US" sz="900" dirty="0"/>
                </a:p>
                <a:p>
                  <a:r>
                    <a:rPr lang="en-US" sz="900" dirty="0"/>
                    <a:t>    0</a:t>
                  </a: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C9146CF9-775F-4F36-6EBC-8AC32D320214}"/>
                    </a:ext>
                  </a:extLst>
                </p:cNvPr>
                <p:cNvSpPr txBox="1"/>
                <p:nvPr/>
              </p:nvSpPr>
              <p:spPr>
                <a:xfrm>
                  <a:off x="1472487" y="5775134"/>
                  <a:ext cx="264435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/>
                    <a:t>0         8         16         24         32         40</a:t>
                  </a:r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C0D6F406-C77C-9C43-D216-7ED842CFE461}"/>
                    </a:ext>
                  </a:extLst>
                </p:cNvPr>
                <p:cNvSpPr txBox="1"/>
                <p:nvPr/>
              </p:nvSpPr>
              <p:spPr>
                <a:xfrm>
                  <a:off x="2056808" y="5914945"/>
                  <a:ext cx="138688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ell Divisions</a:t>
                  </a:r>
                </a:p>
              </p:txBody>
            </p:sp>
          </p:grp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84AA39C3-9345-F0F6-C8DC-A112CE9B1277}"/>
                  </a:ext>
                </a:extLst>
              </p:cNvPr>
              <p:cNvSpPr txBox="1"/>
              <p:nvPr/>
            </p:nvSpPr>
            <p:spPr>
              <a:xfrm>
                <a:off x="2179866" y="4633264"/>
                <a:ext cx="99514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900" dirty="0">
                    <a:solidFill>
                      <a:srgbClr val="1079C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  <a:p>
                <a:pPr algn="r"/>
                <a:r>
                  <a:rPr lang="en-US" sz="900" dirty="0">
                    <a:solidFill>
                      <a:srgbClr val="1EAF5D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R</a:t>
                </a:r>
              </a:p>
              <a:p>
                <a:pPr algn="r"/>
                <a:r>
                  <a:rPr lang="en-US" sz="900" i="1" dirty="0">
                    <a:solidFill>
                      <a:srgbClr val="DAB919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ph1∆</a:t>
                </a:r>
              </a:p>
              <a:p>
                <a:pPr algn="r"/>
                <a:r>
                  <a:rPr lang="en-US" sz="900" dirty="0">
                    <a:solidFill>
                      <a:srgbClr val="F35B0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R </a:t>
                </a:r>
                <a:r>
                  <a:rPr lang="en-US" sz="900" i="1" dirty="0">
                    <a:solidFill>
                      <a:srgbClr val="F35B0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ph1∆</a:t>
                </a:r>
                <a:endParaRPr lang="en-US" sz="900" dirty="0">
                  <a:solidFill>
                    <a:srgbClr val="F35B0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4820600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48E3DB6-5ACC-CAE5-07DD-061D61A2151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A10AFA60-AD5D-1218-8692-C6FAF4059A60}"/>
              </a:ext>
            </a:extLst>
          </p:cNvPr>
          <p:cNvSpPr txBox="1"/>
          <p:nvPr/>
        </p:nvSpPr>
        <p:spPr>
          <a:xfrm>
            <a:off x="31509" y="24710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6.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47B0D598-1DC5-74F6-3B84-B0A3CD3AA576}"/>
              </a:ext>
            </a:extLst>
          </p:cNvPr>
          <p:cNvSpPr txBox="1"/>
          <p:nvPr/>
        </p:nvSpPr>
        <p:spPr>
          <a:xfrm flipH="1">
            <a:off x="2275984" y="2686429"/>
            <a:ext cx="5134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263AA8FC-C942-6E43-D6BD-5BAAAF635D44}"/>
              </a:ext>
            </a:extLst>
          </p:cNvPr>
          <p:cNvSpPr txBox="1"/>
          <p:nvPr/>
        </p:nvSpPr>
        <p:spPr>
          <a:xfrm flipH="1">
            <a:off x="2275984" y="4851682"/>
            <a:ext cx="5134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456D4CCC-7E07-6056-46CE-ACAC676D14D5}"/>
              </a:ext>
            </a:extLst>
          </p:cNvPr>
          <p:cNvSpPr txBox="1"/>
          <p:nvPr/>
        </p:nvSpPr>
        <p:spPr>
          <a:xfrm flipH="1">
            <a:off x="2275984" y="6917499"/>
            <a:ext cx="5134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91" name="Chart 90">
            <a:extLst>
              <a:ext uri="{FF2B5EF4-FFF2-40B4-BE49-F238E27FC236}">
                <a16:creationId xmlns:a16="http://schemas.microsoft.com/office/drawing/2014/main" id="{69676EB6-77B6-7BA0-53EF-1E8E5B9C54A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8309402"/>
              </p:ext>
            </p:extLst>
          </p:nvPr>
        </p:nvGraphicFramePr>
        <p:xfrm>
          <a:off x="2789392" y="2909040"/>
          <a:ext cx="2423035" cy="16966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E897732A-D057-6147-2E5E-56566FD324A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96373785"/>
              </p:ext>
            </p:extLst>
          </p:nvPr>
        </p:nvGraphicFramePr>
        <p:xfrm>
          <a:off x="2706650" y="5024981"/>
          <a:ext cx="2772953" cy="18537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4" name="Group 3">
            <a:extLst>
              <a:ext uri="{FF2B5EF4-FFF2-40B4-BE49-F238E27FC236}">
                <a16:creationId xmlns:a16="http://schemas.microsoft.com/office/drawing/2014/main" id="{5A0B368C-A7C8-C6B2-C82A-6D3904A648F5}"/>
              </a:ext>
            </a:extLst>
          </p:cNvPr>
          <p:cNvGrpSpPr/>
          <p:nvPr/>
        </p:nvGrpSpPr>
        <p:grpSpPr>
          <a:xfrm>
            <a:off x="2302047" y="1143160"/>
            <a:ext cx="1673683" cy="1181383"/>
            <a:chOff x="4798125" y="5393477"/>
            <a:chExt cx="1673683" cy="1181383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727EA515-9ED5-4078-F0A2-3E407B675996}"/>
                </a:ext>
              </a:extLst>
            </p:cNvPr>
            <p:cNvGrpSpPr/>
            <p:nvPr/>
          </p:nvGrpSpPr>
          <p:grpSpPr>
            <a:xfrm>
              <a:off x="4798125" y="5393477"/>
              <a:ext cx="1658577" cy="1181383"/>
              <a:chOff x="3165663" y="2563066"/>
              <a:chExt cx="1658577" cy="1181383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63B8D794-F057-0E94-3E2E-E0A06932984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rcRect t="19998" r="60350" b="16678"/>
              <a:stretch/>
            </p:blipFill>
            <p:spPr>
              <a:xfrm>
                <a:off x="3874850" y="3228289"/>
                <a:ext cx="945246" cy="23397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69329F9D-0257-1942-CC25-424D9A789F1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rcRect l="2173" t="23166" r="59042" b="21349"/>
              <a:stretch/>
            </p:blipFill>
            <p:spPr>
              <a:xfrm>
                <a:off x="3878993" y="3534627"/>
                <a:ext cx="945247" cy="20982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4FF99D47-E6CD-B017-8C03-02ADCA780814}"/>
                  </a:ext>
                </a:extLst>
              </p:cNvPr>
              <p:cNvSpPr txBox="1"/>
              <p:nvPr/>
            </p:nvSpPr>
            <p:spPr>
              <a:xfrm>
                <a:off x="3165663" y="3223205"/>
                <a:ext cx="769763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Npr2-Myc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5055BC45-546D-EABD-BFE8-E42BAA0E006C}"/>
                  </a:ext>
                </a:extLst>
              </p:cNvPr>
              <p:cNvSpPr txBox="1"/>
              <p:nvPr/>
            </p:nvSpPr>
            <p:spPr>
              <a:xfrm>
                <a:off x="3288294" y="3490533"/>
                <a:ext cx="649537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G6PDH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82A194A5-CF84-A1F8-955F-1A1497EA641D}"/>
                  </a:ext>
                </a:extLst>
              </p:cNvPr>
              <p:cNvSpPr txBox="1"/>
              <p:nvPr/>
            </p:nvSpPr>
            <p:spPr>
              <a:xfrm rot="16200000">
                <a:off x="4005770" y="2908624"/>
                <a:ext cx="506870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MR 1</a:t>
                </a:r>
                <a:endParaRPr lang="en-US" sz="105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CB9CBC27-5E86-9FB7-5ADD-10C430EAB3B0}"/>
                  </a:ext>
                </a:extLst>
              </p:cNvPr>
              <p:cNvSpPr txBox="1"/>
              <p:nvPr/>
            </p:nvSpPr>
            <p:spPr>
              <a:xfrm rot="16200000">
                <a:off x="3660897" y="2802555"/>
                <a:ext cx="732893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 1</a:t>
                </a:r>
                <a:endParaRPr lang="en-US" sz="105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45A7A15-688C-1C6B-6265-FEA905CF6537}"/>
                </a:ext>
              </a:extLst>
            </p:cNvPr>
            <p:cNvSpPr txBox="1"/>
            <p:nvPr/>
          </p:nvSpPr>
          <p:spPr>
            <a:xfrm rot="16200000">
              <a:off x="6091415" y="5745978"/>
              <a:ext cx="50687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MR 2</a:t>
              </a:r>
              <a:endParaRPr lang="en-US" sz="10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1DADFCD-4D63-7B5B-47AE-19FD140647C2}"/>
                </a:ext>
              </a:extLst>
            </p:cNvPr>
            <p:cNvSpPr txBox="1"/>
            <p:nvPr/>
          </p:nvSpPr>
          <p:spPr>
            <a:xfrm rot="16200000">
              <a:off x="5746542" y="5639909"/>
              <a:ext cx="73289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Control 2</a:t>
              </a:r>
              <a:endParaRPr lang="en-US" sz="10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5" name="Picture 14">
            <a:extLst>
              <a:ext uri="{FF2B5EF4-FFF2-40B4-BE49-F238E27FC236}">
                <a16:creationId xmlns:a16="http://schemas.microsoft.com/office/drawing/2014/main" id="{29F8F8CF-A960-38B6-C8EA-3BFB271A1FC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55746" y="1127016"/>
            <a:ext cx="1408668" cy="136273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E7A5DBD-0B4B-BC74-BDC7-17335C4C4581}"/>
              </a:ext>
            </a:extLst>
          </p:cNvPr>
          <p:cNvSpPr txBox="1"/>
          <p:nvPr/>
        </p:nvSpPr>
        <p:spPr>
          <a:xfrm flipH="1">
            <a:off x="2275983" y="1127016"/>
            <a:ext cx="5134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D8FA172E-7E69-7552-2C56-658CA1709EFA}"/>
              </a:ext>
            </a:extLst>
          </p:cNvPr>
          <p:cNvGrpSpPr/>
          <p:nvPr/>
        </p:nvGrpSpPr>
        <p:grpSpPr>
          <a:xfrm>
            <a:off x="2789392" y="7140922"/>
            <a:ext cx="3223348" cy="1883369"/>
            <a:chOff x="4834017" y="1127016"/>
            <a:chExt cx="3223348" cy="1883369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D28F9DE-73DC-B7D6-1BEE-F4FF9A30AC66}"/>
                </a:ext>
              </a:extLst>
            </p:cNvPr>
            <p:cNvSpPr txBox="1"/>
            <p:nvPr/>
          </p:nvSpPr>
          <p:spPr>
            <a:xfrm>
              <a:off x="5217701" y="2627427"/>
              <a:ext cx="28396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0        10        20        30       40       50</a:t>
              </a:r>
            </a:p>
          </p:txBody>
        </p: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9F78B3FC-B69E-74C3-E19E-58A8B6616AB2}"/>
                </a:ext>
              </a:extLst>
            </p:cNvPr>
            <p:cNvGrpSpPr/>
            <p:nvPr/>
          </p:nvGrpSpPr>
          <p:grpSpPr>
            <a:xfrm>
              <a:off x="4834017" y="1127016"/>
              <a:ext cx="2419753" cy="1883369"/>
              <a:chOff x="4834017" y="1127016"/>
              <a:chExt cx="2419753" cy="1883369"/>
            </a:xfrm>
          </p:grpSpPr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126A4FAC-809D-3959-5582-766F449FA0F6}"/>
                  </a:ext>
                </a:extLst>
              </p:cNvPr>
              <p:cNvSpPr txBox="1"/>
              <p:nvPr/>
            </p:nvSpPr>
            <p:spPr>
              <a:xfrm>
                <a:off x="4962923" y="1127016"/>
                <a:ext cx="557180" cy="16158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100</a:t>
                </a:r>
              </a:p>
              <a:p>
                <a:endParaRPr lang="en-US" sz="900" dirty="0"/>
              </a:p>
              <a:p>
                <a:r>
                  <a:rPr lang="en-US" sz="900" dirty="0"/>
                  <a:t>  80</a:t>
                </a:r>
              </a:p>
              <a:p>
                <a:endParaRPr lang="en-US" sz="900" dirty="0"/>
              </a:p>
              <a:p>
                <a:r>
                  <a:rPr lang="en-US" sz="900" dirty="0"/>
                  <a:t>  60</a:t>
                </a:r>
              </a:p>
              <a:p>
                <a:endParaRPr lang="en-US" sz="900" dirty="0"/>
              </a:p>
              <a:p>
                <a:r>
                  <a:rPr lang="en-US" sz="900" dirty="0"/>
                  <a:t>  40</a:t>
                </a:r>
              </a:p>
              <a:p>
                <a:endParaRPr lang="en-US" sz="900" dirty="0"/>
              </a:p>
              <a:p>
                <a:r>
                  <a:rPr lang="en-US" sz="900" dirty="0"/>
                  <a:t>  20</a:t>
                </a:r>
              </a:p>
              <a:p>
                <a:endParaRPr lang="en-US" sz="900" dirty="0"/>
              </a:p>
              <a:p>
                <a:r>
                  <a:rPr lang="en-US" sz="900" dirty="0"/>
                  <a:t>    0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B8AB7441-396E-AF01-3080-7102716DAF11}"/>
                  </a:ext>
                </a:extLst>
              </p:cNvPr>
              <p:cNvSpPr txBox="1"/>
              <p:nvPr/>
            </p:nvSpPr>
            <p:spPr>
              <a:xfrm>
                <a:off x="5799735" y="2764164"/>
                <a:ext cx="95410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ell Divisions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DDC61641-B1B8-6E35-426C-60CF136668B8}"/>
                  </a:ext>
                </a:extLst>
              </p:cNvPr>
              <p:cNvSpPr txBox="1"/>
              <p:nvPr/>
            </p:nvSpPr>
            <p:spPr>
              <a:xfrm rot="16200000">
                <a:off x="4193137" y="1819414"/>
                <a:ext cx="152798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% Mothers Still Dividing</a:t>
                </a:r>
              </a:p>
            </p:txBody>
          </p:sp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C0060497-22B2-2587-3522-2D38AF2071F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rcRect l="14298" b="25082"/>
              <a:stretch>
                <a:fillRect/>
              </a:stretch>
            </p:blipFill>
            <p:spPr>
              <a:xfrm>
                <a:off x="5299808" y="1127016"/>
                <a:ext cx="1953962" cy="1500412"/>
              </a:xfrm>
              <a:prstGeom prst="rect">
                <a:avLst/>
              </a:prstGeom>
            </p:spPr>
          </p:pic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129B62BF-5E98-1BC6-F45B-03AA4F6A5649}"/>
                  </a:ext>
                </a:extLst>
              </p:cNvPr>
              <p:cNvSpPr txBox="1"/>
              <p:nvPr/>
            </p:nvSpPr>
            <p:spPr>
              <a:xfrm>
                <a:off x="6368555" y="1196268"/>
                <a:ext cx="840358" cy="9541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solidFill>
                      <a:srgbClr val="DAB919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en-US" sz="800" i="1" dirty="0">
                  <a:solidFill>
                    <a:srgbClr val="DAB919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sz="800" dirty="0">
                    <a:solidFill>
                      <a:srgbClr val="F35B0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trol + rapa</a:t>
                </a:r>
                <a:endParaRPr lang="en-US" sz="800" dirty="0">
                  <a:solidFill>
                    <a:srgbClr val="1079C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sz="800" dirty="0">
                    <a:solidFill>
                      <a:srgbClr val="1079C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R</a:t>
                </a:r>
              </a:p>
              <a:p>
                <a:pPr algn="r"/>
                <a:r>
                  <a:rPr lang="en-US" sz="800" dirty="0">
                    <a:solidFill>
                      <a:srgbClr val="1EAF5D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R + rapa</a:t>
                </a:r>
              </a:p>
              <a:p>
                <a:pPr algn="r"/>
                <a:endParaRPr lang="en-US" sz="800" dirty="0">
                  <a:solidFill>
                    <a:srgbClr val="06908B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sz="800" dirty="0">
                  <a:solidFill>
                    <a:srgbClr val="F35B0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6486166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1B96458-147B-36F0-CA26-6E382F649D1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C3F4E36C-2BC3-9B84-1E9B-6417A85F2014}"/>
              </a:ext>
            </a:extLst>
          </p:cNvPr>
          <p:cNvSpPr txBox="1"/>
          <p:nvPr/>
        </p:nvSpPr>
        <p:spPr>
          <a:xfrm>
            <a:off x="31509" y="24710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7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6B3A1ED-6AD8-F32F-B20F-550D154CEB24}"/>
              </a:ext>
            </a:extLst>
          </p:cNvPr>
          <p:cNvSpPr txBox="1"/>
          <p:nvPr/>
        </p:nvSpPr>
        <p:spPr>
          <a:xfrm flipH="1">
            <a:off x="1978618" y="2043949"/>
            <a:ext cx="5134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BFECE111-9C01-8AED-5DA4-5A299EDC086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74465055"/>
              </p:ext>
            </p:extLst>
          </p:nvPr>
        </p:nvGraphicFramePr>
        <p:xfrm>
          <a:off x="2563343" y="2112336"/>
          <a:ext cx="3114908" cy="19208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5" name="Group 4">
            <a:extLst>
              <a:ext uri="{FF2B5EF4-FFF2-40B4-BE49-F238E27FC236}">
                <a16:creationId xmlns:a16="http://schemas.microsoft.com/office/drawing/2014/main" id="{4A4B6199-3878-3FBF-DBB4-F15FAC413AF0}"/>
              </a:ext>
            </a:extLst>
          </p:cNvPr>
          <p:cNvGrpSpPr/>
          <p:nvPr/>
        </p:nvGrpSpPr>
        <p:grpSpPr>
          <a:xfrm>
            <a:off x="2014536" y="4403163"/>
            <a:ext cx="3954852" cy="1914523"/>
            <a:chOff x="2986625" y="6702743"/>
            <a:chExt cx="3954852" cy="1914523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A63D2CA-7E4C-E765-DF09-05DFCE46CFA3}"/>
                </a:ext>
              </a:extLst>
            </p:cNvPr>
            <p:cNvSpPr txBox="1"/>
            <p:nvPr/>
          </p:nvSpPr>
          <p:spPr>
            <a:xfrm rot="16200000">
              <a:off x="5732960" y="7651777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Control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933B2ED-680B-9D30-C20B-0C96EE00109F}"/>
                </a:ext>
              </a:extLst>
            </p:cNvPr>
            <p:cNvSpPr txBox="1"/>
            <p:nvPr/>
          </p:nvSpPr>
          <p:spPr>
            <a:xfrm rot="16200000">
              <a:off x="6103281" y="7761219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MR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AEA520F-583F-28ED-C1A2-8F12772C625E}"/>
                </a:ext>
              </a:extLst>
            </p:cNvPr>
            <p:cNvSpPr txBox="1"/>
            <p:nvPr/>
          </p:nvSpPr>
          <p:spPr>
            <a:xfrm rot="16200000">
              <a:off x="5981568" y="7374322"/>
              <a:ext cx="11544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Control + met D4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B87270B-18D1-A816-5A9F-BCE0A9FDFC02}"/>
                </a:ext>
              </a:extLst>
            </p:cNvPr>
            <p:cNvSpPr txBox="1"/>
            <p:nvPr/>
          </p:nvSpPr>
          <p:spPr>
            <a:xfrm rot="16200000">
              <a:off x="6346923" y="7478653"/>
              <a:ext cx="9428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MR + met D4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C1EF9C8-6C0F-B7EF-71CD-317781274914}"/>
                </a:ext>
              </a:extLst>
            </p:cNvPr>
            <p:cNvSpPr txBox="1"/>
            <p:nvPr/>
          </p:nvSpPr>
          <p:spPr>
            <a:xfrm>
              <a:off x="6048143" y="6709890"/>
              <a:ext cx="61266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Day 14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DC861E2-0B3B-F433-A16A-E45724D847FD}"/>
                </a:ext>
              </a:extLst>
            </p:cNvPr>
            <p:cNvSpPr txBox="1"/>
            <p:nvPr/>
          </p:nvSpPr>
          <p:spPr>
            <a:xfrm>
              <a:off x="2986625" y="7996133"/>
              <a:ext cx="7521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GFP-Atg8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8F97C1C-2475-643B-EDAF-8DCFCF117D71}"/>
                </a:ext>
              </a:extLst>
            </p:cNvPr>
            <p:cNvSpPr txBox="1"/>
            <p:nvPr/>
          </p:nvSpPr>
          <p:spPr>
            <a:xfrm>
              <a:off x="3004718" y="8181664"/>
              <a:ext cx="7457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Free GFP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A40CCB4-0D87-4A59-5D03-435B9F4CAA44}"/>
                </a:ext>
              </a:extLst>
            </p:cNvPr>
            <p:cNvSpPr txBox="1"/>
            <p:nvPr/>
          </p:nvSpPr>
          <p:spPr>
            <a:xfrm>
              <a:off x="3113262" y="8371045"/>
              <a:ext cx="6254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G6PDH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679C64B-DC37-CD01-AD4E-795B2463C71F}"/>
                </a:ext>
              </a:extLst>
            </p:cNvPr>
            <p:cNvSpPr txBox="1"/>
            <p:nvPr/>
          </p:nvSpPr>
          <p:spPr>
            <a:xfrm rot="16200000">
              <a:off x="4653556" y="7648133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Control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2C44C5AF-BC15-3C08-6A36-5E97056C1A80}"/>
                </a:ext>
              </a:extLst>
            </p:cNvPr>
            <p:cNvSpPr txBox="1"/>
            <p:nvPr/>
          </p:nvSpPr>
          <p:spPr>
            <a:xfrm rot="16200000">
              <a:off x="4997243" y="7757575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MR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BF3877E-B8DC-D72F-F667-50421057511C}"/>
                </a:ext>
              </a:extLst>
            </p:cNvPr>
            <p:cNvSpPr txBox="1"/>
            <p:nvPr/>
          </p:nvSpPr>
          <p:spPr>
            <a:xfrm rot="16200000">
              <a:off x="4875530" y="7370678"/>
              <a:ext cx="11544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Control + met D4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A00794E-3EED-0D91-1294-648512C1A9A5}"/>
                </a:ext>
              </a:extLst>
            </p:cNvPr>
            <p:cNvSpPr txBox="1"/>
            <p:nvPr/>
          </p:nvSpPr>
          <p:spPr>
            <a:xfrm rot="16200000">
              <a:off x="5240885" y="7475009"/>
              <a:ext cx="9428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MR + met D4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0BD1DC2E-8616-6FB4-3E03-3DF6F103A18B}"/>
                </a:ext>
              </a:extLst>
            </p:cNvPr>
            <p:cNvSpPr txBox="1"/>
            <p:nvPr/>
          </p:nvSpPr>
          <p:spPr>
            <a:xfrm>
              <a:off x="5004251" y="6706246"/>
              <a:ext cx="61266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Day 10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4F512F9-7333-7E1F-F373-EC6889DBAA83}"/>
                </a:ext>
              </a:extLst>
            </p:cNvPr>
            <p:cNvSpPr txBox="1"/>
            <p:nvPr/>
          </p:nvSpPr>
          <p:spPr>
            <a:xfrm rot="16200000">
              <a:off x="3548382" y="7644630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Control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81B91580-6DA7-2857-6440-B11D6C4E61E3}"/>
                </a:ext>
              </a:extLst>
            </p:cNvPr>
            <p:cNvSpPr txBox="1"/>
            <p:nvPr/>
          </p:nvSpPr>
          <p:spPr>
            <a:xfrm rot="16200000">
              <a:off x="3892069" y="7754072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MR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4EC4C41E-4939-9078-88A2-8DFDB2A51CBE}"/>
                </a:ext>
              </a:extLst>
            </p:cNvPr>
            <p:cNvSpPr txBox="1"/>
            <p:nvPr/>
          </p:nvSpPr>
          <p:spPr>
            <a:xfrm rot="16200000">
              <a:off x="3770356" y="7367175"/>
              <a:ext cx="11544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Control + met D4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273638C-1538-7B30-EE5F-CAD08063C2F8}"/>
                </a:ext>
              </a:extLst>
            </p:cNvPr>
            <p:cNvSpPr txBox="1"/>
            <p:nvPr/>
          </p:nvSpPr>
          <p:spPr>
            <a:xfrm rot="16200000">
              <a:off x="4135711" y="7471506"/>
              <a:ext cx="9428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MR + met D4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9AF3ECEF-334B-CAD1-4F92-0CEDDAD0A969}"/>
                </a:ext>
              </a:extLst>
            </p:cNvPr>
            <p:cNvSpPr txBox="1"/>
            <p:nvPr/>
          </p:nvSpPr>
          <p:spPr>
            <a:xfrm>
              <a:off x="3941944" y="6702743"/>
              <a:ext cx="53732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/>
                <a:t>Day 7</a:t>
              </a:r>
            </a:p>
          </p:txBody>
        </p: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14B1B41B-A5B1-E6A4-0DAF-F2816A244AA2}"/>
                </a:ext>
              </a:extLst>
            </p:cNvPr>
            <p:cNvCxnSpPr>
              <a:cxnSpLocks/>
            </p:cNvCxnSpPr>
            <p:nvPr/>
          </p:nvCxnSpPr>
          <p:spPr>
            <a:xfrm>
              <a:off x="3711112" y="6965394"/>
              <a:ext cx="9873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EFD936F2-FB13-1052-D26E-FEFD2FD9B024}"/>
              </a:ext>
            </a:extLst>
          </p:cNvPr>
          <p:cNvSpPr txBox="1"/>
          <p:nvPr/>
        </p:nvSpPr>
        <p:spPr>
          <a:xfrm flipH="1">
            <a:off x="1978617" y="4244413"/>
            <a:ext cx="5134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995217F-FC61-87E6-C392-9B9BA3CE7877}"/>
              </a:ext>
            </a:extLst>
          </p:cNvPr>
          <p:cNvSpPr txBox="1"/>
          <p:nvPr/>
        </p:nvSpPr>
        <p:spPr>
          <a:xfrm flipH="1">
            <a:off x="1978617" y="6655789"/>
            <a:ext cx="5134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54" name="Group 53">
            <a:extLst>
              <a:ext uri="{FF2B5EF4-FFF2-40B4-BE49-F238E27FC236}">
                <a16:creationId xmlns:a16="http://schemas.microsoft.com/office/drawing/2014/main" id="{CC400B2E-3236-630E-FEAC-C7514AF7ADF3}"/>
              </a:ext>
            </a:extLst>
          </p:cNvPr>
          <p:cNvGrpSpPr/>
          <p:nvPr/>
        </p:nvGrpSpPr>
        <p:grpSpPr>
          <a:xfrm>
            <a:off x="3061822" y="6655789"/>
            <a:ext cx="1739745" cy="1320460"/>
            <a:chOff x="5119690" y="4711740"/>
            <a:chExt cx="1739745" cy="1320460"/>
          </a:xfrm>
        </p:grpSpPr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7800484A-AC6F-427F-22C5-D6C4DC8603C9}"/>
                </a:ext>
              </a:extLst>
            </p:cNvPr>
            <p:cNvSpPr txBox="1"/>
            <p:nvPr/>
          </p:nvSpPr>
          <p:spPr>
            <a:xfrm>
              <a:off x="5119690" y="5516094"/>
              <a:ext cx="7825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Mup1-Myc</a:t>
              </a:r>
            </a:p>
          </p:txBody>
        </p:sp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9374C7B1-7470-51C6-CC82-173B444A4E74}"/>
                </a:ext>
              </a:extLst>
            </p:cNvPr>
            <p:cNvGrpSpPr/>
            <p:nvPr/>
          </p:nvGrpSpPr>
          <p:grpSpPr>
            <a:xfrm>
              <a:off x="5283504" y="4711740"/>
              <a:ext cx="1575931" cy="1320460"/>
              <a:chOff x="5283504" y="4711740"/>
              <a:chExt cx="1575931" cy="1320460"/>
            </a:xfrm>
          </p:grpSpPr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5D2ACEED-3306-73C7-E0FA-1998FC2DC58E}"/>
                  </a:ext>
                </a:extLst>
              </p:cNvPr>
              <p:cNvSpPr txBox="1"/>
              <p:nvPr/>
            </p:nvSpPr>
            <p:spPr>
              <a:xfrm>
                <a:off x="5283504" y="5785979"/>
                <a:ext cx="62549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G6PDH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BEB28F34-1B95-E09B-C88D-48E184EBB749}"/>
                  </a:ext>
                </a:extLst>
              </p:cNvPr>
              <p:cNvSpPr txBox="1"/>
              <p:nvPr/>
            </p:nvSpPr>
            <p:spPr>
              <a:xfrm rot="16200000">
                <a:off x="5683363" y="5134767"/>
                <a:ext cx="5966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Control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E384CADF-1D7E-FA8F-F68E-CD5991835A7E}"/>
                  </a:ext>
                </a:extLst>
              </p:cNvPr>
              <p:cNvSpPr txBox="1"/>
              <p:nvPr/>
            </p:nvSpPr>
            <p:spPr>
              <a:xfrm rot="16200000">
                <a:off x="6017451" y="5240565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MR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5FF7A020-D7B5-3B8C-565D-4AF20AB50D6B}"/>
                  </a:ext>
                </a:extLst>
              </p:cNvPr>
              <p:cNvSpPr txBox="1"/>
              <p:nvPr/>
            </p:nvSpPr>
            <p:spPr>
              <a:xfrm rot="16200000">
                <a:off x="6146900" y="5134767"/>
                <a:ext cx="5966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Control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66EFC740-063C-6028-502D-4D00C88D92BD}"/>
                  </a:ext>
                </a:extLst>
              </p:cNvPr>
              <p:cNvSpPr txBox="1"/>
              <p:nvPr/>
            </p:nvSpPr>
            <p:spPr>
              <a:xfrm rot="16200000">
                <a:off x="6467587" y="5244299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MR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859871A6-1D14-69F1-EA46-AED1B44D62EA}"/>
                  </a:ext>
                </a:extLst>
              </p:cNvPr>
              <p:cNvSpPr txBox="1"/>
              <p:nvPr/>
            </p:nvSpPr>
            <p:spPr>
              <a:xfrm>
                <a:off x="6322108" y="4711740"/>
                <a:ext cx="537327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Day 9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129489F3-4CBA-F063-B2F9-8263674E89EF}"/>
                  </a:ext>
                </a:extLst>
              </p:cNvPr>
              <p:cNvSpPr txBox="1"/>
              <p:nvPr/>
            </p:nvSpPr>
            <p:spPr>
              <a:xfrm>
                <a:off x="5818023" y="4711740"/>
                <a:ext cx="537327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Day 4</a:t>
                </a:r>
              </a:p>
            </p:txBody>
          </p:sp>
          <p:cxnSp>
            <p:nvCxnSpPr>
              <p:cNvPr id="48" name="Straight Connector 47">
                <a:extLst>
                  <a:ext uri="{FF2B5EF4-FFF2-40B4-BE49-F238E27FC236}">
                    <a16:creationId xmlns:a16="http://schemas.microsoft.com/office/drawing/2014/main" id="{422C5F1F-E491-EDD2-D18F-F7C331FB669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58571" y="4942382"/>
                <a:ext cx="43189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>
                <a:extLst>
                  <a:ext uri="{FF2B5EF4-FFF2-40B4-BE49-F238E27FC236}">
                    <a16:creationId xmlns:a16="http://schemas.microsoft.com/office/drawing/2014/main" id="{D56C8461-07C1-B54E-5818-D6D16A0F4D6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355350" y="4942382"/>
                <a:ext cx="43189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1EC33B0E-FD91-33BD-774F-7501316599AA}"/>
              </a:ext>
            </a:extLst>
          </p:cNvPr>
          <p:cNvCxnSpPr>
            <a:cxnSpLocks/>
          </p:cNvCxnSpPr>
          <p:nvPr/>
        </p:nvCxnSpPr>
        <p:spPr>
          <a:xfrm>
            <a:off x="3831943" y="4665814"/>
            <a:ext cx="9873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97F12102-3C81-9EDB-9AE2-C5D4C9311E9D}"/>
              </a:ext>
            </a:extLst>
          </p:cNvPr>
          <p:cNvCxnSpPr>
            <a:cxnSpLocks/>
          </p:cNvCxnSpPr>
          <p:nvPr/>
        </p:nvCxnSpPr>
        <p:spPr>
          <a:xfrm>
            <a:off x="4889984" y="4665814"/>
            <a:ext cx="9873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4" name="Picture 3" descr="A close-up of a test&#10;&#10;AI-generated content may be incorrect.">
            <a:extLst>
              <a:ext uri="{FF2B5EF4-FFF2-40B4-BE49-F238E27FC236}">
                <a16:creationId xmlns:a16="http://schemas.microsoft.com/office/drawing/2014/main" id="{02B1219F-E58A-551E-3EB4-816666570373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30463" t="42073" r="47381" b="47398"/>
          <a:stretch/>
        </p:blipFill>
        <p:spPr>
          <a:xfrm>
            <a:off x="3812835" y="5699589"/>
            <a:ext cx="1061474" cy="3804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 descr="A close-up of a test&#10;&#10;AI-generated content may be incorrect.">
            <a:extLst>
              <a:ext uri="{FF2B5EF4-FFF2-40B4-BE49-F238E27FC236}">
                <a16:creationId xmlns:a16="http://schemas.microsoft.com/office/drawing/2014/main" id="{B0778F94-F345-9DC3-413E-5EBDE7B87257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31804" t="51620" r="46432" b="42566"/>
          <a:stretch/>
        </p:blipFill>
        <p:spPr>
          <a:xfrm>
            <a:off x="3812835" y="6116072"/>
            <a:ext cx="1061474" cy="1531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Picture 27" descr="A close-up of a test&#10;&#10;AI-generated content may be incorrect.">
            <a:extLst>
              <a:ext uri="{FF2B5EF4-FFF2-40B4-BE49-F238E27FC236}">
                <a16:creationId xmlns:a16="http://schemas.microsoft.com/office/drawing/2014/main" id="{5D9578BB-3F01-562E-67D3-C9F110986BAF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57755" t="46857" r="20755" b="41196"/>
          <a:stretch/>
        </p:blipFill>
        <p:spPr>
          <a:xfrm>
            <a:off x="2706142" y="5696060"/>
            <a:ext cx="1062993" cy="3839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0" name="Picture 49" descr="A close up of a test&#10;&#10;AI-generated content may be incorrect.">
            <a:extLst>
              <a:ext uri="{FF2B5EF4-FFF2-40B4-BE49-F238E27FC236}">
                <a16:creationId xmlns:a16="http://schemas.microsoft.com/office/drawing/2014/main" id="{1A036D23-5ACB-985D-CA9E-C536002972A3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53905" t="50863" r="24969" b="43641"/>
          <a:stretch/>
        </p:blipFill>
        <p:spPr>
          <a:xfrm>
            <a:off x="2706142" y="6116072"/>
            <a:ext cx="1061475" cy="1531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Picture 51" descr="A close-up of a test&#10;&#10;AI-generated content may be incorrect.">
            <a:extLst>
              <a:ext uri="{FF2B5EF4-FFF2-40B4-BE49-F238E27FC236}">
                <a16:creationId xmlns:a16="http://schemas.microsoft.com/office/drawing/2014/main" id="{01105555-E31D-C562-37C7-7E49264B108D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56614" t="51771" r="22842" b="43006"/>
          <a:stretch/>
        </p:blipFill>
        <p:spPr>
          <a:xfrm>
            <a:off x="4920820" y="6114874"/>
            <a:ext cx="1062994" cy="1531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3" name="Picture 52" descr="A close-up of a test&#10;&#10;AI-generated content may be incorrect.">
            <a:extLst>
              <a:ext uri="{FF2B5EF4-FFF2-40B4-BE49-F238E27FC236}">
                <a16:creationId xmlns:a16="http://schemas.microsoft.com/office/drawing/2014/main" id="{E3FC2924-B652-5C83-FC98-C1D8317021BB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55902" t="42073" r="23528" b="47282"/>
          <a:stretch/>
        </p:blipFill>
        <p:spPr>
          <a:xfrm>
            <a:off x="4920820" y="5696953"/>
            <a:ext cx="1069202" cy="38504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5" name="Picture 54" descr="A close-up of a black and white photo&#10;&#10;AI-generated content may be incorrect.">
            <a:extLst>
              <a:ext uri="{FF2B5EF4-FFF2-40B4-BE49-F238E27FC236}">
                <a16:creationId xmlns:a16="http://schemas.microsoft.com/office/drawing/2014/main" id="{ECF29A51-6689-6775-EB08-6BBB2ED2844D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49475" t="50964" r="35544" b="43541"/>
          <a:stretch/>
        </p:blipFill>
        <p:spPr>
          <a:xfrm>
            <a:off x="3767617" y="7769445"/>
            <a:ext cx="1000100" cy="1531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6" name="Picture 55" descr="A blurry image of a bar&#10;&#10;AI-generated content may be incorrect.">
            <a:extLst>
              <a:ext uri="{FF2B5EF4-FFF2-40B4-BE49-F238E27FC236}">
                <a16:creationId xmlns:a16="http://schemas.microsoft.com/office/drawing/2014/main" id="{21D703ED-177F-74A0-6DE8-25DB990A612C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47083" t="54186" r="37311" b="37746"/>
          <a:stretch/>
        </p:blipFill>
        <p:spPr>
          <a:xfrm>
            <a:off x="3770985" y="7436792"/>
            <a:ext cx="1000100" cy="283819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61752737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C167D58-C3E2-A7EB-9C9A-AD4184449703}"/>
              </a:ext>
            </a:extLst>
          </p:cNvPr>
          <p:cNvSpPr txBox="1"/>
          <p:nvPr/>
        </p:nvSpPr>
        <p:spPr>
          <a:xfrm>
            <a:off x="31509" y="24710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8.</a:t>
            </a:r>
          </a:p>
        </p:txBody>
      </p:sp>
      <p:grpSp>
        <p:nvGrpSpPr>
          <p:cNvPr id="75" name="Group 74">
            <a:extLst>
              <a:ext uri="{FF2B5EF4-FFF2-40B4-BE49-F238E27FC236}">
                <a16:creationId xmlns:a16="http://schemas.microsoft.com/office/drawing/2014/main" id="{DA8DEB5F-993F-0B7A-57D8-D27121D52562}"/>
              </a:ext>
            </a:extLst>
          </p:cNvPr>
          <p:cNvGrpSpPr/>
          <p:nvPr/>
        </p:nvGrpSpPr>
        <p:grpSpPr>
          <a:xfrm>
            <a:off x="468157" y="2427081"/>
            <a:ext cx="5432783" cy="3215380"/>
            <a:chOff x="-138840" y="1070464"/>
            <a:chExt cx="5432783" cy="3215380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0082F164-CE44-FB73-0B5E-A9596A4B2F9F}"/>
                </a:ext>
              </a:extLst>
            </p:cNvPr>
            <p:cNvSpPr txBox="1"/>
            <p:nvPr/>
          </p:nvSpPr>
          <p:spPr>
            <a:xfrm>
              <a:off x="1007004" y="2664051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3K36me3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F2CC65DD-2AEA-E4E9-AE00-C5AC9AED0351}"/>
                </a:ext>
              </a:extLst>
            </p:cNvPr>
            <p:cNvSpPr txBox="1"/>
            <p:nvPr/>
          </p:nvSpPr>
          <p:spPr>
            <a:xfrm>
              <a:off x="1216672" y="4039623"/>
              <a:ext cx="6399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82EF6F36-CA31-04A0-B1DA-0E04F27F3897}"/>
                </a:ext>
              </a:extLst>
            </p:cNvPr>
            <p:cNvSpPr txBox="1"/>
            <p:nvPr/>
          </p:nvSpPr>
          <p:spPr>
            <a:xfrm>
              <a:off x="1484880" y="3292547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3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B00A144-BA98-F17C-C32C-3333220A934B}"/>
                </a:ext>
              </a:extLst>
            </p:cNvPr>
            <p:cNvSpPr txBox="1"/>
            <p:nvPr/>
          </p:nvSpPr>
          <p:spPr>
            <a:xfrm rot="16200000">
              <a:off x="1637797" y="2066756"/>
              <a:ext cx="7024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 1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0E39ACB8-3A33-4457-3EA8-54216B067EDD}"/>
                </a:ext>
              </a:extLst>
            </p:cNvPr>
            <p:cNvSpPr txBox="1"/>
            <p:nvPr/>
          </p:nvSpPr>
          <p:spPr>
            <a:xfrm rot="16200000">
              <a:off x="1924022" y="2066756"/>
              <a:ext cx="7024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 2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4A48C39F-57FE-8D81-00E8-FAD85C666CC3}"/>
                </a:ext>
              </a:extLst>
            </p:cNvPr>
            <p:cNvSpPr txBox="1"/>
            <p:nvPr/>
          </p:nvSpPr>
          <p:spPr>
            <a:xfrm rot="16200000">
              <a:off x="2567980" y="2172554"/>
              <a:ext cx="4908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R 2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32DB6EB8-1898-C8CA-70B1-9C5F4385F9AF}"/>
                </a:ext>
              </a:extLst>
            </p:cNvPr>
            <p:cNvSpPr txBox="1"/>
            <p:nvPr/>
          </p:nvSpPr>
          <p:spPr>
            <a:xfrm rot="16200000">
              <a:off x="2293185" y="2172554"/>
              <a:ext cx="4908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R 1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4B30AD91-68A1-A4F0-6D82-53DF44B8D8D7}"/>
                </a:ext>
              </a:extLst>
            </p:cNvPr>
            <p:cNvSpPr txBox="1"/>
            <p:nvPr/>
          </p:nvSpPr>
          <p:spPr>
            <a:xfrm rot="16200000">
              <a:off x="2748407" y="2066756"/>
              <a:ext cx="7024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 1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31C1BB89-927C-4473-C7C6-4F94FAB1EDEF}"/>
                </a:ext>
              </a:extLst>
            </p:cNvPr>
            <p:cNvSpPr txBox="1"/>
            <p:nvPr/>
          </p:nvSpPr>
          <p:spPr>
            <a:xfrm rot="16200000">
              <a:off x="2755709" y="1787834"/>
              <a:ext cx="12602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 2 + met D9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19498F7A-A8D7-30B8-9FDA-DE74EF4AD087}"/>
                </a:ext>
              </a:extLst>
            </p:cNvPr>
            <p:cNvSpPr txBox="1"/>
            <p:nvPr/>
          </p:nvSpPr>
          <p:spPr>
            <a:xfrm rot="16200000">
              <a:off x="3433957" y="1893632"/>
              <a:ext cx="10486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R 2 + met D9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62047507-F0AC-0D30-1F01-D99E6DEB3A7A}"/>
                </a:ext>
              </a:extLst>
            </p:cNvPr>
            <p:cNvSpPr txBox="1"/>
            <p:nvPr/>
          </p:nvSpPr>
          <p:spPr>
            <a:xfrm rot="16200000">
              <a:off x="3426655" y="2172554"/>
              <a:ext cx="4908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R 1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92AC3141-9D64-F49F-07AF-3675FC574CAF}"/>
                </a:ext>
              </a:extLst>
            </p:cNvPr>
            <p:cNvSpPr txBox="1"/>
            <p:nvPr/>
          </p:nvSpPr>
          <p:spPr>
            <a:xfrm rot="16200000">
              <a:off x="3893307" y="2066756"/>
              <a:ext cx="7024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 1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0A2D788-7F2A-628F-6D54-9ADDCC64D76A}"/>
                </a:ext>
              </a:extLst>
            </p:cNvPr>
            <p:cNvSpPr txBox="1"/>
            <p:nvPr/>
          </p:nvSpPr>
          <p:spPr>
            <a:xfrm rot="16200000">
              <a:off x="3900609" y="1787834"/>
              <a:ext cx="12602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 2 + met D9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E787F284-CE51-6B1D-F2DD-69EE51A2694B}"/>
                </a:ext>
              </a:extLst>
            </p:cNvPr>
            <p:cNvSpPr txBox="1"/>
            <p:nvPr/>
          </p:nvSpPr>
          <p:spPr>
            <a:xfrm rot="16200000">
              <a:off x="4613151" y="1893632"/>
              <a:ext cx="10486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R 2 + met D9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CC1133C4-83C7-7DB0-195C-75FE1B4D5862}"/>
                </a:ext>
              </a:extLst>
            </p:cNvPr>
            <p:cNvSpPr txBox="1"/>
            <p:nvPr/>
          </p:nvSpPr>
          <p:spPr>
            <a:xfrm rot="16200000">
              <a:off x="4605845" y="2172554"/>
              <a:ext cx="4908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R 1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A98690E4-A51B-3C3E-5722-0C913AC05E3D}"/>
                </a:ext>
              </a:extLst>
            </p:cNvPr>
            <p:cNvSpPr txBox="1"/>
            <p:nvPr/>
          </p:nvSpPr>
          <p:spPr>
            <a:xfrm>
              <a:off x="2143016" y="1070464"/>
              <a:ext cx="5180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ay 6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231A813F-DF34-9FE7-B0E9-1236064B2FDA}"/>
                </a:ext>
              </a:extLst>
            </p:cNvPr>
            <p:cNvSpPr txBox="1"/>
            <p:nvPr/>
          </p:nvSpPr>
          <p:spPr>
            <a:xfrm>
              <a:off x="3205318" y="1070642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ay 10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E333A9DE-F97F-B201-87B6-9648DDF3B329}"/>
                </a:ext>
              </a:extLst>
            </p:cNvPr>
            <p:cNvSpPr txBox="1"/>
            <p:nvPr/>
          </p:nvSpPr>
          <p:spPr>
            <a:xfrm>
              <a:off x="4385939" y="1072917"/>
              <a:ext cx="6457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ay 14</a:t>
              </a:r>
            </a:p>
          </p:txBody>
        </p: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6426D54A-C368-7D11-4401-71B85B93657B}"/>
                </a:ext>
              </a:extLst>
            </p:cNvPr>
            <p:cNvCxnSpPr>
              <a:cxnSpLocks/>
            </p:cNvCxnSpPr>
            <p:nvPr/>
          </p:nvCxnSpPr>
          <p:spPr>
            <a:xfrm>
              <a:off x="4125621" y="1329641"/>
              <a:ext cx="1168322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4275C55A-3A56-C8F7-C386-E7D649EEEFB3}"/>
                </a:ext>
              </a:extLst>
            </p:cNvPr>
            <p:cNvSpPr txBox="1"/>
            <p:nvPr/>
          </p:nvSpPr>
          <p:spPr>
            <a:xfrm>
              <a:off x="-138840" y="1077137"/>
              <a:ext cx="20135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 into chronological lifespan:</a:t>
              </a:r>
            </a:p>
          </p:txBody>
        </p: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2A1975D4-21E8-672B-3BE7-52BFC0D284A5}"/>
                </a:ext>
              </a:extLst>
            </p:cNvPr>
            <p:cNvCxnSpPr>
              <a:cxnSpLocks/>
            </p:cNvCxnSpPr>
            <p:nvPr/>
          </p:nvCxnSpPr>
          <p:spPr>
            <a:xfrm>
              <a:off x="2949935" y="1329641"/>
              <a:ext cx="1090479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420DCB2D-4C60-2F5B-C2AF-B18F1DCFA34C}"/>
                </a:ext>
              </a:extLst>
            </p:cNvPr>
            <p:cNvCxnSpPr>
              <a:cxnSpLocks/>
            </p:cNvCxnSpPr>
            <p:nvPr/>
          </p:nvCxnSpPr>
          <p:spPr>
            <a:xfrm>
              <a:off x="1838522" y="1329641"/>
              <a:ext cx="1026207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6" name="Picture 5" descr="A black line on a white surface&#10;&#10;AI-generated content may be incorrect.">
            <a:extLst>
              <a:ext uri="{FF2B5EF4-FFF2-40B4-BE49-F238E27FC236}">
                <a16:creationId xmlns:a16="http://schemas.microsoft.com/office/drawing/2014/main" id="{3BFDA478-2D5D-60B4-A580-C35DAACA00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36662" y="5222761"/>
            <a:ext cx="3456447" cy="5171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 descr="A blurry image of a person's face&#10;&#10;AI-generated content may be incorrect.">
            <a:extLst>
              <a:ext uri="{FF2B5EF4-FFF2-40B4-BE49-F238E27FC236}">
                <a16:creationId xmlns:a16="http://schemas.microsoft.com/office/drawing/2014/main" id="{76468225-D82A-0C68-8C25-89F206ECAE5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436662" y="3871147"/>
            <a:ext cx="3456448" cy="5850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 descr="A blurry black oval object&#10;&#10;AI-generated content may be incorrect.">
            <a:extLst>
              <a:ext uri="{FF2B5EF4-FFF2-40B4-BE49-F238E27FC236}">
                <a16:creationId xmlns:a16="http://schemas.microsoft.com/office/drawing/2014/main" id="{7C3A95D2-8865-F6BA-C736-160E17C0FED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3427" r="1879"/>
          <a:stretch>
            <a:fillRect/>
          </a:stretch>
        </p:blipFill>
        <p:spPr>
          <a:xfrm>
            <a:off x="2436662" y="4493574"/>
            <a:ext cx="3456448" cy="683791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4023485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f71b58b5-4126-43a9-bcb3-21c9de6f5241}" enabled="0" method="" siteId="{f71b58b5-4126-43a9-bcb3-21c9de6f5241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59420</TotalTime>
  <Words>427</Words>
  <Application>Microsoft Macintosh PowerPoint</Application>
  <PresentationFormat>Custom</PresentationFormat>
  <Paragraphs>223</Paragraphs>
  <Slides>8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1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ylah Birmingham</dc:creator>
  <cp:lastModifiedBy>Jessica Tyler</cp:lastModifiedBy>
  <cp:revision>250</cp:revision>
  <dcterms:created xsi:type="dcterms:W3CDTF">2023-08-07T15:31:58Z</dcterms:created>
  <dcterms:modified xsi:type="dcterms:W3CDTF">2026-04-02T17:17:17Z</dcterms:modified>
</cp:coreProperties>
</file>